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0" r:id="rId4"/>
    <p:sldId id="261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2C2DD"/>
    <a:srgbClr val="E74B3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81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3%20Col-0,%20mature%20zone,%20Na%20adding%20overnigh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0%20Na%20efflux%20from%20Col-0%20roo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0%20Na%20efflux%20from%20Col-0%20roo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0%20Na%20efflux%20from%20Col-0%20roo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0%20Na%20efflux%20from%20Col-0%20roo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0%20Na%20efflux%20from%20Col-0%20roo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IFE\flux%20data\Na%20adding%20on%20leaf\2022-03-20%20Na%20efflux%20from%20Col-0%20roo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400"/>
              <a:t>Mature root zo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NaCl solution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Net Na+ flux'!$S$4:$S$147</c:f>
                <c:numCache>
                  <c:formatCode>General</c:formatCode>
                  <c:ptCount val="144"/>
                  <c:pt idx="0">
                    <c:v>9.20444735650198</c:v>
                  </c:pt>
                  <c:pt idx="1">
                    <c:v>10.901139484934689</c:v>
                  </c:pt>
                  <c:pt idx="2">
                    <c:v>12.717529701968846</c:v>
                  </c:pt>
                  <c:pt idx="3">
                    <c:v>13.573362106421293</c:v>
                  </c:pt>
                  <c:pt idx="4">
                    <c:v>14.539950204526146</c:v>
                  </c:pt>
                  <c:pt idx="5">
                    <c:v>16.781087102134752</c:v>
                  </c:pt>
                  <c:pt idx="6">
                    <c:v>19.123558482398092</c:v>
                  </c:pt>
                  <c:pt idx="7">
                    <c:v>20.335922462750954</c:v>
                  </c:pt>
                  <c:pt idx="8">
                    <c:v>17.061776465471976</c:v>
                  </c:pt>
                  <c:pt idx="9">
                    <c:v>14.874432015190807</c:v>
                  </c:pt>
                  <c:pt idx="10">
                    <c:v>16.780969535418187</c:v>
                  </c:pt>
                  <c:pt idx="11">
                    <c:v>14.323443818789999</c:v>
                  </c:pt>
                  <c:pt idx="12">
                    <c:v>9.6697879245944822</c:v>
                  </c:pt>
                  <c:pt idx="13">
                    <c:v>12.504695957640521</c:v>
                  </c:pt>
                  <c:pt idx="14">
                    <c:v>12.86450866172639</c:v>
                  </c:pt>
                  <c:pt idx="15">
                    <c:v>6.804655007870231</c:v>
                  </c:pt>
                  <c:pt idx="16">
                    <c:v>1.4040065547330349</c:v>
                  </c:pt>
                  <c:pt idx="17">
                    <c:v>4.9619659661166553</c:v>
                  </c:pt>
                  <c:pt idx="18">
                    <c:v>4.2029470981007284</c:v>
                  </c:pt>
                  <c:pt idx="19">
                    <c:v>5.4574359950621494</c:v>
                  </c:pt>
                  <c:pt idx="20">
                    <c:v>2.8363750049667296</c:v>
                  </c:pt>
                  <c:pt idx="21">
                    <c:v>27.87259821728561</c:v>
                  </c:pt>
                  <c:pt idx="22">
                    <c:v>22.14558451504724</c:v>
                  </c:pt>
                  <c:pt idx="23">
                    <c:v>5.9226538665815553</c:v>
                  </c:pt>
                  <c:pt idx="24">
                    <c:v>4.6707571458867392</c:v>
                  </c:pt>
                  <c:pt idx="25">
                    <c:v>8.9249457233438267</c:v>
                  </c:pt>
                  <c:pt idx="26">
                    <c:v>20.017622428096832</c:v>
                  </c:pt>
                  <c:pt idx="27">
                    <c:v>12.194680001171694</c:v>
                  </c:pt>
                  <c:pt idx="28">
                    <c:v>2.1556533264153566</c:v>
                  </c:pt>
                  <c:pt idx="29">
                    <c:v>3.3379617377125901</c:v>
                  </c:pt>
                  <c:pt idx="30">
                    <c:v>5.067008328240223</c:v>
                  </c:pt>
                  <c:pt idx="31">
                    <c:v>0.79475439203069564</c:v>
                  </c:pt>
                  <c:pt idx="32">
                    <c:v>0.89602037409871282</c:v>
                  </c:pt>
                  <c:pt idx="33">
                    <c:v>1.3782286610114212</c:v>
                  </c:pt>
                  <c:pt idx="34">
                    <c:v>20.021181747362807</c:v>
                  </c:pt>
                  <c:pt idx="35">
                    <c:v>16.934644192683816</c:v>
                  </c:pt>
                  <c:pt idx="36">
                    <c:v>17.026020516290252</c:v>
                  </c:pt>
                  <c:pt idx="37">
                    <c:v>29.544220768686028</c:v>
                  </c:pt>
                  <c:pt idx="38">
                    <c:v>27.178811627069258</c:v>
                  </c:pt>
                  <c:pt idx="39">
                    <c:v>37.951498023675974</c:v>
                  </c:pt>
                  <c:pt idx="40">
                    <c:v>45.298571538761252</c:v>
                  </c:pt>
                  <c:pt idx="41">
                    <c:v>38.172633344492148</c:v>
                  </c:pt>
                  <c:pt idx="42">
                    <c:v>36.972318734604684</c:v>
                  </c:pt>
                  <c:pt idx="43">
                    <c:v>37.673348290963375</c:v>
                  </c:pt>
                  <c:pt idx="44">
                    <c:v>30.215635780311374</c:v>
                  </c:pt>
                  <c:pt idx="45">
                    <c:v>23.835908433773479</c:v>
                  </c:pt>
                  <c:pt idx="46">
                    <c:v>32.429614720977362</c:v>
                  </c:pt>
                  <c:pt idx="47">
                    <c:v>39.301987821259537</c:v>
                  </c:pt>
                  <c:pt idx="48">
                    <c:v>33.340649852875295</c:v>
                  </c:pt>
                  <c:pt idx="49">
                    <c:v>43.908341433031076</c:v>
                  </c:pt>
                  <c:pt idx="50">
                    <c:v>45.4107804992056</c:v>
                  </c:pt>
                  <c:pt idx="51">
                    <c:v>50.848938917197337</c:v>
                  </c:pt>
                  <c:pt idx="52">
                    <c:v>67.20545703123544</c:v>
                  </c:pt>
                  <c:pt idx="53">
                    <c:v>61.825589256846392</c:v>
                  </c:pt>
                  <c:pt idx="54">
                    <c:v>53.966867802496182</c:v>
                  </c:pt>
                  <c:pt idx="55">
                    <c:v>67.896615574418433</c:v>
                  </c:pt>
                  <c:pt idx="56">
                    <c:v>64.835610372150811</c:v>
                  </c:pt>
                  <c:pt idx="57">
                    <c:v>64.390183369420811</c:v>
                  </c:pt>
                  <c:pt idx="58">
                    <c:v>68.250681897445062</c:v>
                  </c:pt>
                  <c:pt idx="59">
                    <c:v>63.746115233879429</c:v>
                  </c:pt>
                  <c:pt idx="60">
                    <c:v>48.189556365341573</c:v>
                  </c:pt>
                  <c:pt idx="61">
                    <c:v>46.014527060357807</c:v>
                  </c:pt>
                  <c:pt idx="62">
                    <c:v>43.547350502606925</c:v>
                  </c:pt>
                  <c:pt idx="63">
                    <c:v>56.922629531118233</c:v>
                  </c:pt>
                  <c:pt idx="64">
                    <c:v>65.339288317519035</c:v>
                  </c:pt>
                  <c:pt idx="65">
                    <c:v>53.55862322757595</c:v>
                  </c:pt>
                  <c:pt idx="66">
                    <c:v>37.514217877761993</c:v>
                  </c:pt>
                  <c:pt idx="67">
                    <c:v>27.393775314792542</c:v>
                  </c:pt>
                  <c:pt idx="68">
                    <c:v>51.607545267881434</c:v>
                  </c:pt>
                  <c:pt idx="69">
                    <c:v>55.272377846584455</c:v>
                  </c:pt>
                  <c:pt idx="70">
                    <c:v>49.227354261193788</c:v>
                  </c:pt>
                  <c:pt idx="71">
                    <c:v>54.29759041455042</c:v>
                  </c:pt>
                  <c:pt idx="72">
                    <c:v>67.078994896892198</c:v>
                  </c:pt>
                  <c:pt idx="73">
                    <c:v>64.023904681444094</c:v>
                  </c:pt>
                  <c:pt idx="74">
                    <c:v>79.623845889159554</c:v>
                  </c:pt>
                  <c:pt idx="75">
                    <c:v>70.504587271099609</c:v>
                  </c:pt>
                  <c:pt idx="76">
                    <c:v>56.268818373380761</c:v>
                  </c:pt>
                  <c:pt idx="77">
                    <c:v>49.885922893394451</c:v>
                  </c:pt>
                  <c:pt idx="78">
                    <c:v>72.071431533911095</c:v>
                  </c:pt>
                  <c:pt idx="79">
                    <c:v>62.688759641952004</c:v>
                  </c:pt>
                  <c:pt idx="80">
                    <c:v>63.699946222159213</c:v>
                  </c:pt>
                  <c:pt idx="81">
                    <c:v>73.568611528337485</c:v>
                  </c:pt>
                  <c:pt idx="82">
                    <c:v>67.424643849264214</c:v>
                  </c:pt>
                  <c:pt idx="83">
                    <c:v>63.247847799530952</c:v>
                  </c:pt>
                  <c:pt idx="84">
                    <c:v>69.327109189715259</c:v>
                  </c:pt>
                  <c:pt idx="85">
                    <c:v>67.140037583430299</c:v>
                  </c:pt>
                  <c:pt idx="86">
                    <c:v>59.958623868628834</c:v>
                  </c:pt>
                  <c:pt idx="87">
                    <c:v>57.493804797186939</c:v>
                  </c:pt>
                  <c:pt idx="88">
                    <c:v>95.310540665644609</c:v>
                  </c:pt>
                  <c:pt idx="89">
                    <c:v>69.577129058605905</c:v>
                  </c:pt>
                  <c:pt idx="90">
                    <c:v>71.366366503789621</c:v>
                  </c:pt>
                  <c:pt idx="91">
                    <c:v>80.164491169626658</c:v>
                  </c:pt>
                  <c:pt idx="92">
                    <c:v>67.951670631683442</c:v>
                  </c:pt>
                  <c:pt idx="93">
                    <c:v>77.528458665541663</c:v>
                  </c:pt>
                  <c:pt idx="94">
                    <c:v>69.815770494860473</c:v>
                  </c:pt>
                  <c:pt idx="95">
                    <c:v>62.667333169141926</c:v>
                  </c:pt>
                  <c:pt idx="96">
                    <c:v>67.970905359802131</c:v>
                  </c:pt>
                  <c:pt idx="97">
                    <c:v>62.180094350453032</c:v>
                  </c:pt>
                  <c:pt idx="98">
                    <c:v>71.470681052631136</c:v>
                  </c:pt>
                  <c:pt idx="99">
                    <c:v>73.044431061177363</c:v>
                  </c:pt>
                  <c:pt idx="100">
                    <c:v>64.039703273428785</c:v>
                  </c:pt>
                  <c:pt idx="101">
                    <c:v>78.069341113877911</c:v>
                  </c:pt>
                  <c:pt idx="102">
                    <c:v>73.423523080631981</c:v>
                  </c:pt>
                  <c:pt idx="103">
                    <c:v>85.899590770382318</c:v>
                  </c:pt>
                  <c:pt idx="104">
                    <c:v>78.325024486646242</c:v>
                  </c:pt>
                  <c:pt idx="105">
                    <c:v>82.082003603796267</c:v>
                  </c:pt>
                  <c:pt idx="106">
                    <c:v>83.873868464444499</c:v>
                  </c:pt>
                  <c:pt idx="107">
                    <c:v>84.950088005075685</c:v>
                  </c:pt>
                  <c:pt idx="108">
                    <c:v>82.197385066762465</c:v>
                  </c:pt>
                  <c:pt idx="109">
                    <c:v>77.705982371593521</c:v>
                  </c:pt>
                  <c:pt idx="110">
                    <c:v>86.05133497774473</c:v>
                  </c:pt>
                  <c:pt idx="111">
                    <c:v>83.810710825831748</c:v>
                  </c:pt>
                  <c:pt idx="112">
                    <c:v>80.663077993560393</c:v>
                  </c:pt>
                  <c:pt idx="113">
                    <c:v>80.066686387306746</c:v>
                  </c:pt>
                  <c:pt idx="114">
                    <c:v>80.839100794034636</c:v>
                  </c:pt>
                  <c:pt idx="115">
                    <c:v>87.120399101293785</c:v>
                  </c:pt>
                  <c:pt idx="116">
                    <c:v>86.461839143288444</c:v>
                  </c:pt>
                  <c:pt idx="117">
                    <c:v>82.398757889259315</c:v>
                  </c:pt>
                  <c:pt idx="118">
                    <c:v>82.625615929499745</c:v>
                  </c:pt>
                  <c:pt idx="119">
                    <c:v>72.701843251128196</c:v>
                  </c:pt>
                  <c:pt idx="120">
                    <c:v>69.162799289828058</c:v>
                  </c:pt>
                  <c:pt idx="121">
                    <c:v>85.818989329312643</c:v>
                  </c:pt>
                  <c:pt idx="122">
                    <c:v>92.311448536049056</c:v>
                  </c:pt>
                  <c:pt idx="123">
                    <c:v>99.140213256814434</c:v>
                  </c:pt>
                  <c:pt idx="124">
                    <c:v>126.26759836627929</c:v>
                  </c:pt>
                  <c:pt idx="125">
                    <c:v>110.6817578002801</c:v>
                  </c:pt>
                  <c:pt idx="126">
                    <c:v>134.97638878739508</c:v>
                  </c:pt>
                  <c:pt idx="127">
                    <c:v>126.95673183273571</c:v>
                  </c:pt>
                  <c:pt idx="128">
                    <c:v>100.89966370107889</c:v>
                  </c:pt>
                  <c:pt idx="129">
                    <c:v>73.042279283174068</c:v>
                  </c:pt>
                  <c:pt idx="130">
                    <c:v>86.27605410932928</c:v>
                  </c:pt>
                  <c:pt idx="131">
                    <c:v>108.51738313056504</c:v>
                  </c:pt>
                  <c:pt idx="132">
                    <c:v>119.57043741231217</c:v>
                  </c:pt>
                  <c:pt idx="133">
                    <c:v>107.90092905628778</c:v>
                  </c:pt>
                  <c:pt idx="134">
                    <c:v>83.641335655479409</c:v>
                  </c:pt>
                  <c:pt idx="135">
                    <c:v>106.40422202760763</c:v>
                  </c:pt>
                  <c:pt idx="136">
                    <c:v>114.00957664459648</c:v>
                  </c:pt>
                  <c:pt idx="137">
                    <c:v>127.48723977027517</c:v>
                  </c:pt>
                  <c:pt idx="138">
                    <c:v>127.5452187414387</c:v>
                  </c:pt>
                  <c:pt idx="139">
                    <c:v>118.42992991111763</c:v>
                  </c:pt>
                  <c:pt idx="140">
                    <c:v>107.51321989090425</c:v>
                  </c:pt>
                  <c:pt idx="141">
                    <c:v>115.8894940909922</c:v>
                  </c:pt>
                  <c:pt idx="142">
                    <c:v>118.1127692264057</c:v>
                  </c:pt>
                  <c:pt idx="143">
                    <c:v>114.25761343909609</c:v>
                  </c:pt>
                </c:numCache>
              </c:numRef>
            </c:plus>
            <c:minus>
              <c:numRef>
                <c:f>'Net Na+ flux'!$S$4:$S$147</c:f>
                <c:numCache>
                  <c:formatCode>General</c:formatCode>
                  <c:ptCount val="144"/>
                  <c:pt idx="0">
                    <c:v>9.20444735650198</c:v>
                  </c:pt>
                  <c:pt idx="1">
                    <c:v>10.901139484934689</c:v>
                  </c:pt>
                  <c:pt idx="2">
                    <c:v>12.717529701968846</c:v>
                  </c:pt>
                  <c:pt idx="3">
                    <c:v>13.573362106421293</c:v>
                  </c:pt>
                  <c:pt idx="4">
                    <c:v>14.539950204526146</c:v>
                  </c:pt>
                  <c:pt idx="5">
                    <c:v>16.781087102134752</c:v>
                  </c:pt>
                  <c:pt idx="6">
                    <c:v>19.123558482398092</c:v>
                  </c:pt>
                  <c:pt idx="7">
                    <c:v>20.335922462750954</c:v>
                  </c:pt>
                  <c:pt idx="8">
                    <c:v>17.061776465471976</c:v>
                  </c:pt>
                  <c:pt idx="9">
                    <c:v>14.874432015190807</c:v>
                  </c:pt>
                  <c:pt idx="10">
                    <c:v>16.780969535418187</c:v>
                  </c:pt>
                  <c:pt idx="11">
                    <c:v>14.323443818789999</c:v>
                  </c:pt>
                  <c:pt idx="12">
                    <c:v>9.6697879245944822</c:v>
                  </c:pt>
                  <c:pt idx="13">
                    <c:v>12.504695957640521</c:v>
                  </c:pt>
                  <c:pt idx="14">
                    <c:v>12.86450866172639</c:v>
                  </c:pt>
                  <c:pt idx="15">
                    <c:v>6.804655007870231</c:v>
                  </c:pt>
                  <c:pt idx="16">
                    <c:v>1.4040065547330349</c:v>
                  </c:pt>
                  <c:pt idx="17">
                    <c:v>4.9619659661166553</c:v>
                  </c:pt>
                  <c:pt idx="18">
                    <c:v>4.2029470981007284</c:v>
                  </c:pt>
                  <c:pt idx="19">
                    <c:v>5.4574359950621494</c:v>
                  </c:pt>
                  <c:pt idx="20">
                    <c:v>2.8363750049667296</c:v>
                  </c:pt>
                  <c:pt idx="21">
                    <c:v>27.87259821728561</c:v>
                  </c:pt>
                  <c:pt idx="22">
                    <c:v>22.14558451504724</c:v>
                  </c:pt>
                  <c:pt idx="23">
                    <c:v>5.9226538665815553</c:v>
                  </c:pt>
                  <c:pt idx="24">
                    <c:v>4.6707571458867392</c:v>
                  </c:pt>
                  <c:pt idx="25">
                    <c:v>8.9249457233438267</c:v>
                  </c:pt>
                  <c:pt idx="26">
                    <c:v>20.017622428096832</c:v>
                  </c:pt>
                  <c:pt idx="27">
                    <c:v>12.194680001171694</c:v>
                  </c:pt>
                  <c:pt idx="28">
                    <c:v>2.1556533264153566</c:v>
                  </c:pt>
                  <c:pt idx="29">
                    <c:v>3.3379617377125901</c:v>
                  </c:pt>
                  <c:pt idx="30">
                    <c:v>5.067008328240223</c:v>
                  </c:pt>
                  <c:pt idx="31">
                    <c:v>0.79475439203069564</c:v>
                  </c:pt>
                  <c:pt idx="32">
                    <c:v>0.89602037409871282</c:v>
                  </c:pt>
                  <c:pt idx="33">
                    <c:v>1.3782286610114212</c:v>
                  </c:pt>
                  <c:pt idx="34">
                    <c:v>20.021181747362807</c:v>
                  </c:pt>
                  <c:pt idx="35">
                    <c:v>16.934644192683816</c:v>
                  </c:pt>
                  <c:pt idx="36">
                    <c:v>17.026020516290252</c:v>
                  </c:pt>
                  <c:pt idx="37">
                    <c:v>29.544220768686028</c:v>
                  </c:pt>
                  <c:pt idx="38">
                    <c:v>27.178811627069258</c:v>
                  </c:pt>
                  <c:pt idx="39">
                    <c:v>37.951498023675974</c:v>
                  </c:pt>
                  <c:pt idx="40">
                    <c:v>45.298571538761252</c:v>
                  </c:pt>
                  <c:pt idx="41">
                    <c:v>38.172633344492148</c:v>
                  </c:pt>
                  <c:pt idx="42">
                    <c:v>36.972318734604684</c:v>
                  </c:pt>
                  <c:pt idx="43">
                    <c:v>37.673348290963375</c:v>
                  </c:pt>
                  <c:pt idx="44">
                    <c:v>30.215635780311374</c:v>
                  </c:pt>
                  <c:pt idx="45">
                    <c:v>23.835908433773479</c:v>
                  </c:pt>
                  <c:pt idx="46">
                    <c:v>32.429614720977362</c:v>
                  </c:pt>
                  <c:pt idx="47">
                    <c:v>39.301987821259537</c:v>
                  </c:pt>
                  <c:pt idx="48">
                    <c:v>33.340649852875295</c:v>
                  </c:pt>
                  <c:pt idx="49">
                    <c:v>43.908341433031076</c:v>
                  </c:pt>
                  <c:pt idx="50">
                    <c:v>45.4107804992056</c:v>
                  </c:pt>
                  <c:pt idx="51">
                    <c:v>50.848938917197337</c:v>
                  </c:pt>
                  <c:pt idx="52">
                    <c:v>67.20545703123544</c:v>
                  </c:pt>
                  <c:pt idx="53">
                    <c:v>61.825589256846392</c:v>
                  </c:pt>
                  <c:pt idx="54">
                    <c:v>53.966867802496182</c:v>
                  </c:pt>
                  <c:pt idx="55">
                    <c:v>67.896615574418433</c:v>
                  </c:pt>
                  <c:pt idx="56">
                    <c:v>64.835610372150811</c:v>
                  </c:pt>
                  <c:pt idx="57">
                    <c:v>64.390183369420811</c:v>
                  </c:pt>
                  <c:pt idx="58">
                    <c:v>68.250681897445062</c:v>
                  </c:pt>
                  <c:pt idx="59">
                    <c:v>63.746115233879429</c:v>
                  </c:pt>
                  <c:pt idx="60">
                    <c:v>48.189556365341573</c:v>
                  </c:pt>
                  <c:pt idx="61">
                    <c:v>46.014527060357807</c:v>
                  </c:pt>
                  <c:pt idx="62">
                    <c:v>43.547350502606925</c:v>
                  </c:pt>
                  <c:pt idx="63">
                    <c:v>56.922629531118233</c:v>
                  </c:pt>
                  <c:pt idx="64">
                    <c:v>65.339288317519035</c:v>
                  </c:pt>
                  <c:pt idx="65">
                    <c:v>53.55862322757595</c:v>
                  </c:pt>
                  <c:pt idx="66">
                    <c:v>37.514217877761993</c:v>
                  </c:pt>
                  <c:pt idx="67">
                    <c:v>27.393775314792542</c:v>
                  </c:pt>
                  <c:pt idx="68">
                    <c:v>51.607545267881434</c:v>
                  </c:pt>
                  <c:pt idx="69">
                    <c:v>55.272377846584455</c:v>
                  </c:pt>
                  <c:pt idx="70">
                    <c:v>49.227354261193788</c:v>
                  </c:pt>
                  <c:pt idx="71">
                    <c:v>54.29759041455042</c:v>
                  </c:pt>
                  <c:pt idx="72">
                    <c:v>67.078994896892198</c:v>
                  </c:pt>
                  <c:pt idx="73">
                    <c:v>64.023904681444094</c:v>
                  </c:pt>
                  <c:pt idx="74">
                    <c:v>79.623845889159554</c:v>
                  </c:pt>
                  <c:pt idx="75">
                    <c:v>70.504587271099609</c:v>
                  </c:pt>
                  <c:pt idx="76">
                    <c:v>56.268818373380761</c:v>
                  </c:pt>
                  <c:pt idx="77">
                    <c:v>49.885922893394451</c:v>
                  </c:pt>
                  <c:pt idx="78">
                    <c:v>72.071431533911095</c:v>
                  </c:pt>
                  <c:pt idx="79">
                    <c:v>62.688759641952004</c:v>
                  </c:pt>
                  <c:pt idx="80">
                    <c:v>63.699946222159213</c:v>
                  </c:pt>
                  <c:pt idx="81">
                    <c:v>73.568611528337485</c:v>
                  </c:pt>
                  <c:pt idx="82">
                    <c:v>67.424643849264214</c:v>
                  </c:pt>
                  <c:pt idx="83">
                    <c:v>63.247847799530952</c:v>
                  </c:pt>
                  <c:pt idx="84">
                    <c:v>69.327109189715259</c:v>
                  </c:pt>
                  <c:pt idx="85">
                    <c:v>67.140037583430299</c:v>
                  </c:pt>
                  <c:pt idx="86">
                    <c:v>59.958623868628834</c:v>
                  </c:pt>
                  <c:pt idx="87">
                    <c:v>57.493804797186939</c:v>
                  </c:pt>
                  <c:pt idx="88">
                    <c:v>95.310540665644609</c:v>
                  </c:pt>
                  <c:pt idx="89">
                    <c:v>69.577129058605905</c:v>
                  </c:pt>
                  <c:pt idx="90">
                    <c:v>71.366366503789621</c:v>
                  </c:pt>
                  <c:pt idx="91">
                    <c:v>80.164491169626658</c:v>
                  </c:pt>
                  <c:pt idx="92">
                    <c:v>67.951670631683442</c:v>
                  </c:pt>
                  <c:pt idx="93">
                    <c:v>77.528458665541663</c:v>
                  </c:pt>
                  <c:pt idx="94">
                    <c:v>69.815770494860473</c:v>
                  </c:pt>
                  <c:pt idx="95">
                    <c:v>62.667333169141926</c:v>
                  </c:pt>
                  <c:pt idx="96">
                    <c:v>67.970905359802131</c:v>
                  </c:pt>
                  <c:pt idx="97">
                    <c:v>62.180094350453032</c:v>
                  </c:pt>
                  <c:pt idx="98">
                    <c:v>71.470681052631136</c:v>
                  </c:pt>
                  <c:pt idx="99">
                    <c:v>73.044431061177363</c:v>
                  </c:pt>
                  <c:pt idx="100">
                    <c:v>64.039703273428785</c:v>
                  </c:pt>
                  <c:pt idx="101">
                    <c:v>78.069341113877911</c:v>
                  </c:pt>
                  <c:pt idx="102">
                    <c:v>73.423523080631981</c:v>
                  </c:pt>
                  <c:pt idx="103">
                    <c:v>85.899590770382318</c:v>
                  </c:pt>
                  <c:pt idx="104">
                    <c:v>78.325024486646242</c:v>
                  </c:pt>
                  <c:pt idx="105">
                    <c:v>82.082003603796267</c:v>
                  </c:pt>
                  <c:pt idx="106">
                    <c:v>83.873868464444499</c:v>
                  </c:pt>
                  <c:pt idx="107">
                    <c:v>84.950088005075685</c:v>
                  </c:pt>
                  <c:pt idx="108">
                    <c:v>82.197385066762465</c:v>
                  </c:pt>
                  <c:pt idx="109">
                    <c:v>77.705982371593521</c:v>
                  </c:pt>
                  <c:pt idx="110">
                    <c:v>86.05133497774473</c:v>
                  </c:pt>
                  <c:pt idx="111">
                    <c:v>83.810710825831748</c:v>
                  </c:pt>
                  <c:pt idx="112">
                    <c:v>80.663077993560393</c:v>
                  </c:pt>
                  <c:pt idx="113">
                    <c:v>80.066686387306746</c:v>
                  </c:pt>
                  <c:pt idx="114">
                    <c:v>80.839100794034636</c:v>
                  </c:pt>
                  <c:pt idx="115">
                    <c:v>87.120399101293785</c:v>
                  </c:pt>
                  <c:pt idx="116">
                    <c:v>86.461839143288444</c:v>
                  </c:pt>
                  <c:pt idx="117">
                    <c:v>82.398757889259315</c:v>
                  </c:pt>
                  <c:pt idx="118">
                    <c:v>82.625615929499745</c:v>
                  </c:pt>
                  <c:pt idx="119">
                    <c:v>72.701843251128196</c:v>
                  </c:pt>
                  <c:pt idx="120">
                    <c:v>69.162799289828058</c:v>
                  </c:pt>
                  <c:pt idx="121">
                    <c:v>85.818989329312643</c:v>
                  </c:pt>
                  <c:pt idx="122">
                    <c:v>92.311448536049056</c:v>
                  </c:pt>
                  <c:pt idx="123">
                    <c:v>99.140213256814434</c:v>
                  </c:pt>
                  <c:pt idx="124">
                    <c:v>126.26759836627929</c:v>
                  </c:pt>
                  <c:pt idx="125">
                    <c:v>110.6817578002801</c:v>
                  </c:pt>
                  <c:pt idx="126">
                    <c:v>134.97638878739508</c:v>
                  </c:pt>
                  <c:pt idx="127">
                    <c:v>126.95673183273571</c:v>
                  </c:pt>
                  <c:pt idx="128">
                    <c:v>100.89966370107889</c:v>
                  </c:pt>
                  <c:pt idx="129">
                    <c:v>73.042279283174068</c:v>
                  </c:pt>
                  <c:pt idx="130">
                    <c:v>86.27605410932928</c:v>
                  </c:pt>
                  <c:pt idx="131">
                    <c:v>108.51738313056504</c:v>
                  </c:pt>
                  <c:pt idx="132">
                    <c:v>119.57043741231217</c:v>
                  </c:pt>
                  <c:pt idx="133">
                    <c:v>107.90092905628778</c:v>
                  </c:pt>
                  <c:pt idx="134">
                    <c:v>83.641335655479409</c:v>
                  </c:pt>
                  <c:pt idx="135">
                    <c:v>106.40422202760763</c:v>
                  </c:pt>
                  <c:pt idx="136">
                    <c:v>114.00957664459648</c:v>
                  </c:pt>
                  <c:pt idx="137">
                    <c:v>127.48723977027517</c:v>
                  </c:pt>
                  <c:pt idx="138">
                    <c:v>127.5452187414387</c:v>
                  </c:pt>
                  <c:pt idx="139">
                    <c:v>118.42992991111763</c:v>
                  </c:pt>
                  <c:pt idx="140">
                    <c:v>107.51321989090425</c:v>
                  </c:pt>
                  <c:pt idx="141">
                    <c:v>115.8894940909922</c:v>
                  </c:pt>
                  <c:pt idx="142">
                    <c:v>118.1127692264057</c:v>
                  </c:pt>
                  <c:pt idx="143">
                    <c:v>114.2576134390960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xVal>
            <c:numRef>
              <c:f>'Net Na+ flux'!$O$4:$O$147</c:f>
              <c:numCache>
                <c:formatCode>General</c:formatCode>
                <c:ptCount val="144"/>
                <c:pt idx="0">
                  <c:v>8.3333333333333329E-2</c:v>
                </c:pt>
                <c:pt idx="1">
                  <c:v>0.16666666666666666</c:v>
                </c:pt>
                <c:pt idx="2">
                  <c:v>0.25</c:v>
                </c:pt>
                <c:pt idx="3">
                  <c:v>0.33333333333333331</c:v>
                </c:pt>
                <c:pt idx="4">
                  <c:v>0.41666666666666663</c:v>
                </c:pt>
                <c:pt idx="5">
                  <c:v>0.49999999999999994</c:v>
                </c:pt>
                <c:pt idx="6">
                  <c:v>0.58333333333333326</c:v>
                </c:pt>
                <c:pt idx="7">
                  <c:v>0.66666666666666663</c:v>
                </c:pt>
                <c:pt idx="8">
                  <c:v>0.75</c:v>
                </c:pt>
                <c:pt idx="9">
                  <c:v>0.83333333333333337</c:v>
                </c:pt>
                <c:pt idx="10">
                  <c:v>0.91666666666666674</c:v>
                </c:pt>
                <c:pt idx="11">
                  <c:v>1</c:v>
                </c:pt>
                <c:pt idx="12">
                  <c:v>1.0833333333333333</c:v>
                </c:pt>
                <c:pt idx="13">
                  <c:v>1.1666666666666665</c:v>
                </c:pt>
                <c:pt idx="14">
                  <c:v>1.2499999999999998</c:v>
                </c:pt>
                <c:pt idx="15">
                  <c:v>1.333333333333333</c:v>
                </c:pt>
                <c:pt idx="16">
                  <c:v>1.4166666666666663</c:v>
                </c:pt>
                <c:pt idx="17">
                  <c:v>1.4999999999999996</c:v>
                </c:pt>
                <c:pt idx="18">
                  <c:v>1.5833333333333328</c:v>
                </c:pt>
                <c:pt idx="19">
                  <c:v>1.6666666666666661</c:v>
                </c:pt>
                <c:pt idx="20">
                  <c:v>1.7499999999999993</c:v>
                </c:pt>
                <c:pt idx="21">
                  <c:v>1.8333333333333326</c:v>
                </c:pt>
                <c:pt idx="22">
                  <c:v>1.9166666666666659</c:v>
                </c:pt>
                <c:pt idx="23">
                  <c:v>1.9999999999999991</c:v>
                </c:pt>
                <c:pt idx="24">
                  <c:v>2.0833333333333326</c:v>
                </c:pt>
                <c:pt idx="25">
                  <c:v>2.1666666666666661</c:v>
                </c:pt>
                <c:pt idx="26">
                  <c:v>2.2499999999999996</c:v>
                </c:pt>
                <c:pt idx="27">
                  <c:v>2.333333333333333</c:v>
                </c:pt>
                <c:pt idx="28">
                  <c:v>2.4166666666666665</c:v>
                </c:pt>
                <c:pt idx="29">
                  <c:v>2.5</c:v>
                </c:pt>
                <c:pt idx="30">
                  <c:v>2.5833333333333335</c:v>
                </c:pt>
                <c:pt idx="31">
                  <c:v>2.666666666666667</c:v>
                </c:pt>
                <c:pt idx="32">
                  <c:v>2.7500000000000004</c:v>
                </c:pt>
                <c:pt idx="33">
                  <c:v>2.8333333333333339</c:v>
                </c:pt>
                <c:pt idx="34">
                  <c:v>2.9166666666666674</c:v>
                </c:pt>
                <c:pt idx="35">
                  <c:v>3.0000000000000009</c:v>
                </c:pt>
                <c:pt idx="36">
                  <c:v>3.0833333333333344</c:v>
                </c:pt>
                <c:pt idx="37">
                  <c:v>3.1666666666666679</c:v>
                </c:pt>
                <c:pt idx="38">
                  <c:v>3.2500000000000013</c:v>
                </c:pt>
                <c:pt idx="39">
                  <c:v>3.3333333333333348</c:v>
                </c:pt>
                <c:pt idx="40">
                  <c:v>3.4166666666666683</c:v>
                </c:pt>
                <c:pt idx="41">
                  <c:v>3.5000000000000018</c:v>
                </c:pt>
                <c:pt idx="42">
                  <c:v>3.5833333333333353</c:v>
                </c:pt>
                <c:pt idx="43">
                  <c:v>3.6666666666666687</c:v>
                </c:pt>
                <c:pt idx="44">
                  <c:v>3.7500000000000022</c:v>
                </c:pt>
                <c:pt idx="45">
                  <c:v>3.8333333333333357</c:v>
                </c:pt>
                <c:pt idx="46">
                  <c:v>3.9166666666666692</c:v>
                </c:pt>
                <c:pt idx="47">
                  <c:v>4.0000000000000027</c:v>
                </c:pt>
                <c:pt idx="48">
                  <c:v>4.0833333333333357</c:v>
                </c:pt>
                <c:pt idx="49">
                  <c:v>4.1666666666666687</c:v>
                </c:pt>
                <c:pt idx="50">
                  <c:v>4.2500000000000018</c:v>
                </c:pt>
                <c:pt idx="51">
                  <c:v>4.3333333333333348</c:v>
                </c:pt>
                <c:pt idx="52">
                  <c:v>4.4166666666666679</c:v>
                </c:pt>
                <c:pt idx="53">
                  <c:v>4.5000000000000009</c:v>
                </c:pt>
                <c:pt idx="54">
                  <c:v>4.5833333333333339</c:v>
                </c:pt>
                <c:pt idx="55">
                  <c:v>4.666666666666667</c:v>
                </c:pt>
                <c:pt idx="56">
                  <c:v>4.75</c:v>
                </c:pt>
                <c:pt idx="57">
                  <c:v>4.833333333333333</c:v>
                </c:pt>
                <c:pt idx="58">
                  <c:v>4.9166666666666661</c:v>
                </c:pt>
                <c:pt idx="59">
                  <c:v>4.9999999999999991</c:v>
                </c:pt>
                <c:pt idx="60">
                  <c:v>5.0833333333333321</c:v>
                </c:pt>
                <c:pt idx="61">
                  <c:v>5.1666666666666652</c:v>
                </c:pt>
                <c:pt idx="62">
                  <c:v>5.2499999999999982</c:v>
                </c:pt>
                <c:pt idx="63">
                  <c:v>5.3333333333333313</c:v>
                </c:pt>
                <c:pt idx="64">
                  <c:v>5.4166666666666643</c:v>
                </c:pt>
                <c:pt idx="65">
                  <c:v>5.4999999999999973</c:v>
                </c:pt>
                <c:pt idx="66">
                  <c:v>5.5833333333333304</c:v>
                </c:pt>
                <c:pt idx="67">
                  <c:v>5.6666666666666634</c:v>
                </c:pt>
                <c:pt idx="68">
                  <c:v>5.7499999999999964</c:v>
                </c:pt>
                <c:pt idx="69">
                  <c:v>5.8333333333333295</c:v>
                </c:pt>
                <c:pt idx="70">
                  <c:v>5.9166666666666625</c:v>
                </c:pt>
                <c:pt idx="71">
                  <c:v>5.9999999999999956</c:v>
                </c:pt>
                <c:pt idx="72">
                  <c:v>6.0833333333333286</c:v>
                </c:pt>
                <c:pt idx="73">
                  <c:v>6.1666666666666616</c:v>
                </c:pt>
                <c:pt idx="74">
                  <c:v>6.2499999999999947</c:v>
                </c:pt>
                <c:pt idx="75">
                  <c:v>6.3333333333333277</c:v>
                </c:pt>
                <c:pt idx="76">
                  <c:v>6.4166666666666607</c:v>
                </c:pt>
                <c:pt idx="77">
                  <c:v>6.4999999999999938</c:v>
                </c:pt>
                <c:pt idx="78">
                  <c:v>6.5833333333333268</c:v>
                </c:pt>
                <c:pt idx="79">
                  <c:v>6.6666666666666599</c:v>
                </c:pt>
                <c:pt idx="80">
                  <c:v>6.7499999999999929</c:v>
                </c:pt>
                <c:pt idx="81">
                  <c:v>6.8333333333333259</c:v>
                </c:pt>
                <c:pt idx="82">
                  <c:v>6.916666666666659</c:v>
                </c:pt>
                <c:pt idx="83">
                  <c:v>6.999999999999992</c:v>
                </c:pt>
                <c:pt idx="84">
                  <c:v>7.083333333333325</c:v>
                </c:pt>
                <c:pt idx="85">
                  <c:v>7.1666666666666581</c:v>
                </c:pt>
                <c:pt idx="86">
                  <c:v>7.2499999999999911</c:v>
                </c:pt>
                <c:pt idx="87">
                  <c:v>7.3333333333333242</c:v>
                </c:pt>
                <c:pt idx="88">
                  <c:v>7.4166666666666572</c:v>
                </c:pt>
                <c:pt idx="89">
                  <c:v>7.4999999999999902</c:v>
                </c:pt>
                <c:pt idx="90">
                  <c:v>7.5833333333333233</c:v>
                </c:pt>
                <c:pt idx="91">
                  <c:v>7.6666666666666563</c:v>
                </c:pt>
                <c:pt idx="92">
                  <c:v>7.7499999999999893</c:v>
                </c:pt>
                <c:pt idx="93">
                  <c:v>7.8333333333333224</c:v>
                </c:pt>
                <c:pt idx="94">
                  <c:v>7.9166666666666554</c:v>
                </c:pt>
                <c:pt idx="95">
                  <c:v>7.9999999999999885</c:v>
                </c:pt>
                <c:pt idx="96">
                  <c:v>8.0833333333333215</c:v>
                </c:pt>
                <c:pt idx="97">
                  <c:v>8.1666666666666554</c:v>
                </c:pt>
                <c:pt idx="98">
                  <c:v>8.2499999999999893</c:v>
                </c:pt>
                <c:pt idx="99">
                  <c:v>8.3333333333333233</c:v>
                </c:pt>
                <c:pt idx="100">
                  <c:v>8.4166666666666572</c:v>
                </c:pt>
                <c:pt idx="101">
                  <c:v>8.4999999999999911</c:v>
                </c:pt>
                <c:pt idx="102">
                  <c:v>8.583333333333325</c:v>
                </c:pt>
                <c:pt idx="103">
                  <c:v>8.666666666666659</c:v>
                </c:pt>
                <c:pt idx="104">
                  <c:v>8.7499999999999929</c:v>
                </c:pt>
                <c:pt idx="105">
                  <c:v>8.8333333333333268</c:v>
                </c:pt>
                <c:pt idx="106">
                  <c:v>8.9166666666666607</c:v>
                </c:pt>
                <c:pt idx="107">
                  <c:v>8.9999999999999947</c:v>
                </c:pt>
                <c:pt idx="108">
                  <c:v>9.0833333333333286</c:v>
                </c:pt>
                <c:pt idx="109">
                  <c:v>9.1666666666666625</c:v>
                </c:pt>
                <c:pt idx="110">
                  <c:v>9.2499999999999964</c:v>
                </c:pt>
                <c:pt idx="111">
                  <c:v>9.3333333333333304</c:v>
                </c:pt>
                <c:pt idx="112">
                  <c:v>9.4166666666666643</c:v>
                </c:pt>
                <c:pt idx="113">
                  <c:v>9.4999999999999982</c:v>
                </c:pt>
                <c:pt idx="114">
                  <c:v>9.5833333333333321</c:v>
                </c:pt>
                <c:pt idx="115">
                  <c:v>9.6666666666666661</c:v>
                </c:pt>
                <c:pt idx="116">
                  <c:v>9.75</c:v>
                </c:pt>
                <c:pt idx="117">
                  <c:v>9.8333333333333339</c:v>
                </c:pt>
                <c:pt idx="118">
                  <c:v>9.9166666666666679</c:v>
                </c:pt>
                <c:pt idx="119">
                  <c:v>10.000000000000002</c:v>
                </c:pt>
                <c:pt idx="120">
                  <c:v>10.083333333333336</c:v>
                </c:pt>
                <c:pt idx="121">
                  <c:v>10.16666666666667</c:v>
                </c:pt>
                <c:pt idx="122">
                  <c:v>10.250000000000004</c:v>
                </c:pt>
                <c:pt idx="123">
                  <c:v>10.333333333333337</c:v>
                </c:pt>
                <c:pt idx="124">
                  <c:v>10.416666666666671</c:v>
                </c:pt>
                <c:pt idx="125">
                  <c:v>10.500000000000005</c:v>
                </c:pt>
                <c:pt idx="126">
                  <c:v>10.583333333333339</c:v>
                </c:pt>
                <c:pt idx="127">
                  <c:v>10.666666666666673</c:v>
                </c:pt>
                <c:pt idx="128">
                  <c:v>10.750000000000007</c:v>
                </c:pt>
                <c:pt idx="129">
                  <c:v>10.833333333333341</c:v>
                </c:pt>
                <c:pt idx="130">
                  <c:v>10.916666666666675</c:v>
                </c:pt>
                <c:pt idx="131">
                  <c:v>11.000000000000009</c:v>
                </c:pt>
                <c:pt idx="132">
                  <c:v>11.083333333333343</c:v>
                </c:pt>
                <c:pt idx="133">
                  <c:v>11.166666666666677</c:v>
                </c:pt>
                <c:pt idx="134">
                  <c:v>11.250000000000011</c:v>
                </c:pt>
                <c:pt idx="135">
                  <c:v>11.333333333333345</c:v>
                </c:pt>
                <c:pt idx="136">
                  <c:v>11.416666666666679</c:v>
                </c:pt>
                <c:pt idx="137">
                  <c:v>11.500000000000012</c:v>
                </c:pt>
                <c:pt idx="138">
                  <c:v>11.583333333333346</c:v>
                </c:pt>
                <c:pt idx="139">
                  <c:v>11.66666666666668</c:v>
                </c:pt>
                <c:pt idx="140">
                  <c:v>11.750000000000014</c:v>
                </c:pt>
                <c:pt idx="141">
                  <c:v>11.833333333333348</c:v>
                </c:pt>
                <c:pt idx="142">
                  <c:v>11.916666666666682</c:v>
                </c:pt>
                <c:pt idx="143">
                  <c:v>12.000000000000016</c:v>
                </c:pt>
              </c:numCache>
            </c:numRef>
          </c:xVal>
          <c:yVal>
            <c:numRef>
              <c:f>'Net Na+ flux'!$P$4:$P$147</c:f>
              <c:numCache>
                <c:formatCode>General</c:formatCode>
                <c:ptCount val="144"/>
                <c:pt idx="0">
                  <c:v>-8.9621871428571431</c:v>
                </c:pt>
                <c:pt idx="1">
                  <c:v>-9.3551608333333327</c:v>
                </c:pt>
                <c:pt idx="2">
                  <c:v>-10.700727619047619</c:v>
                </c:pt>
                <c:pt idx="3">
                  <c:v>-11.055753333333335</c:v>
                </c:pt>
                <c:pt idx="4">
                  <c:v>-11.38937</c:v>
                </c:pt>
                <c:pt idx="5">
                  <c:v>-13.174973333333336</c:v>
                </c:pt>
                <c:pt idx="6">
                  <c:v>-16.106780000000001</c:v>
                </c:pt>
                <c:pt idx="7">
                  <c:v>-16.509992499999999</c:v>
                </c:pt>
                <c:pt idx="8">
                  <c:v>-14.794553333333333</c:v>
                </c:pt>
                <c:pt idx="9">
                  <c:v>-13.550713333333332</c:v>
                </c:pt>
                <c:pt idx="10">
                  <c:v>-15.190036666666666</c:v>
                </c:pt>
                <c:pt idx="11">
                  <c:v>-13.799163333333334</c:v>
                </c:pt>
                <c:pt idx="12">
                  <c:v>-11.786476666666667</c:v>
                </c:pt>
                <c:pt idx="13">
                  <c:v>-14.103687619047619</c:v>
                </c:pt>
                <c:pt idx="14">
                  <c:v>-15.826823333333337</c:v>
                </c:pt>
                <c:pt idx="15">
                  <c:v>-12.863076666666664</c:v>
                </c:pt>
                <c:pt idx="16">
                  <c:v>-11.164426666666666</c:v>
                </c:pt>
                <c:pt idx="17">
                  <c:v>-13.275530000000002</c:v>
                </c:pt>
                <c:pt idx="18">
                  <c:v>-10.146746666666665</c:v>
                </c:pt>
                <c:pt idx="19">
                  <c:v>-12.102740000000001</c:v>
                </c:pt>
                <c:pt idx="20">
                  <c:v>-12.54923</c:v>
                </c:pt>
                <c:pt idx="21">
                  <c:v>-28.559153333333331</c:v>
                </c:pt>
                <c:pt idx="22">
                  <c:v>-25.930260000000004</c:v>
                </c:pt>
                <c:pt idx="23">
                  <c:v>-16.449833333333331</c:v>
                </c:pt>
                <c:pt idx="24">
                  <c:v>-15.291885833333334</c:v>
                </c:pt>
                <c:pt idx="25">
                  <c:v>-19.336563333333334</c:v>
                </c:pt>
                <c:pt idx="26">
                  <c:v>-26.572147619047616</c:v>
                </c:pt>
                <c:pt idx="27">
                  <c:v>-22.459794166666669</c:v>
                </c:pt>
                <c:pt idx="28">
                  <c:v>-17.655643703703703</c:v>
                </c:pt>
                <c:pt idx="29">
                  <c:v>-14.471043333333336</c:v>
                </c:pt>
                <c:pt idx="30">
                  <c:v>-20.400018611111111</c:v>
                </c:pt>
                <c:pt idx="31">
                  <c:v>-18.824985833333333</c:v>
                </c:pt>
                <c:pt idx="32">
                  <c:v>-19.806119999999996</c:v>
                </c:pt>
                <c:pt idx="33">
                  <c:v>-19.727316666666667</c:v>
                </c:pt>
                <c:pt idx="34">
                  <c:v>-31.648646666666664</c:v>
                </c:pt>
                <c:pt idx="35">
                  <c:v>-33.759869999999999</c:v>
                </c:pt>
                <c:pt idx="36">
                  <c:v>-34.488711111111115</c:v>
                </c:pt>
                <c:pt idx="37">
                  <c:v>-42.326455555555555</c:v>
                </c:pt>
                <c:pt idx="38">
                  <c:v>-40.635602222222218</c:v>
                </c:pt>
                <c:pt idx="39">
                  <c:v>-47.260712222222224</c:v>
                </c:pt>
                <c:pt idx="40">
                  <c:v>-53.134308888888903</c:v>
                </c:pt>
                <c:pt idx="41">
                  <c:v>-50.334343333333329</c:v>
                </c:pt>
                <c:pt idx="42">
                  <c:v>-50.336260000000003</c:v>
                </c:pt>
                <c:pt idx="43">
                  <c:v>-52.794566666666668</c:v>
                </c:pt>
                <c:pt idx="44">
                  <c:v>-50.181093333333337</c:v>
                </c:pt>
                <c:pt idx="45">
                  <c:v>-47.749043333333326</c:v>
                </c:pt>
                <c:pt idx="46">
                  <c:v>-51.008246666666672</c:v>
                </c:pt>
                <c:pt idx="47">
                  <c:v>-57.01965666666667</c:v>
                </c:pt>
                <c:pt idx="48">
                  <c:v>-56.616626666666669</c:v>
                </c:pt>
                <c:pt idx="49">
                  <c:v>-66.627933333333331</c:v>
                </c:pt>
                <c:pt idx="50">
                  <c:v>-69.818813333333352</c:v>
                </c:pt>
                <c:pt idx="51">
                  <c:v>-73.816757499999994</c:v>
                </c:pt>
                <c:pt idx="52">
                  <c:v>-85.674386666666678</c:v>
                </c:pt>
                <c:pt idx="53">
                  <c:v>-81.365092222222231</c:v>
                </c:pt>
                <c:pt idx="54">
                  <c:v>-78.250060000000005</c:v>
                </c:pt>
                <c:pt idx="55">
                  <c:v>-85.018915185185207</c:v>
                </c:pt>
                <c:pt idx="56">
                  <c:v>-85.694262222222221</c:v>
                </c:pt>
                <c:pt idx="57">
                  <c:v>-86.740563333333341</c:v>
                </c:pt>
                <c:pt idx="58">
                  <c:v>-90.875923333333347</c:v>
                </c:pt>
                <c:pt idx="59">
                  <c:v>-88.863203333333317</c:v>
                </c:pt>
                <c:pt idx="60">
                  <c:v>-80.020583333333335</c:v>
                </c:pt>
                <c:pt idx="61">
                  <c:v>-80.660529999999994</c:v>
                </c:pt>
                <c:pt idx="62">
                  <c:v>-80.239599999999996</c:v>
                </c:pt>
                <c:pt idx="63">
                  <c:v>-85.055743333333325</c:v>
                </c:pt>
                <c:pt idx="64">
                  <c:v>-91.008500833333343</c:v>
                </c:pt>
                <c:pt idx="65">
                  <c:v>-87.014566666666667</c:v>
                </c:pt>
                <c:pt idx="66">
                  <c:v>-81.611741904761899</c:v>
                </c:pt>
                <c:pt idx="67">
                  <c:v>-75.370081111111119</c:v>
                </c:pt>
                <c:pt idx="68">
                  <c:v>-91.084856666666667</c:v>
                </c:pt>
                <c:pt idx="69">
                  <c:v>-90.84057</c:v>
                </c:pt>
                <c:pt idx="70">
                  <c:v>-94.38537238095239</c:v>
                </c:pt>
                <c:pt idx="71">
                  <c:v>-94.95625037037037</c:v>
                </c:pt>
                <c:pt idx="72">
                  <c:v>-101.62888444444445</c:v>
                </c:pt>
                <c:pt idx="73">
                  <c:v>-100.16694333333334</c:v>
                </c:pt>
                <c:pt idx="74">
                  <c:v>-110.02058333333333</c:v>
                </c:pt>
                <c:pt idx="75">
                  <c:v>-106.29299000000002</c:v>
                </c:pt>
                <c:pt idx="76">
                  <c:v>-99.485918333333345</c:v>
                </c:pt>
                <c:pt idx="77">
                  <c:v>-100.27314000000001</c:v>
                </c:pt>
                <c:pt idx="78">
                  <c:v>-115.61771666666668</c:v>
                </c:pt>
                <c:pt idx="79">
                  <c:v>-115.15814666666667</c:v>
                </c:pt>
                <c:pt idx="80">
                  <c:v>-112.09031500000002</c:v>
                </c:pt>
                <c:pt idx="81">
                  <c:v>-116.78467333333334</c:v>
                </c:pt>
                <c:pt idx="82">
                  <c:v>-110.89267416666668</c:v>
                </c:pt>
                <c:pt idx="83">
                  <c:v>-109.89533333333334</c:v>
                </c:pt>
                <c:pt idx="84">
                  <c:v>-114.38850000000001</c:v>
                </c:pt>
                <c:pt idx="85">
                  <c:v>-117.40417666666667</c:v>
                </c:pt>
                <c:pt idx="86">
                  <c:v>-117.81505259259261</c:v>
                </c:pt>
                <c:pt idx="87">
                  <c:v>-118.44545333333333</c:v>
                </c:pt>
                <c:pt idx="88">
                  <c:v>-145.90739703703699</c:v>
                </c:pt>
                <c:pt idx="89">
                  <c:v>-133.84721999999999</c:v>
                </c:pt>
                <c:pt idx="90">
                  <c:v>-138.66376666666667</c:v>
                </c:pt>
                <c:pt idx="91">
                  <c:v>-143.78481916666667</c:v>
                </c:pt>
                <c:pt idx="92">
                  <c:v>-133.38727000000003</c:v>
                </c:pt>
                <c:pt idx="93">
                  <c:v>-141.39963833333334</c:v>
                </c:pt>
                <c:pt idx="94">
                  <c:v>-140.36248666666665</c:v>
                </c:pt>
                <c:pt idx="95">
                  <c:v>-136.36335666666665</c:v>
                </c:pt>
                <c:pt idx="96">
                  <c:v>-138.07094174603174</c:v>
                </c:pt>
                <c:pt idx="97">
                  <c:v>-141.40363333333332</c:v>
                </c:pt>
                <c:pt idx="98">
                  <c:v>-146.27913333333336</c:v>
                </c:pt>
                <c:pt idx="99">
                  <c:v>-149.46221</c:v>
                </c:pt>
                <c:pt idx="100">
                  <c:v>-150.33059166666666</c:v>
                </c:pt>
                <c:pt idx="101">
                  <c:v>-152.55080333333333</c:v>
                </c:pt>
                <c:pt idx="102">
                  <c:v>-154.44286</c:v>
                </c:pt>
                <c:pt idx="103">
                  <c:v>-157.76570814814812</c:v>
                </c:pt>
                <c:pt idx="104">
                  <c:v>-154.67076333333333</c:v>
                </c:pt>
                <c:pt idx="105">
                  <c:v>-158.87307666666666</c:v>
                </c:pt>
                <c:pt idx="106">
                  <c:v>-157.70952333333335</c:v>
                </c:pt>
                <c:pt idx="107">
                  <c:v>-159.91745</c:v>
                </c:pt>
                <c:pt idx="108">
                  <c:v>-164.00331333333335</c:v>
                </c:pt>
                <c:pt idx="109">
                  <c:v>-163.42561999999998</c:v>
                </c:pt>
                <c:pt idx="110">
                  <c:v>-169.70621333333335</c:v>
                </c:pt>
                <c:pt idx="111">
                  <c:v>-169.09865702380952</c:v>
                </c:pt>
                <c:pt idx="112">
                  <c:v>-165.45240222222222</c:v>
                </c:pt>
                <c:pt idx="113">
                  <c:v>-166.18361666666667</c:v>
                </c:pt>
                <c:pt idx="114">
                  <c:v>-167.68472999999997</c:v>
                </c:pt>
                <c:pt idx="115">
                  <c:v>-175.47284999999999</c:v>
                </c:pt>
                <c:pt idx="116">
                  <c:v>-172.68520000000001</c:v>
                </c:pt>
                <c:pt idx="117">
                  <c:v>-169.32324750000001</c:v>
                </c:pt>
                <c:pt idx="118">
                  <c:v>-170.68407000000002</c:v>
                </c:pt>
                <c:pt idx="119">
                  <c:v>-165.61552333333336</c:v>
                </c:pt>
                <c:pt idx="120">
                  <c:v>-165.99959666666663</c:v>
                </c:pt>
                <c:pt idx="121">
                  <c:v>-176.71704619047622</c:v>
                </c:pt>
                <c:pt idx="122">
                  <c:v>-178.83247333333335</c:v>
                </c:pt>
                <c:pt idx="123">
                  <c:v>-189.40525333333335</c:v>
                </c:pt>
                <c:pt idx="124">
                  <c:v>-203.1715833333333</c:v>
                </c:pt>
                <c:pt idx="125">
                  <c:v>-197.06778750000001</c:v>
                </c:pt>
                <c:pt idx="126">
                  <c:v>-215.76407777777777</c:v>
                </c:pt>
                <c:pt idx="127">
                  <c:v>-205.89198250000001</c:v>
                </c:pt>
                <c:pt idx="128">
                  <c:v>-192.52622666666664</c:v>
                </c:pt>
                <c:pt idx="129">
                  <c:v>-179.6807725925926</c:v>
                </c:pt>
                <c:pt idx="130">
                  <c:v>-190.62778904761907</c:v>
                </c:pt>
                <c:pt idx="131">
                  <c:v>-206.81771333333333</c:v>
                </c:pt>
                <c:pt idx="132">
                  <c:v>-211.58381166666666</c:v>
                </c:pt>
                <c:pt idx="133">
                  <c:v>-206.94772083333331</c:v>
                </c:pt>
                <c:pt idx="134">
                  <c:v>-191.9586757142857</c:v>
                </c:pt>
                <c:pt idx="135">
                  <c:v>-206.03618666666668</c:v>
                </c:pt>
                <c:pt idx="136">
                  <c:v>-216.29958999999999</c:v>
                </c:pt>
                <c:pt idx="137">
                  <c:v>-218.25675666666666</c:v>
                </c:pt>
                <c:pt idx="138">
                  <c:v>-212.32350333333332</c:v>
                </c:pt>
                <c:pt idx="139">
                  <c:v>-209.47524333333334</c:v>
                </c:pt>
                <c:pt idx="140">
                  <c:v>-212.6934</c:v>
                </c:pt>
                <c:pt idx="141">
                  <c:v>-216.5669383333333</c:v>
                </c:pt>
                <c:pt idx="142">
                  <c:v>-221.24391333333332</c:v>
                </c:pt>
                <c:pt idx="143">
                  <c:v>-212.2722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35D-487D-AA56-723F0F6E2093}"/>
            </c:ext>
          </c:extLst>
        </c:ser>
        <c:ser>
          <c:idx val="1"/>
          <c:order val="1"/>
          <c:tx>
            <c:v>Water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Net Na+ flux'!$T$4:$T$147</c:f>
                <c:numCache>
                  <c:formatCode>General</c:formatCode>
                  <c:ptCount val="144"/>
                  <c:pt idx="0">
                    <c:v>2.6900150129391012</c:v>
                  </c:pt>
                  <c:pt idx="1">
                    <c:v>1.735944005116167</c:v>
                  </c:pt>
                  <c:pt idx="2">
                    <c:v>0.72924806227244976</c:v>
                  </c:pt>
                  <c:pt idx="3">
                    <c:v>0</c:v>
                  </c:pt>
                  <c:pt idx="4">
                    <c:v>4.3068904295629844</c:v>
                  </c:pt>
                  <c:pt idx="5">
                    <c:v>3.9499621193183612</c:v>
                  </c:pt>
                  <c:pt idx="6">
                    <c:v>3.0201096309902398</c:v>
                  </c:pt>
                  <c:pt idx="7">
                    <c:v>3.7764876126898645</c:v>
                  </c:pt>
                  <c:pt idx="8">
                    <c:v>3.3441201002655387</c:v>
                  </c:pt>
                  <c:pt idx="9">
                    <c:v>3.7351855056007599</c:v>
                  </c:pt>
                  <c:pt idx="10">
                    <c:v>2.7395932998257244</c:v>
                  </c:pt>
                  <c:pt idx="11">
                    <c:v>2.924621931258808</c:v>
                  </c:pt>
                  <c:pt idx="12">
                    <c:v>2.2641559133593243</c:v>
                  </c:pt>
                  <c:pt idx="13">
                    <c:v>2.0697298328042728</c:v>
                  </c:pt>
                  <c:pt idx="14">
                    <c:v>1.9385271797076526</c:v>
                  </c:pt>
                  <c:pt idx="15">
                    <c:v>2.5362435316920973</c:v>
                  </c:pt>
                  <c:pt idx="16">
                    <c:v>2.2694097167435414</c:v>
                  </c:pt>
                  <c:pt idx="17">
                    <c:v>3.2354731433362258</c:v>
                  </c:pt>
                  <c:pt idx="18">
                    <c:v>2.3194223692243208</c:v>
                  </c:pt>
                  <c:pt idx="19">
                    <c:v>1.7471636291295463</c:v>
                  </c:pt>
                  <c:pt idx="20">
                    <c:v>1.812463958279372</c:v>
                  </c:pt>
                  <c:pt idx="21">
                    <c:v>3.0786085749978027</c:v>
                  </c:pt>
                  <c:pt idx="22">
                    <c:v>3.9468538799387738</c:v>
                  </c:pt>
                  <c:pt idx="23">
                    <c:v>1.9412697438661126</c:v>
                  </c:pt>
                  <c:pt idx="24">
                    <c:v>2.3826387256149437</c:v>
                  </c:pt>
                  <c:pt idx="25">
                    <c:v>2.6540758057090228</c:v>
                  </c:pt>
                  <c:pt idx="26">
                    <c:v>3.4182248909338888</c:v>
                  </c:pt>
                  <c:pt idx="27">
                    <c:v>3.8270891841041199</c:v>
                  </c:pt>
                  <c:pt idx="28">
                    <c:v>3.1001611896883676</c:v>
                  </c:pt>
                  <c:pt idx="29">
                    <c:v>2.6234651531514568</c:v>
                  </c:pt>
                  <c:pt idx="30">
                    <c:v>3.7892791743615315</c:v>
                  </c:pt>
                  <c:pt idx="31">
                    <c:v>3.2461999532068262</c:v>
                  </c:pt>
                  <c:pt idx="32">
                    <c:v>2.8413247524350345</c:v>
                  </c:pt>
                  <c:pt idx="33">
                    <c:v>2.1445258203512334</c:v>
                  </c:pt>
                  <c:pt idx="34">
                    <c:v>4.4158341188022598</c:v>
                  </c:pt>
                  <c:pt idx="35">
                    <c:v>4.0583403756708227</c:v>
                  </c:pt>
                  <c:pt idx="36">
                    <c:v>2.7838864685992482</c:v>
                  </c:pt>
                  <c:pt idx="37">
                    <c:v>4.0450768202227163</c:v>
                  </c:pt>
                  <c:pt idx="38">
                    <c:v>4.6873861037482794</c:v>
                  </c:pt>
                  <c:pt idx="39">
                    <c:v>4.0273266722479795</c:v>
                  </c:pt>
                  <c:pt idx="40">
                    <c:v>4.3252519723653089</c:v>
                  </c:pt>
                  <c:pt idx="41">
                    <c:v>4.003384036637005</c:v>
                  </c:pt>
                  <c:pt idx="42">
                    <c:v>4.0196757768755429</c:v>
                  </c:pt>
                  <c:pt idx="43">
                    <c:v>6.3802598419852767</c:v>
                  </c:pt>
                  <c:pt idx="44">
                    <c:v>4.9520102100056294</c:v>
                  </c:pt>
                  <c:pt idx="45">
                    <c:v>3.7333258147662391</c:v>
                  </c:pt>
                  <c:pt idx="46">
                    <c:v>5.132152733580714</c:v>
                  </c:pt>
                  <c:pt idx="47">
                    <c:v>5.9356310979751772</c:v>
                  </c:pt>
                  <c:pt idx="48">
                    <c:v>5.1254635034306881</c:v>
                  </c:pt>
                  <c:pt idx="49">
                    <c:v>4.0040133616722606</c:v>
                  </c:pt>
                  <c:pt idx="50">
                    <c:v>4.6369729257835886</c:v>
                  </c:pt>
                  <c:pt idx="51">
                    <c:v>4.6951059420318861</c:v>
                  </c:pt>
                  <c:pt idx="52">
                    <c:v>4.5981661199578694</c:v>
                  </c:pt>
                  <c:pt idx="53">
                    <c:v>4.6578396468964023</c:v>
                  </c:pt>
                  <c:pt idx="54">
                    <c:v>4.5231499472159866</c:v>
                  </c:pt>
                  <c:pt idx="55">
                    <c:v>5.666371906767151</c:v>
                  </c:pt>
                  <c:pt idx="56">
                    <c:v>4.1516219022449512</c:v>
                  </c:pt>
                  <c:pt idx="57">
                    <c:v>6.0169695910150667</c:v>
                  </c:pt>
                  <c:pt idx="58">
                    <c:v>3.3188056774990629</c:v>
                  </c:pt>
                  <c:pt idx="59">
                    <c:v>6.8390590058903582</c:v>
                  </c:pt>
                  <c:pt idx="60">
                    <c:v>8.549189685122208</c:v>
                  </c:pt>
                  <c:pt idx="61">
                    <c:v>7.6506054586581573</c:v>
                  </c:pt>
                  <c:pt idx="62">
                    <c:v>6.8760477616142257</c:v>
                  </c:pt>
                  <c:pt idx="63">
                    <c:v>7.5728150703114201</c:v>
                  </c:pt>
                  <c:pt idx="64">
                    <c:v>5.9631116245146911</c:v>
                  </c:pt>
                  <c:pt idx="65">
                    <c:v>7.707470986001181</c:v>
                  </c:pt>
                  <c:pt idx="66">
                    <c:v>6.2057812437274968</c:v>
                  </c:pt>
                  <c:pt idx="67">
                    <c:v>6.3754727290766464</c:v>
                  </c:pt>
                  <c:pt idx="68">
                    <c:v>7.0207430222484302</c:v>
                  </c:pt>
                  <c:pt idx="69">
                    <c:v>8.4821276779944768</c:v>
                  </c:pt>
                  <c:pt idx="70">
                    <c:v>7.1078858518093124</c:v>
                  </c:pt>
                  <c:pt idx="71">
                    <c:v>8.1693177801331736</c:v>
                  </c:pt>
                  <c:pt idx="72">
                    <c:v>7.6528116318154575</c:v>
                  </c:pt>
                  <c:pt idx="73">
                    <c:v>7.4639716948317805</c:v>
                  </c:pt>
                  <c:pt idx="74">
                    <c:v>10.136418134716026</c:v>
                  </c:pt>
                  <c:pt idx="75">
                    <c:v>4.9440340455138454</c:v>
                  </c:pt>
                  <c:pt idx="76">
                    <c:v>6.8880402926231445</c:v>
                  </c:pt>
                  <c:pt idx="77">
                    <c:v>5.6700276488258829</c:v>
                  </c:pt>
                  <c:pt idx="78">
                    <c:v>6.0637093492514973</c:v>
                  </c:pt>
                  <c:pt idx="79">
                    <c:v>7.8242425998463263</c:v>
                  </c:pt>
                  <c:pt idx="80">
                    <c:v>7.9047962043590934</c:v>
                  </c:pt>
                  <c:pt idx="81">
                    <c:v>5.7113014716437434</c:v>
                  </c:pt>
                  <c:pt idx="82">
                    <c:v>6.5705458123364799</c:v>
                  </c:pt>
                  <c:pt idx="83">
                    <c:v>9.2444665698595045</c:v>
                  </c:pt>
                  <c:pt idx="84">
                    <c:v>9.0652609627694947</c:v>
                  </c:pt>
                  <c:pt idx="85">
                    <c:v>7.2660030093029855</c:v>
                  </c:pt>
                  <c:pt idx="86">
                    <c:v>7.0703112076096026</c:v>
                  </c:pt>
                  <c:pt idx="87">
                    <c:v>9.4145752482095553</c:v>
                  </c:pt>
                  <c:pt idx="88">
                    <c:v>9.0551351936629008</c:v>
                  </c:pt>
                  <c:pt idx="89">
                    <c:v>9.4269354747446936</c:v>
                  </c:pt>
                  <c:pt idx="90">
                    <c:v>9.1480101338378503</c:v>
                  </c:pt>
                  <c:pt idx="91">
                    <c:v>8.1977010463300033</c:v>
                  </c:pt>
                  <c:pt idx="92">
                    <c:v>8.4322130103105213</c:v>
                  </c:pt>
                  <c:pt idx="93">
                    <c:v>8.6202468455636438</c:v>
                  </c:pt>
                  <c:pt idx="94">
                    <c:v>8.2239134947085866</c:v>
                  </c:pt>
                  <c:pt idx="95">
                    <c:v>10.325286355970958</c:v>
                  </c:pt>
                  <c:pt idx="96">
                    <c:v>9.0886705184348848</c:v>
                  </c:pt>
                  <c:pt idx="97">
                    <c:v>10.808220842084882</c:v>
                  </c:pt>
                  <c:pt idx="98">
                    <c:v>10.026257969274978</c:v>
                  </c:pt>
                  <c:pt idx="99">
                    <c:v>8.8397045061727102</c:v>
                  </c:pt>
                  <c:pt idx="100">
                    <c:v>9.1592130622744516</c:v>
                  </c:pt>
                  <c:pt idx="101">
                    <c:v>8.8997308008276299</c:v>
                  </c:pt>
                  <c:pt idx="102">
                    <c:v>8.9456856705369407</c:v>
                  </c:pt>
                  <c:pt idx="103">
                    <c:v>10.606029746979665</c:v>
                  </c:pt>
                  <c:pt idx="104">
                    <c:v>9.6896627670615185</c:v>
                  </c:pt>
                  <c:pt idx="105">
                    <c:v>9.0183738906203263</c:v>
                  </c:pt>
                  <c:pt idx="106">
                    <c:v>10.945567495495615</c:v>
                  </c:pt>
                  <c:pt idx="107">
                    <c:v>12.607416923708049</c:v>
                  </c:pt>
                  <c:pt idx="108">
                    <c:v>8.6590210459100199</c:v>
                  </c:pt>
                  <c:pt idx="109">
                    <c:v>6.0457357050262583</c:v>
                  </c:pt>
                  <c:pt idx="110">
                    <c:v>6.4330382921330296</c:v>
                  </c:pt>
                  <c:pt idx="111">
                    <c:v>8.2963424423055283</c:v>
                  </c:pt>
                  <c:pt idx="112">
                    <c:v>6.6437207575875714</c:v>
                  </c:pt>
                  <c:pt idx="113">
                    <c:v>9.4222756410566717</c:v>
                  </c:pt>
                  <c:pt idx="114">
                    <c:v>12.671551508761656</c:v>
                  </c:pt>
                  <c:pt idx="115">
                    <c:v>13.048945004482636</c:v>
                  </c:pt>
                  <c:pt idx="116">
                    <c:v>15.108595030121101</c:v>
                  </c:pt>
                  <c:pt idx="117">
                    <c:v>12.117384853277937</c:v>
                  </c:pt>
                  <c:pt idx="118">
                    <c:v>12.447723928244873</c:v>
                  </c:pt>
                  <c:pt idx="119">
                    <c:v>13.241217944888987</c:v>
                  </c:pt>
                  <c:pt idx="120">
                    <c:v>12.821663207339757</c:v>
                  </c:pt>
                  <c:pt idx="121">
                    <c:v>14.888953521748943</c:v>
                  </c:pt>
                  <c:pt idx="122">
                    <c:v>14.798482744630029</c:v>
                  </c:pt>
                  <c:pt idx="123">
                    <c:v>21.120219679544594</c:v>
                  </c:pt>
                  <c:pt idx="124">
                    <c:v>23.473427835252338</c:v>
                  </c:pt>
                  <c:pt idx="125">
                    <c:v>19.323573699960377</c:v>
                  </c:pt>
                  <c:pt idx="126">
                    <c:v>16.075627193004006</c:v>
                  </c:pt>
                  <c:pt idx="127">
                    <c:v>17.846581626205136</c:v>
                  </c:pt>
                  <c:pt idx="128">
                    <c:v>18.257843572559445</c:v>
                  </c:pt>
                  <c:pt idx="129">
                    <c:v>17.591734842546085</c:v>
                  </c:pt>
                  <c:pt idx="130">
                    <c:v>18.669839338617788</c:v>
                  </c:pt>
                  <c:pt idx="131">
                    <c:v>16.018485894016329</c:v>
                  </c:pt>
                  <c:pt idx="132">
                    <c:v>15.320941553534034</c:v>
                  </c:pt>
                  <c:pt idx="133">
                    <c:v>16.568204847846371</c:v>
                  </c:pt>
                  <c:pt idx="134">
                    <c:v>18.223824665316545</c:v>
                  </c:pt>
                  <c:pt idx="135">
                    <c:v>19.399778008513191</c:v>
                  </c:pt>
                  <c:pt idx="136">
                    <c:v>17.153088221904827</c:v>
                  </c:pt>
                  <c:pt idx="137">
                    <c:v>18.19555251589961</c:v>
                  </c:pt>
                  <c:pt idx="138">
                    <c:v>15.046659547156967</c:v>
                  </c:pt>
                  <c:pt idx="139">
                    <c:v>21.661233363224046</c:v>
                  </c:pt>
                  <c:pt idx="140">
                    <c:v>23.96147293562731</c:v>
                  </c:pt>
                  <c:pt idx="141">
                    <c:v>22.619737818325824</c:v>
                  </c:pt>
                  <c:pt idx="142">
                    <c:v>19.700546467146559</c:v>
                  </c:pt>
                  <c:pt idx="143">
                    <c:v>21.097372273770265</c:v>
                  </c:pt>
                </c:numCache>
              </c:numRef>
            </c:plus>
            <c:minus>
              <c:numRef>
                <c:f>'Net Na+ flux'!$T$4:$T$147</c:f>
                <c:numCache>
                  <c:formatCode>General</c:formatCode>
                  <c:ptCount val="144"/>
                  <c:pt idx="0">
                    <c:v>2.6900150129391012</c:v>
                  </c:pt>
                  <c:pt idx="1">
                    <c:v>1.735944005116167</c:v>
                  </c:pt>
                  <c:pt idx="2">
                    <c:v>0.72924806227244976</c:v>
                  </c:pt>
                  <c:pt idx="3">
                    <c:v>0</c:v>
                  </c:pt>
                  <c:pt idx="4">
                    <c:v>4.3068904295629844</c:v>
                  </c:pt>
                  <c:pt idx="5">
                    <c:v>3.9499621193183612</c:v>
                  </c:pt>
                  <c:pt idx="6">
                    <c:v>3.0201096309902398</c:v>
                  </c:pt>
                  <c:pt idx="7">
                    <c:v>3.7764876126898645</c:v>
                  </c:pt>
                  <c:pt idx="8">
                    <c:v>3.3441201002655387</c:v>
                  </c:pt>
                  <c:pt idx="9">
                    <c:v>3.7351855056007599</c:v>
                  </c:pt>
                  <c:pt idx="10">
                    <c:v>2.7395932998257244</c:v>
                  </c:pt>
                  <c:pt idx="11">
                    <c:v>2.924621931258808</c:v>
                  </c:pt>
                  <c:pt idx="12">
                    <c:v>2.2641559133593243</c:v>
                  </c:pt>
                  <c:pt idx="13">
                    <c:v>2.0697298328042728</c:v>
                  </c:pt>
                  <c:pt idx="14">
                    <c:v>1.9385271797076526</c:v>
                  </c:pt>
                  <c:pt idx="15">
                    <c:v>2.5362435316920973</c:v>
                  </c:pt>
                  <c:pt idx="16">
                    <c:v>2.2694097167435414</c:v>
                  </c:pt>
                  <c:pt idx="17">
                    <c:v>3.2354731433362258</c:v>
                  </c:pt>
                  <c:pt idx="18">
                    <c:v>2.3194223692243208</c:v>
                  </c:pt>
                  <c:pt idx="19">
                    <c:v>1.7471636291295463</c:v>
                  </c:pt>
                  <c:pt idx="20">
                    <c:v>1.812463958279372</c:v>
                  </c:pt>
                  <c:pt idx="21">
                    <c:v>3.0786085749978027</c:v>
                  </c:pt>
                  <c:pt idx="22">
                    <c:v>3.9468538799387738</c:v>
                  </c:pt>
                  <c:pt idx="23">
                    <c:v>1.9412697438661126</c:v>
                  </c:pt>
                  <c:pt idx="24">
                    <c:v>2.3826387256149437</c:v>
                  </c:pt>
                  <c:pt idx="25">
                    <c:v>2.6540758057090228</c:v>
                  </c:pt>
                  <c:pt idx="26">
                    <c:v>3.4182248909338888</c:v>
                  </c:pt>
                  <c:pt idx="27">
                    <c:v>3.8270891841041199</c:v>
                  </c:pt>
                  <c:pt idx="28">
                    <c:v>3.1001611896883676</c:v>
                  </c:pt>
                  <c:pt idx="29">
                    <c:v>2.6234651531514568</c:v>
                  </c:pt>
                  <c:pt idx="30">
                    <c:v>3.7892791743615315</c:v>
                  </c:pt>
                  <c:pt idx="31">
                    <c:v>3.2461999532068262</c:v>
                  </c:pt>
                  <c:pt idx="32">
                    <c:v>2.8413247524350345</c:v>
                  </c:pt>
                  <c:pt idx="33">
                    <c:v>2.1445258203512334</c:v>
                  </c:pt>
                  <c:pt idx="34">
                    <c:v>4.4158341188022598</c:v>
                  </c:pt>
                  <c:pt idx="35">
                    <c:v>4.0583403756708227</c:v>
                  </c:pt>
                  <c:pt idx="36">
                    <c:v>2.7838864685992482</c:v>
                  </c:pt>
                  <c:pt idx="37">
                    <c:v>4.0450768202227163</c:v>
                  </c:pt>
                  <c:pt idx="38">
                    <c:v>4.6873861037482794</c:v>
                  </c:pt>
                  <c:pt idx="39">
                    <c:v>4.0273266722479795</c:v>
                  </c:pt>
                  <c:pt idx="40">
                    <c:v>4.3252519723653089</c:v>
                  </c:pt>
                  <c:pt idx="41">
                    <c:v>4.003384036637005</c:v>
                  </c:pt>
                  <c:pt idx="42">
                    <c:v>4.0196757768755429</c:v>
                  </c:pt>
                  <c:pt idx="43">
                    <c:v>6.3802598419852767</c:v>
                  </c:pt>
                  <c:pt idx="44">
                    <c:v>4.9520102100056294</c:v>
                  </c:pt>
                  <c:pt idx="45">
                    <c:v>3.7333258147662391</c:v>
                  </c:pt>
                  <c:pt idx="46">
                    <c:v>5.132152733580714</c:v>
                  </c:pt>
                  <c:pt idx="47">
                    <c:v>5.9356310979751772</c:v>
                  </c:pt>
                  <c:pt idx="48">
                    <c:v>5.1254635034306881</c:v>
                  </c:pt>
                  <c:pt idx="49">
                    <c:v>4.0040133616722606</c:v>
                  </c:pt>
                  <c:pt idx="50">
                    <c:v>4.6369729257835886</c:v>
                  </c:pt>
                  <c:pt idx="51">
                    <c:v>4.6951059420318861</c:v>
                  </c:pt>
                  <c:pt idx="52">
                    <c:v>4.5981661199578694</c:v>
                  </c:pt>
                  <c:pt idx="53">
                    <c:v>4.6578396468964023</c:v>
                  </c:pt>
                  <c:pt idx="54">
                    <c:v>4.5231499472159866</c:v>
                  </c:pt>
                  <c:pt idx="55">
                    <c:v>5.666371906767151</c:v>
                  </c:pt>
                  <c:pt idx="56">
                    <c:v>4.1516219022449512</c:v>
                  </c:pt>
                  <c:pt idx="57">
                    <c:v>6.0169695910150667</c:v>
                  </c:pt>
                  <c:pt idx="58">
                    <c:v>3.3188056774990629</c:v>
                  </c:pt>
                  <c:pt idx="59">
                    <c:v>6.8390590058903582</c:v>
                  </c:pt>
                  <c:pt idx="60">
                    <c:v>8.549189685122208</c:v>
                  </c:pt>
                  <c:pt idx="61">
                    <c:v>7.6506054586581573</c:v>
                  </c:pt>
                  <c:pt idx="62">
                    <c:v>6.8760477616142257</c:v>
                  </c:pt>
                  <c:pt idx="63">
                    <c:v>7.5728150703114201</c:v>
                  </c:pt>
                  <c:pt idx="64">
                    <c:v>5.9631116245146911</c:v>
                  </c:pt>
                  <c:pt idx="65">
                    <c:v>7.707470986001181</c:v>
                  </c:pt>
                  <c:pt idx="66">
                    <c:v>6.2057812437274968</c:v>
                  </c:pt>
                  <c:pt idx="67">
                    <c:v>6.3754727290766464</c:v>
                  </c:pt>
                  <c:pt idx="68">
                    <c:v>7.0207430222484302</c:v>
                  </c:pt>
                  <c:pt idx="69">
                    <c:v>8.4821276779944768</c:v>
                  </c:pt>
                  <c:pt idx="70">
                    <c:v>7.1078858518093124</c:v>
                  </c:pt>
                  <c:pt idx="71">
                    <c:v>8.1693177801331736</c:v>
                  </c:pt>
                  <c:pt idx="72">
                    <c:v>7.6528116318154575</c:v>
                  </c:pt>
                  <c:pt idx="73">
                    <c:v>7.4639716948317805</c:v>
                  </c:pt>
                  <c:pt idx="74">
                    <c:v>10.136418134716026</c:v>
                  </c:pt>
                  <c:pt idx="75">
                    <c:v>4.9440340455138454</c:v>
                  </c:pt>
                  <c:pt idx="76">
                    <c:v>6.8880402926231445</c:v>
                  </c:pt>
                  <c:pt idx="77">
                    <c:v>5.6700276488258829</c:v>
                  </c:pt>
                  <c:pt idx="78">
                    <c:v>6.0637093492514973</c:v>
                  </c:pt>
                  <c:pt idx="79">
                    <c:v>7.8242425998463263</c:v>
                  </c:pt>
                  <c:pt idx="80">
                    <c:v>7.9047962043590934</c:v>
                  </c:pt>
                  <c:pt idx="81">
                    <c:v>5.7113014716437434</c:v>
                  </c:pt>
                  <c:pt idx="82">
                    <c:v>6.5705458123364799</c:v>
                  </c:pt>
                  <c:pt idx="83">
                    <c:v>9.2444665698595045</c:v>
                  </c:pt>
                  <c:pt idx="84">
                    <c:v>9.0652609627694947</c:v>
                  </c:pt>
                  <c:pt idx="85">
                    <c:v>7.2660030093029855</c:v>
                  </c:pt>
                  <c:pt idx="86">
                    <c:v>7.0703112076096026</c:v>
                  </c:pt>
                  <c:pt idx="87">
                    <c:v>9.4145752482095553</c:v>
                  </c:pt>
                  <c:pt idx="88">
                    <c:v>9.0551351936629008</c:v>
                  </c:pt>
                  <c:pt idx="89">
                    <c:v>9.4269354747446936</c:v>
                  </c:pt>
                  <c:pt idx="90">
                    <c:v>9.1480101338378503</c:v>
                  </c:pt>
                  <c:pt idx="91">
                    <c:v>8.1977010463300033</c:v>
                  </c:pt>
                  <c:pt idx="92">
                    <c:v>8.4322130103105213</c:v>
                  </c:pt>
                  <c:pt idx="93">
                    <c:v>8.6202468455636438</c:v>
                  </c:pt>
                  <c:pt idx="94">
                    <c:v>8.2239134947085866</c:v>
                  </c:pt>
                  <c:pt idx="95">
                    <c:v>10.325286355970958</c:v>
                  </c:pt>
                  <c:pt idx="96">
                    <c:v>9.0886705184348848</c:v>
                  </c:pt>
                  <c:pt idx="97">
                    <c:v>10.808220842084882</c:v>
                  </c:pt>
                  <c:pt idx="98">
                    <c:v>10.026257969274978</c:v>
                  </c:pt>
                  <c:pt idx="99">
                    <c:v>8.8397045061727102</c:v>
                  </c:pt>
                  <c:pt idx="100">
                    <c:v>9.1592130622744516</c:v>
                  </c:pt>
                  <c:pt idx="101">
                    <c:v>8.8997308008276299</c:v>
                  </c:pt>
                  <c:pt idx="102">
                    <c:v>8.9456856705369407</c:v>
                  </c:pt>
                  <c:pt idx="103">
                    <c:v>10.606029746979665</c:v>
                  </c:pt>
                  <c:pt idx="104">
                    <c:v>9.6896627670615185</c:v>
                  </c:pt>
                  <c:pt idx="105">
                    <c:v>9.0183738906203263</c:v>
                  </c:pt>
                  <c:pt idx="106">
                    <c:v>10.945567495495615</c:v>
                  </c:pt>
                  <c:pt idx="107">
                    <c:v>12.607416923708049</c:v>
                  </c:pt>
                  <c:pt idx="108">
                    <c:v>8.6590210459100199</c:v>
                  </c:pt>
                  <c:pt idx="109">
                    <c:v>6.0457357050262583</c:v>
                  </c:pt>
                  <c:pt idx="110">
                    <c:v>6.4330382921330296</c:v>
                  </c:pt>
                  <c:pt idx="111">
                    <c:v>8.2963424423055283</c:v>
                  </c:pt>
                  <c:pt idx="112">
                    <c:v>6.6437207575875714</c:v>
                  </c:pt>
                  <c:pt idx="113">
                    <c:v>9.4222756410566717</c:v>
                  </c:pt>
                  <c:pt idx="114">
                    <c:v>12.671551508761656</c:v>
                  </c:pt>
                  <c:pt idx="115">
                    <c:v>13.048945004482636</c:v>
                  </c:pt>
                  <c:pt idx="116">
                    <c:v>15.108595030121101</c:v>
                  </c:pt>
                  <c:pt idx="117">
                    <c:v>12.117384853277937</c:v>
                  </c:pt>
                  <c:pt idx="118">
                    <c:v>12.447723928244873</c:v>
                  </c:pt>
                  <c:pt idx="119">
                    <c:v>13.241217944888987</c:v>
                  </c:pt>
                  <c:pt idx="120">
                    <c:v>12.821663207339757</c:v>
                  </c:pt>
                  <c:pt idx="121">
                    <c:v>14.888953521748943</c:v>
                  </c:pt>
                  <c:pt idx="122">
                    <c:v>14.798482744630029</c:v>
                  </c:pt>
                  <c:pt idx="123">
                    <c:v>21.120219679544594</c:v>
                  </c:pt>
                  <c:pt idx="124">
                    <c:v>23.473427835252338</c:v>
                  </c:pt>
                  <c:pt idx="125">
                    <c:v>19.323573699960377</c:v>
                  </c:pt>
                  <c:pt idx="126">
                    <c:v>16.075627193004006</c:v>
                  </c:pt>
                  <c:pt idx="127">
                    <c:v>17.846581626205136</c:v>
                  </c:pt>
                  <c:pt idx="128">
                    <c:v>18.257843572559445</c:v>
                  </c:pt>
                  <c:pt idx="129">
                    <c:v>17.591734842546085</c:v>
                  </c:pt>
                  <c:pt idx="130">
                    <c:v>18.669839338617788</c:v>
                  </c:pt>
                  <c:pt idx="131">
                    <c:v>16.018485894016329</c:v>
                  </c:pt>
                  <c:pt idx="132">
                    <c:v>15.320941553534034</c:v>
                  </c:pt>
                  <c:pt idx="133">
                    <c:v>16.568204847846371</c:v>
                  </c:pt>
                  <c:pt idx="134">
                    <c:v>18.223824665316545</c:v>
                  </c:pt>
                  <c:pt idx="135">
                    <c:v>19.399778008513191</c:v>
                  </c:pt>
                  <c:pt idx="136">
                    <c:v>17.153088221904827</c:v>
                  </c:pt>
                  <c:pt idx="137">
                    <c:v>18.19555251589961</c:v>
                  </c:pt>
                  <c:pt idx="138">
                    <c:v>15.046659547156967</c:v>
                  </c:pt>
                  <c:pt idx="139">
                    <c:v>21.661233363224046</c:v>
                  </c:pt>
                  <c:pt idx="140">
                    <c:v>23.96147293562731</c:v>
                  </c:pt>
                  <c:pt idx="141">
                    <c:v>22.619737818325824</c:v>
                  </c:pt>
                  <c:pt idx="142">
                    <c:v>19.700546467146559</c:v>
                  </c:pt>
                  <c:pt idx="143">
                    <c:v>21.097372273770265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Net Na+ flux'!$O$4:$O$147</c:f>
              <c:numCache>
                <c:formatCode>General</c:formatCode>
                <c:ptCount val="144"/>
                <c:pt idx="0">
                  <c:v>8.3333333333333329E-2</c:v>
                </c:pt>
                <c:pt idx="1">
                  <c:v>0.16666666666666666</c:v>
                </c:pt>
                <c:pt idx="2">
                  <c:v>0.25</c:v>
                </c:pt>
                <c:pt idx="3">
                  <c:v>0.33333333333333331</c:v>
                </c:pt>
                <c:pt idx="4">
                  <c:v>0.41666666666666663</c:v>
                </c:pt>
                <c:pt idx="5">
                  <c:v>0.49999999999999994</c:v>
                </c:pt>
                <c:pt idx="6">
                  <c:v>0.58333333333333326</c:v>
                </c:pt>
                <c:pt idx="7">
                  <c:v>0.66666666666666663</c:v>
                </c:pt>
                <c:pt idx="8">
                  <c:v>0.75</c:v>
                </c:pt>
                <c:pt idx="9">
                  <c:v>0.83333333333333337</c:v>
                </c:pt>
                <c:pt idx="10">
                  <c:v>0.91666666666666674</c:v>
                </c:pt>
                <c:pt idx="11">
                  <c:v>1</c:v>
                </c:pt>
                <c:pt idx="12">
                  <c:v>1.0833333333333333</c:v>
                </c:pt>
                <c:pt idx="13">
                  <c:v>1.1666666666666665</c:v>
                </c:pt>
                <c:pt idx="14">
                  <c:v>1.2499999999999998</c:v>
                </c:pt>
                <c:pt idx="15">
                  <c:v>1.333333333333333</c:v>
                </c:pt>
                <c:pt idx="16">
                  <c:v>1.4166666666666663</c:v>
                </c:pt>
                <c:pt idx="17">
                  <c:v>1.4999999999999996</c:v>
                </c:pt>
                <c:pt idx="18">
                  <c:v>1.5833333333333328</c:v>
                </c:pt>
                <c:pt idx="19">
                  <c:v>1.6666666666666661</c:v>
                </c:pt>
                <c:pt idx="20">
                  <c:v>1.7499999999999993</c:v>
                </c:pt>
                <c:pt idx="21">
                  <c:v>1.8333333333333326</c:v>
                </c:pt>
                <c:pt idx="22">
                  <c:v>1.9166666666666659</c:v>
                </c:pt>
                <c:pt idx="23">
                  <c:v>1.9999999999999991</c:v>
                </c:pt>
                <c:pt idx="24">
                  <c:v>2.0833333333333326</c:v>
                </c:pt>
                <c:pt idx="25">
                  <c:v>2.1666666666666661</c:v>
                </c:pt>
                <c:pt idx="26">
                  <c:v>2.2499999999999996</c:v>
                </c:pt>
                <c:pt idx="27">
                  <c:v>2.333333333333333</c:v>
                </c:pt>
                <c:pt idx="28">
                  <c:v>2.4166666666666665</c:v>
                </c:pt>
                <c:pt idx="29">
                  <c:v>2.5</c:v>
                </c:pt>
                <c:pt idx="30">
                  <c:v>2.5833333333333335</c:v>
                </c:pt>
                <c:pt idx="31">
                  <c:v>2.666666666666667</c:v>
                </c:pt>
                <c:pt idx="32">
                  <c:v>2.7500000000000004</c:v>
                </c:pt>
                <c:pt idx="33">
                  <c:v>2.8333333333333339</c:v>
                </c:pt>
                <c:pt idx="34">
                  <c:v>2.9166666666666674</c:v>
                </c:pt>
                <c:pt idx="35">
                  <c:v>3.0000000000000009</c:v>
                </c:pt>
                <c:pt idx="36">
                  <c:v>3.0833333333333344</c:v>
                </c:pt>
                <c:pt idx="37">
                  <c:v>3.1666666666666679</c:v>
                </c:pt>
                <c:pt idx="38">
                  <c:v>3.2500000000000013</c:v>
                </c:pt>
                <c:pt idx="39">
                  <c:v>3.3333333333333348</c:v>
                </c:pt>
                <c:pt idx="40">
                  <c:v>3.4166666666666683</c:v>
                </c:pt>
                <c:pt idx="41">
                  <c:v>3.5000000000000018</c:v>
                </c:pt>
                <c:pt idx="42">
                  <c:v>3.5833333333333353</c:v>
                </c:pt>
                <c:pt idx="43">
                  <c:v>3.6666666666666687</c:v>
                </c:pt>
                <c:pt idx="44">
                  <c:v>3.7500000000000022</c:v>
                </c:pt>
                <c:pt idx="45">
                  <c:v>3.8333333333333357</c:v>
                </c:pt>
                <c:pt idx="46">
                  <c:v>3.9166666666666692</c:v>
                </c:pt>
                <c:pt idx="47">
                  <c:v>4.0000000000000027</c:v>
                </c:pt>
                <c:pt idx="48">
                  <c:v>4.0833333333333357</c:v>
                </c:pt>
                <c:pt idx="49">
                  <c:v>4.1666666666666687</c:v>
                </c:pt>
                <c:pt idx="50">
                  <c:v>4.2500000000000018</c:v>
                </c:pt>
                <c:pt idx="51">
                  <c:v>4.3333333333333348</c:v>
                </c:pt>
                <c:pt idx="52">
                  <c:v>4.4166666666666679</c:v>
                </c:pt>
                <c:pt idx="53">
                  <c:v>4.5000000000000009</c:v>
                </c:pt>
                <c:pt idx="54">
                  <c:v>4.5833333333333339</c:v>
                </c:pt>
                <c:pt idx="55">
                  <c:v>4.666666666666667</c:v>
                </c:pt>
                <c:pt idx="56">
                  <c:v>4.75</c:v>
                </c:pt>
                <c:pt idx="57">
                  <c:v>4.833333333333333</c:v>
                </c:pt>
                <c:pt idx="58">
                  <c:v>4.9166666666666661</c:v>
                </c:pt>
                <c:pt idx="59">
                  <c:v>4.9999999999999991</c:v>
                </c:pt>
                <c:pt idx="60">
                  <c:v>5.0833333333333321</c:v>
                </c:pt>
                <c:pt idx="61">
                  <c:v>5.1666666666666652</c:v>
                </c:pt>
                <c:pt idx="62">
                  <c:v>5.2499999999999982</c:v>
                </c:pt>
                <c:pt idx="63">
                  <c:v>5.3333333333333313</c:v>
                </c:pt>
                <c:pt idx="64">
                  <c:v>5.4166666666666643</c:v>
                </c:pt>
                <c:pt idx="65">
                  <c:v>5.4999999999999973</c:v>
                </c:pt>
                <c:pt idx="66">
                  <c:v>5.5833333333333304</c:v>
                </c:pt>
                <c:pt idx="67">
                  <c:v>5.6666666666666634</c:v>
                </c:pt>
                <c:pt idx="68">
                  <c:v>5.7499999999999964</c:v>
                </c:pt>
                <c:pt idx="69">
                  <c:v>5.8333333333333295</c:v>
                </c:pt>
                <c:pt idx="70">
                  <c:v>5.9166666666666625</c:v>
                </c:pt>
                <c:pt idx="71">
                  <c:v>5.9999999999999956</c:v>
                </c:pt>
                <c:pt idx="72">
                  <c:v>6.0833333333333286</c:v>
                </c:pt>
                <c:pt idx="73">
                  <c:v>6.1666666666666616</c:v>
                </c:pt>
                <c:pt idx="74">
                  <c:v>6.2499999999999947</c:v>
                </c:pt>
                <c:pt idx="75">
                  <c:v>6.3333333333333277</c:v>
                </c:pt>
                <c:pt idx="76">
                  <c:v>6.4166666666666607</c:v>
                </c:pt>
                <c:pt idx="77">
                  <c:v>6.4999999999999938</c:v>
                </c:pt>
                <c:pt idx="78">
                  <c:v>6.5833333333333268</c:v>
                </c:pt>
                <c:pt idx="79">
                  <c:v>6.6666666666666599</c:v>
                </c:pt>
                <c:pt idx="80">
                  <c:v>6.7499999999999929</c:v>
                </c:pt>
                <c:pt idx="81">
                  <c:v>6.8333333333333259</c:v>
                </c:pt>
                <c:pt idx="82">
                  <c:v>6.916666666666659</c:v>
                </c:pt>
                <c:pt idx="83">
                  <c:v>6.999999999999992</c:v>
                </c:pt>
                <c:pt idx="84">
                  <c:v>7.083333333333325</c:v>
                </c:pt>
                <c:pt idx="85">
                  <c:v>7.1666666666666581</c:v>
                </c:pt>
                <c:pt idx="86">
                  <c:v>7.2499999999999911</c:v>
                </c:pt>
                <c:pt idx="87">
                  <c:v>7.3333333333333242</c:v>
                </c:pt>
                <c:pt idx="88">
                  <c:v>7.4166666666666572</c:v>
                </c:pt>
                <c:pt idx="89">
                  <c:v>7.4999999999999902</c:v>
                </c:pt>
                <c:pt idx="90">
                  <c:v>7.5833333333333233</c:v>
                </c:pt>
                <c:pt idx="91">
                  <c:v>7.6666666666666563</c:v>
                </c:pt>
                <c:pt idx="92">
                  <c:v>7.7499999999999893</c:v>
                </c:pt>
                <c:pt idx="93">
                  <c:v>7.8333333333333224</c:v>
                </c:pt>
                <c:pt idx="94">
                  <c:v>7.9166666666666554</c:v>
                </c:pt>
                <c:pt idx="95">
                  <c:v>7.9999999999999885</c:v>
                </c:pt>
                <c:pt idx="96">
                  <c:v>8.0833333333333215</c:v>
                </c:pt>
                <c:pt idx="97">
                  <c:v>8.1666666666666554</c:v>
                </c:pt>
                <c:pt idx="98">
                  <c:v>8.2499999999999893</c:v>
                </c:pt>
                <c:pt idx="99">
                  <c:v>8.3333333333333233</c:v>
                </c:pt>
                <c:pt idx="100">
                  <c:v>8.4166666666666572</c:v>
                </c:pt>
                <c:pt idx="101">
                  <c:v>8.4999999999999911</c:v>
                </c:pt>
                <c:pt idx="102">
                  <c:v>8.583333333333325</c:v>
                </c:pt>
                <c:pt idx="103">
                  <c:v>8.666666666666659</c:v>
                </c:pt>
                <c:pt idx="104">
                  <c:v>8.7499999999999929</c:v>
                </c:pt>
                <c:pt idx="105">
                  <c:v>8.8333333333333268</c:v>
                </c:pt>
                <c:pt idx="106">
                  <c:v>8.9166666666666607</c:v>
                </c:pt>
                <c:pt idx="107">
                  <c:v>8.9999999999999947</c:v>
                </c:pt>
                <c:pt idx="108">
                  <c:v>9.0833333333333286</c:v>
                </c:pt>
                <c:pt idx="109">
                  <c:v>9.1666666666666625</c:v>
                </c:pt>
                <c:pt idx="110">
                  <c:v>9.2499999999999964</c:v>
                </c:pt>
                <c:pt idx="111">
                  <c:v>9.3333333333333304</c:v>
                </c:pt>
                <c:pt idx="112">
                  <c:v>9.4166666666666643</c:v>
                </c:pt>
                <c:pt idx="113">
                  <c:v>9.4999999999999982</c:v>
                </c:pt>
                <c:pt idx="114">
                  <c:v>9.5833333333333321</c:v>
                </c:pt>
                <c:pt idx="115">
                  <c:v>9.6666666666666661</c:v>
                </c:pt>
                <c:pt idx="116">
                  <c:v>9.75</c:v>
                </c:pt>
                <c:pt idx="117">
                  <c:v>9.8333333333333339</c:v>
                </c:pt>
                <c:pt idx="118">
                  <c:v>9.9166666666666679</c:v>
                </c:pt>
                <c:pt idx="119">
                  <c:v>10.000000000000002</c:v>
                </c:pt>
                <c:pt idx="120">
                  <c:v>10.083333333333336</c:v>
                </c:pt>
                <c:pt idx="121">
                  <c:v>10.16666666666667</c:v>
                </c:pt>
                <c:pt idx="122">
                  <c:v>10.250000000000004</c:v>
                </c:pt>
                <c:pt idx="123">
                  <c:v>10.333333333333337</c:v>
                </c:pt>
                <c:pt idx="124">
                  <c:v>10.416666666666671</c:v>
                </c:pt>
                <c:pt idx="125">
                  <c:v>10.500000000000005</c:v>
                </c:pt>
                <c:pt idx="126">
                  <c:v>10.583333333333339</c:v>
                </c:pt>
                <c:pt idx="127">
                  <c:v>10.666666666666673</c:v>
                </c:pt>
                <c:pt idx="128">
                  <c:v>10.750000000000007</c:v>
                </c:pt>
                <c:pt idx="129">
                  <c:v>10.833333333333341</c:v>
                </c:pt>
                <c:pt idx="130">
                  <c:v>10.916666666666675</c:v>
                </c:pt>
                <c:pt idx="131">
                  <c:v>11.000000000000009</c:v>
                </c:pt>
                <c:pt idx="132">
                  <c:v>11.083333333333343</c:v>
                </c:pt>
                <c:pt idx="133">
                  <c:v>11.166666666666677</c:v>
                </c:pt>
                <c:pt idx="134">
                  <c:v>11.250000000000011</c:v>
                </c:pt>
                <c:pt idx="135">
                  <c:v>11.333333333333345</c:v>
                </c:pt>
                <c:pt idx="136">
                  <c:v>11.416666666666679</c:v>
                </c:pt>
                <c:pt idx="137">
                  <c:v>11.500000000000012</c:v>
                </c:pt>
                <c:pt idx="138">
                  <c:v>11.583333333333346</c:v>
                </c:pt>
                <c:pt idx="139">
                  <c:v>11.66666666666668</c:v>
                </c:pt>
                <c:pt idx="140">
                  <c:v>11.750000000000014</c:v>
                </c:pt>
                <c:pt idx="141">
                  <c:v>11.833333333333348</c:v>
                </c:pt>
                <c:pt idx="142">
                  <c:v>11.916666666666682</c:v>
                </c:pt>
                <c:pt idx="143">
                  <c:v>12.000000000000016</c:v>
                </c:pt>
              </c:numCache>
            </c:numRef>
          </c:xVal>
          <c:yVal>
            <c:numRef>
              <c:f>'Net Na+ flux'!$Q$4:$Q$147</c:f>
              <c:numCache>
                <c:formatCode>General</c:formatCode>
                <c:ptCount val="144"/>
                <c:pt idx="0">
                  <c:v>-1.2001421428571428</c:v>
                </c:pt>
                <c:pt idx="1">
                  <c:v>-2.9481422222222222</c:v>
                </c:pt>
                <c:pt idx="2">
                  <c:v>-2.0763937500000003</c:v>
                </c:pt>
                <c:pt idx="3">
                  <c:v>-1.8306100000000001</c:v>
                </c:pt>
                <c:pt idx="4">
                  <c:v>-4.2847114285714287</c:v>
                </c:pt>
                <c:pt idx="5">
                  <c:v>-3.9204150000000002</c:v>
                </c:pt>
                <c:pt idx="6">
                  <c:v>-4.4435000000000002</c:v>
                </c:pt>
                <c:pt idx="7">
                  <c:v>-3.3241399999999999</c:v>
                </c:pt>
                <c:pt idx="8">
                  <c:v>-2.4298499999999996</c:v>
                </c:pt>
                <c:pt idx="9">
                  <c:v>-3.0309650000000001</c:v>
                </c:pt>
                <c:pt idx="10">
                  <c:v>-2.2512750000000006</c:v>
                </c:pt>
                <c:pt idx="11">
                  <c:v>-1.57385</c:v>
                </c:pt>
                <c:pt idx="12">
                  <c:v>-2.4969399999999999</c:v>
                </c:pt>
                <c:pt idx="13">
                  <c:v>-2.3744100000000006</c:v>
                </c:pt>
                <c:pt idx="14">
                  <c:v>-1.4947257142857142</c:v>
                </c:pt>
                <c:pt idx="15">
                  <c:v>-2.3436850000000002</c:v>
                </c:pt>
                <c:pt idx="16">
                  <c:v>-1.8102849999999999</c:v>
                </c:pt>
                <c:pt idx="17">
                  <c:v>-2.5971550000000003</c:v>
                </c:pt>
                <c:pt idx="18">
                  <c:v>-1.6412492857142857</c:v>
                </c:pt>
                <c:pt idx="19">
                  <c:v>-1.31231875</c:v>
                </c:pt>
                <c:pt idx="20">
                  <c:v>-2.4115944444444444</c:v>
                </c:pt>
                <c:pt idx="21">
                  <c:v>-2.6490950000000004</c:v>
                </c:pt>
                <c:pt idx="22">
                  <c:v>-3.498167142857143</c:v>
                </c:pt>
                <c:pt idx="23">
                  <c:v>-2.267795</c:v>
                </c:pt>
                <c:pt idx="24">
                  <c:v>-2.4599300000000004</c:v>
                </c:pt>
                <c:pt idx="25">
                  <c:v>-2.0107950000000003</c:v>
                </c:pt>
                <c:pt idx="26">
                  <c:v>-1.8306699999999996</c:v>
                </c:pt>
                <c:pt idx="27">
                  <c:v>-3.5409892857142853</c:v>
                </c:pt>
                <c:pt idx="28">
                  <c:v>-2.830155</c:v>
                </c:pt>
                <c:pt idx="29">
                  <c:v>-2.7213999999999992</c:v>
                </c:pt>
                <c:pt idx="30">
                  <c:v>-4.1096850000000007</c:v>
                </c:pt>
                <c:pt idx="31">
                  <c:v>-3.6683600000000007</c:v>
                </c:pt>
                <c:pt idx="32">
                  <c:v>-4.6253000000000002</c:v>
                </c:pt>
                <c:pt idx="33">
                  <c:v>-3.9856287500000001</c:v>
                </c:pt>
                <c:pt idx="34">
                  <c:v>-4.3555462499999997</c:v>
                </c:pt>
                <c:pt idx="35">
                  <c:v>-4.1248699999999996</c:v>
                </c:pt>
                <c:pt idx="36">
                  <c:v>-4.3653250000000003</c:v>
                </c:pt>
                <c:pt idx="37">
                  <c:v>-5.5851612499999996</c:v>
                </c:pt>
                <c:pt idx="38">
                  <c:v>-6.4967924999999997</c:v>
                </c:pt>
                <c:pt idx="39">
                  <c:v>-4.9331200000000006</c:v>
                </c:pt>
                <c:pt idx="40">
                  <c:v>-4.8585849999999997</c:v>
                </c:pt>
                <c:pt idx="41">
                  <c:v>-4.9629100000000008</c:v>
                </c:pt>
                <c:pt idx="42">
                  <c:v>-3.9823199999999996</c:v>
                </c:pt>
                <c:pt idx="43">
                  <c:v>-4.8083149999999995</c:v>
                </c:pt>
                <c:pt idx="44">
                  <c:v>-3.5730699999999995</c:v>
                </c:pt>
                <c:pt idx="45">
                  <c:v>-3.4898600000000002</c:v>
                </c:pt>
                <c:pt idx="46">
                  <c:v>-3.7089299999999996</c:v>
                </c:pt>
                <c:pt idx="47">
                  <c:v>-3.9157450000000003</c:v>
                </c:pt>
                <c:pt idx="48">
                  <c:v>-4.7299499999999997</c:v>
                </c:pt>
                <c:pt idx="49">
                  <c:v>-4.1485450000000004</c:v>
                </c:pt>
                <c:pt idx="50">
                  <c:v>-4.0775850000000009</c:v>
                </c:pt>
                <c:pt idx="51">
                  <c:v>-4.5599712499999994</c:v>
                </c:pt>
                <c:pt idx="52">
                  <c:v>-5.2088944444444447</c:v>
                </c:pt>
                <c:pt idx="53">
                  <c:v>-5.2731100000000009</c:v>
                </c:pt>
                <c:pt idx="54">
                  <c:v>-5.8815100000000005</c:v>
                </c:pt>
                <c:pt idx="55">
                  <c:v>-5.7846899999999994</c:v>
                </c:pt>
                <c:pt idx="56">
                  <c:v>-4.5348899999999999</c:v>
                </c:pt>
                <c:pt idx="57">
                  <c:v>-6.2141199999999994</c:v>
                </c:pt>
                <c:pt idx="58">
                  <c:v>-6.0877999999999997</c:v>
                </c:pt>
                <c:pt idx="59">
                  <c:v>-6.914295000000001</c:v>
                </c:pt>
                <c:pt idx="60">
                  <c:v>-6.3336999999999994</c:v>
                </c:pt>
                <c:pt idx="61">
                  <c:v>-7.2456950000000004</c:v>
                </c:pt>
                <c:pt idx="62">
                  <c:v>-6.5482300000000011</c:v>
                </c:pt>
                <c:pt idx="63">
                  <c:v>-7.5986111111111105</c:v>
                </c:pt>
                <c:pt idx="64">
                  <c:v>-7.7479233333333335</c:v>
                </c:pt>
                <c:pt idx="65">
                  <c:v>-6.6559150000000002</c:v>
                </c:pt>
                <c:pt idx="66">
                  <c:v>-6.6954100000000007</c:v>
                </c:pt>
                <c:pt idx="67">
                  <c:v>-6.18973</c:v>
                </c:pt>
                <c:pt idx="68">
                  <c:v>-7.910804999999999</c:v>
                </c:pt>
                <c:pt idx="69">
                  <c:v>-8.4440400000000011</c:v>
                </c:pt>
                <c:pt idx="70">
                  <c:v>-6.9478942857142858</c:v>
                </c:pt>
                <c:pt idx="71">
                  <c:v>-6.9650000000000007</c:v>
                </c:pt>
                <c:pt idx="72">
                  <c:v>-8.0716949999999983</c:v>
                </c:pt>
                <c:pt idx="73">
                  <c:v>-8.3428649999999998</c:v>
                </c:pt>
                <c:pt idx="74">
                  <c:v>-9.6019099999999984</c:v>
                </c:pt>
                <c:pt idx="75">
                  <c:v>-7.86111</c:v>
                </c:pt>
                <c:pt idx="76">
                  <c:v>-8.4847900000000003</c:v>
                </c:pt>
                <c:pt idx="77">
                  <c:v>-8.1955449999999992</c:v>
                </c:pt>
                <c:pt idx="78">
                  <c:v>-8.2673599999999983</c:v>
                </c:pt>
                <c:pt idx="79">
                  <c:v>-9.7396950000000011</c:v>
                </c:pt>
                <c:pt idx="80">
                  <c:v>-9.8844349999999999</c:v>
                </c:pt>
                <c:pt idx="81">
                  <c:v>-7.8798500000000011</c:v>
                </c:pt>
                <c:pt idx="82">
                  <c:v>-9.8564524999999996</c:v>
                </c:pt>
                <c:pt idx="83">
                  <c:v>-11.476194999999999</c:v>
                </c:pt>
                <c:pt idx="84">
                  <c:v>-12.2141675</c:v>
                </c:pt>
                <c:pt idx="85">
                  <c:v>-12.62106</c:v>
                </c:pt>
                <c:pt idx="86">
                  <c:v>-12.020004999999999</c:v>
                </c:pt>
                <c:pt idx="87">
                  <c:v>-11.598710000000001</c:v>
                </c:pt>
                <c:pt idx="88">
                  <c:v>-13.000027500000002</c:v>
                </c:pt>
                <c:pt idx="89">
                  <c:v>-14.70725</c:v>
                </c:pt>
                <c:pt idx="90">
                  <c:v>-14.886340000000001</c:v>
                </c:pt>
                <c:pt idx="91">
                  <c:v>-12.692429999999998</c:v>
                </c:pt>
                <c:pt idx="92">
                  <c:v>-14.508405000000002</c:v>
                </c:pt>
                <c:pt idx="93">
                  <c:v>-14.558384999999999</c:v>
                </c:pt>
                <c:pt idx="94">
                  <c:v>-15.193985000000001</c:v>
                </c:pt>
                <c:pt idx="95">
                  <c:v>-15.445320000000001</c:v>
                </c:pt>
                <c:pt idx="96">
                  <c:v>-14.258249444444445</c:v>
                </c:pt>
                <c:pt idx="97">
                  <c:v>-15.70920375</c:v>
                </c:pt>
                <c:pt idx="98">
                  <c:v>-17.541364999999999</c:v>
                </c:pt>
                <c:pt idx="99">
                  <c:v>-14.995535</c:v>
                </c:pt>
                <c:pt idx="100">
                  <c:v>-16.978475</c:v>
                </c:pt>
                <c:pt idx="101">
                  <c:v>-17.863110000000002</c:v>
                </c:pt>
                <c:pt idx="102">
                  <c:v>-16.909685</c:v>
                </c:pt>
                <c:pt idx="103">
                  <c:v>-18.308415555555555</c:v>
                </c:pt>
                <c:pt idx="104">
                  <c:v>-19.163936249999999</c:v>
                </c:pt>
                <c:pt idx="105">
                  <c:v>-19.225386666666669</c:v>
                </c:pt>
                <c:pt idx="106">
                  <c:v>-20.195504999999997</c:v>
                </c:pt>
                <c:pt idx="107">
                  <c:v>-21.730860000000003</c:v>
                </c:pt>
                <c:pt idx="108">
                  <c:v>-19.516272499999999</c:v>
                </c:pt>
                <c:pt idx="109">
                  <c:v>-19.283790714285715</c:v>
                </c:pt>
                <c:pt idx="110">
                  <c:v>-17.884855000000002</c:v>
                </c:pt>
                <c:pt idx="111">
                  <c:v>-20.863509999999998</c:v>
                </c:pt>
                <c:pt idx="112">
                  <c:v>-19.323899999999998</c:v>
                </c:pt>
                <c:pt idx="113">
                  <c:v>-19.392265000000002</c:v>
                </c:pt>
                <c:pt idx="114">
                  <c:v>-22.22701</c:v>
                </c:pt>
                <c:pt idx="115">
                  <c:v>-20.950872500000003</c:v>
                </c:pt>
                <c:pt idx="116">
                  <c:v>-25.177710000000001</c:v>
                </c:pt>
                <c:pt idx="117">
                  <c:v>-23.440525000000001</c:v>
                </c:pt>
                <c:pt idx="118">
                  <c:v>-23.6556</c:v>
                </c:pt>
                <c:pt idx="119">
                  <c:v>-25.016314999999999</c:v>
                </c:pt>
                <c:pt idx="120">
                  <c:v>-25.097315000000002</c:v>
                </c:pt>
                <c:pt idx="121">
                  <c:v>-24.276879999999998</c:v>
                </c:pt>
                <c:pt idx="122">
                  <c:v>-26.393017500000003</c:v>
                </c:pt>
                <c:pt idx="123">
                  <c:v>-30.842360555555558</c:v>
                </c:pt>
                <c:pt idx="124">
                  <c:v>-33.983710000000002</c:v>
                </c:pt>
                <c:pt idx="125">
                  <c:v>-30.940059999999999</c:v>
                </c:pt>
                <c:pt idx="126">
                  <c:v>-28.359845</c:v>
                </c:pt>
                <c:pt idx="127">
                  <c:v>-29.151861111111117</c:v>
                </c:pt>
                <c:pt idx="128">
                  <c:v>-28.046804999999999</c:v>
                </c:pt>
                <c:pt idx="129">
                  <c:v>-28.913594999999997</c:v>
                </c:pt>
                <c:pt idx="130">
                  <c:v>-28.602330000000006</c:v>
                </c:pt>
                <c:pt idx="131">
                  <c:v>-28.020530000000001</c:v>
                </c:pt>
                <c:pt idx="132">
                  <c:v>-28.077908333333333</c:v>
                </c:pt>
                <c:pt idx="133">
                  <c:v>-28.571389999999997</c:v>
                </c:pt>
                <c:pt idx="134">
                  <c:v>-29.090439999999997</c:v>
                </c:pt>
                <c:pt idx="135">
                  <c:v>-29.899747916666669</c:v>
                </c:pt>
                <c:pt idx="136">
                  <c:v>-30.472515000000001</c:v>
                </c:pt>
                <c:pt idx="137">
                  <c:v>-31.779058571428571</c:v>
                </c:pt>
                <c:pt idx="138">
                  <c:v>-30.597665000000003</c:v>
                </c:pt>
                <c:pt idx="139">
                  <c:v>-32.378124999999997</c:v>
                </c:pt>
                <c:pt idx="140">
                  <c:v>-35.232260000000004</c:v>
                </c:pt>
                <c:pt idx="141">
                  <c:v>-35.457999999999998</c:v>
                </c:pt>
                <c:pt idx="142">
                  <c:v>-34.061179999999993</c:v>
                </c:pt>
                <c:pt idx="143">
                  <c:v>-31.525154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35D-487D-AA56-723F0F6E20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5772176"/>
        <c:axId val="565773840"/>
      </c:scatterChart>
      <c:valAx>
        <c:axId val="565772176"/>
        <c:scaling>
          <c:orientation val="minMax"/>
          <c:max val="13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8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5773840"/>
        <c:crossesAt val="-400"/>
        <c:crossBetween val="midCat"/>
      </c:valAx>
      <c:valAx>
        <c:axId val="565773840"/>
        <c:scaling>
          <c:orientation val="minMax"/>
          <c:max val="50"/>
          <c:min val="-4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800"/>
                  <a:t>Net Na</a:t>
                </a:r>
                <a:r>
                  <a:rPr lang="en-US" altLang="ja-JP" sz="1800" baseline="30000"/>
                  <a:t>+</a:t>
                </a:r>
                <a:r>
                  <a:rPr lang="en-US" altLang="ja-JP" sz="1800"/>
                  <a:t> flux (nmol m</a:t>
                </a:r>
                <a:r>
                  <a:rPr lang="en-US" altLang="ja-JP" sz="1800" baseline="30000"/>
                  <a:t>-2</a:t>
                </a:r>
                <a:r>
                  <a:rPr lang="en-US" altLang="ja-JP" sz="1800"/>
                  <a:t> s</a:t>
                </a:r>
                <a:r>
                  <a:rPr lang="en-US" altLang="ja-JP" sz="1800" baseline="30000"/>
                  <a:t>-1</a:t>
                </a:r>
                <a:r>
                  <a:rPr lang="en-US" altLang="ja-JP" sz="1800"/>
                  <a:t>)</a:t>
                </a:r>
              </a:p>
            </c:rich>
          </c:tx>
          <c:layout>
            <c:manualLayout>
              <c:xMode val="edge"/>
              <c:yMode val="edge"/>
              <c:x val="1.6462962962962964E-2"/>
              <c:y val="0.151130000000000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5772176"/>
        <c:crosses val="autoZero"/>
        <c:crossBetween val="midCat"/>
        <c:majorUnit val="1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832740740740741"/>
          <c:y val="0.51907777777777775"/>
          <c:w val="0.2902635185185185"/>
          <c:h val="0.1583327160493827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/>
              <a:t>Mature root zone</a:t>
            </a:r>
          </a:p>
        </c:rich>
      </c:tx>
      <c:layout>
        <c:manualLayout>
          <c:xMode val="edge"/>
          <c:yMode val="edge"/>
          <c:x val="0.2960256172839506"/>
          <c:y val="3.02380952380952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WT, sorbitol</c:v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B$14:$G$14</c:f>
                <c:numCache>
                  <c:formatCode>General</c:formatCode>
                  <c:ptCount val="6"/>
                  <c:pt idx="0">
                    <c:v>1.1299953136775793</c:v>
                  </c:pt>
                  <c:pt idx="1">
                    <c:v>7.1291592339441179</c:v>
                  </c:pt>
                  <c:pt idx="2">
                    <c:v>5.1980593003296613</c:v>
                  </c:pt>
                  <c:pt idx="3">
                    <c:v>7.6111972478859506</c:v>
                  </c:pt>
                  <c:pt idx="4">
                    <c:v>6.2445395961582832</c:v>
                  </c:pt>
                  <c:pt idx="5">
                    <c:v>3.2496072303251018</c:v>
                  </c:pt>
                </c:numCache>
              </c:numRef>
            </c:plus>
            <c:minus>
              <c:numRef>
                <c:f>'Na+'!$B$14:$G$14</c:f>
                <c:numCache>
                  <c:formatCode>General</c:formatCode>
                  <c:ptCount val="6"/>
                  <c:pt idx="0">
                    <c:v>1.1299953136775793</c:v>
                  </c:pt>
                  <c:pt idx="1">
                    <c:v>7.1291592339441179</c:v>
                  </c:pt>
                  <c:pt idx="2">
                    <c:v>5.1980593003296613</c:v>
                  </c:pt>
                  <c:pt idx="3">
                    <c:v>7.6111972478859506</c:v>
                  </c:pt>
                  <c:pt idx="4">
                    <c:v>6.2445395961582832</c:v>
                  </c:pt>
                  <c:pt idx="5">
                    <c:v>3.24960723032510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Na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B$13:$G$13</c:f>
              <c:numCache>
                <c:formatCode>General</c:formatCode>
                <c:ptCount val="6"/>
                <c:pt idx="0">
                  <c:v>3.4634783913187993E-2</c:v>
                </c:pt>
                <c:pt idx="1">
                  <c:v>-4.7199295255411258</c:v>
                </c:pt>
                <c:pt idx="2">
                  <c:v>-3.3020318809523816</c:v>
                </c:pt>
                <c:pt idx="3">
                  <c:v>-4.6336556159420299</c:v>
                </c:pt>
                <c:pt idx="4">
                  <c:v>-3.3332361904761902</c:v>
                </c:pt>
                <c:pt idx="5">
                  <c:v>-2.83889896480331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F82-45C5-9AB9-124BED7B6E32}"/>
            </c:ext>
          </c:extLst>
        </c:ser>
        <c:ser>
          <c:idx val="0"/>
          <c:order val="1"/>
          <c:tx>
            <c:v>WT, NaCl</c:v>
          </c:tx>
          <c:spPr>
            <a:ln w="19050" cap="rnd">
              <a:solidFill>
                <a:srgbClr val="E74B3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B$25:$G$25</c:f>
                <c:numCache>
                  <c:formatCode>General</c:formatCode>
                  <c:ptCount val="6"/>
                  <c:pt idx="0">
                    <c:v>9.5003679099217067</c:v>
                  </c:pt>
                  <c:pt idx="1">
                    <c:v>16.889490804051739</c:v>
                  </c:pt>
                  <c:pt idx="2">
                    <c:v>24.082502842719077</c:v>
                  </c:pt>
                  <c:pt idx="3">
                    <c:v>29.067644923405151</c:v>
                  </c:pt>
                  <c:pt idx="4">
                    <c:v>39.987850057685925</c:v>
                  </c:pt>
                  <c:pt idx="5">
                    <c:v>66.393138874424068</c:v>
                  </c:pt>
                </c:numCache>
              </c:numRef>
            </c:plus>
            <c:minus>
              <c:numRef>
                <c:f>'Na+'!$B$25:$G$25</c:f>
                <c:numCache>
                  <c:formatCode>General</c:formatCode>
                  <c:ptCount val="6"/>
                  <c:pt idx="0">
                    <c:v>9.5003679099217067</c:v>
                  </c:pt>
                  <c:pt idx="1">
                    <c:v>16.889490804051739</c:v>
                  </c:pt>
                  <c:pt idx="2">
                    <c:v>24.082502842719077</c:v>
                  </c:pt>
                  <c:pt idx="3">
                    <c:v>29.067644923405151</c:v>
                  </c:pt>
                  <c:pt idx="4">
                    <c:v>39.987850057685925</c:v>
                  </c:pt>
                  <c:pt idx="5">
                    <c:v>66.393138874424068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E74B35"/>
                </a:solidFill>
                <a:round/>
              </a:ln>
              <a:effectLst/>
            </c:spPr>
          </c:errBars>
          <c:xVal>
            <c:numRef>
              <c:f>'Na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B$24:$G$24</c:f>
              <c:numCache>
                <c:formatCode>General</c:formatCode>
                <c:ptCount val="6"/>
                <c:pt idx="0">
                  <c:v>-9.5047966912442412</c:v>
                </c:pt>
                <c:pt idx="1">
                  <c:v>-15.412002872503841</c:v>
                </c:pt>
                <c:pt idx="2">
                  <c:v>-25.117980215455045</c:v>
                </c:pt>
                <c:pt idx="3">
                  <c:v>-32.470734285248795</c:v>
                </c:pt>
                <c:pt idx="4">
                  <c:v>-44.691813730522355</c:v>
                </c:pt>
                <c:pt idx="5">
                  <c:v>-102.098059614332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F82-45C5-9AB9-124BED7B6E32}"/>
            </c:ext>
          </c:extLst>
        </c:ser>
        <c:ser>
          <c:idx val="3"/>
          <c:order val="2"/>
          <c:tx>
            <c:v>WT, NaCl, amiloride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B$35:$G$35</c:f>
                <c:numCache>
                  <c:formatCode>General</c:formatCode>
                  <c:ptCount val="6"/>
                  <c:pt idx="0">
                    <c:v>4.6087613621057226</c:v>
                  </c:pt>
                  <c:pt idx="1">
                    <c:v>8.2957691624796031</c:v>
                  </c:pt>
                  <c:pt idx="2">
                    <c:v>16.906363580345463</c:v>
                  </c:pt>
                  <c:pt idx="3">
                    <c:v>10.788664563489487</c:v>
                  </c:pt>
                  <c:pt idx="4">
                    <c:v>11.123016129631411</c:v>
                  </c:pt>
                  <c:pt idx="5">
                    <c:v>9.4777177056633377</c:v>
                  </c:pt>
                </c:numCache>
              </c:numRef>
            </c:plus>
            <c:minus>
              <c:numRef>
                <c:f>'Na+'!$B$35:$G$35</c:f>
                <c:numCache>
                  <c:formatCode>General</c:formatCode>
                  <c:ptCount val="6"/>
                  <c:pt idx="0">
                    <c:v>4.6087613621057226</c:v>
                  </c:pt>
                  <c:pt idx="1">
                    <c:v>8.2957691624796031</c:v>
                  </c:pt>
                  <c:pt idx="2">
                    <c:v>16.906363580345463</c:v>
                  </c:pt>
                  <c:pt idx="3">
                    <c:v>10.788664563489487</c:v>
                  </c:pt>
                  <c:pt idx="4">
                    <c:v>11.123016129631411</c:v>
                  </c:pt>
                  <c:pt idx="5">
                    <c:v>9.47771770566333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Na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B$34:$G$34</c:f>
              <c:numCache>
                <c:formatCode>General</c:formatCode>
                <c:ptCount val="6"/>
                <c:pt idx="0">
                  <c:v>6.3730726817042435E-2</c:v>
                </c:pt>
                <c:pt idx="1">
                  <c:v>-8.1769786580086592</c:v>
                </c:pt>
                <c:pt idx="2">
                  <c:v>-13.92293794139194</c:v>
                </c:pt>
                <c:pt idx="3">
                  <c:v>-9.3948876853002048</c:v>
                </c:pt>
                <c:pt idx="4">
                  <c:v>-8.7626794064872335</c:v>
                </c:pt>
                <c:pt idx="5">
                  <c:v>-7.96349699792960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F82-45C5-9AB9-124BED7B6E32}"/>
            </c:ext>
          </c:extLst>
        </c:ser>
        <c:ser>
          <c:idx val="2"/>
          <c:order val="3"/>
          <c:tx>
            <c:v>sos1, NaCl</c:v>
          </c:tx>
          <c:spPr>
            <a:ln w="19050" cap="rnd">
              <a:solidFill>
                <a:srgbClr val="52C2DD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2C2DD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B$48:$G$48</c:f>
                <c:numCache>
                  <c:formatCode>General</c:formatCode>
                  <c:ptCount val="6"/>
                  <c:pt idx="0">
                    <c:v>5.0454454156525363</c:v>
                  </c:pt>
                  <c:pt idx="1">
                    <c:v>3.0019459028120705</c:v>
                  </c:pt>
                  <c:pt idx="2">
                    <c:v>2.6094745228712513</c:v>
                  </c:pt>
                  <c:pt idx="3">
                    <c:v>1.4602209602668057</c:v>
                  </c:pt>
                  <c:pt idx="4">
                    <c:v>1.9930691147042203</c:v>
                  </c:pt>
                  <c:pt idx="5">
                    <c:v>1.6755712885779885</c:v>
                  </c:pt>
                </c:numCache>
              </c:numRef>
            </c:plus>
            <c:minus>
              <c:numRef>
                <c:f>'Na+'!$B$48:$G$48</c:f>
                <c:numCache>
                  <c:formatCode>General</c:formatCode>
                  <c:ptCount val="6"/>
                  <c:pt idx="0">
                    <c:v>5.0454454156525363</c:v>
                  </c:pt>
                  <c:pt idx="1">
                    <c:v>3.0019459028120705</c:v>
                  </c:pt>
                  <c:pt idx="2">
                    <c:v>2.6094745228712513</c:v>
                  </c:pt>
                  <c:pt idx="3">
                    <c:v>1.4602209602668057</c:v>
                  </c:pt>
                  <c:pt idx="4">
                    <c:v>1.9930691147042203</c:v>
                  </c:pt>
                  <c:pt idx="5">
                    <c:v>1.6755712885779885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52C2DD"/>
                </a:solidFill>
                <a:round/>
              </a:ln>
              <a:effectLst/>
            </c:spPr>
          </c:errBars>
          <c:xVal>
            <c:numRef>
              <c:f>'Na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B$47:$G$47</c:f>
              <c:numCache>
                <c:formatCode>General</c:formatCode>
                <c:ptCount val="6"/>
                <c:pt idx="0">
                  <c:v>1.8099710866511669</c:v>
                </c:pt>
                <c:pt idx="1">
                  <c:v>4.6934493950076659</c:v>
                </c:pt>
                <c:pt idx="2">
                  <c:v>2.222406526957315</c:v>
                </c:pt>
                <c:pt idx="3">
                  <c:v>0.99755583717357921</c:v>
                </c:pt>
                <c:pt idx="4">
                  <c:v>-1.4278522226793942</c:v>
                </c:pt>
                <c:pt idx="5">
                  <c:v>-1.51791365209621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F82-45C5-9AB9-124BED7B6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3375880"/>
        <c:axId val="393374704"/>
      </c:scatterChart>
      <c:valAx>
        <c:axId val="393375880"/>
        <c:scaling>
          <c:orientation val="minMax"/>
          <c:max val="6.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4704"/>
        <c:crossesAt val="-200"/>
        <c:crossBetween val="midCat"/>
        <c:majorUnit val="2"/>
      </c:valAx>
      <c:valAx>
        <c:axId val="3933747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Net Na</a:t>
                </a:r>
                <a:r>
                  <a:rPr lang="en-US" sz="1200" baseline="30000" dirty="0"/>
                  <a:t>+</a:t>
                </a:r>
                <a:r>
                  <a:rPr lang="en-US" sz="1200" dirty="0"/>
                  <a:t> flux (nmol m</a:t>
                </a:r>
                <a:r>
                  <a:rPr lang="en-US" sz="1200" baseline="30000" dirty="0"/>
                  <a:t>-2</a:t>
                </a:r>
                <a:r>
                  <a:rPr lang="en-US" sz="1200" dirty="0"/>
                  <a:t> s</a:t>
                </a:r>
                <a:r>
                  <a:rPr lang="en-US" sz="1200" baseline="30000" dirty="0"/>
                  <a:t>-1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2.3518518518518518E-2"/>
              <c:y val="0.171740079365079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588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4468179012345678"/>
          <c:y val="0.46969642857142868"/>
          <c:w val="0.42213919753086421"/>
          <c:h val="0.2721476190476190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/>
              <a:t>Root apex</a:t>
            </a:r>
          </a:p>
        </c:rich>
      </c:tx>
      <c:layout>
        <c:manualLayout>
          <c:xMode val="edge"/>
          <c:yMode val="edge"/>
          <c:x val="0.40388765432098767"/>
          <c:y val="3.02380952380952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WT, sorbitol</c:v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K$14:$P$14</c:f>
                <c:numCache>
                  <c:formatCode>General</c:formatCode>
                  <c:ptCount val="6"/>
                  <c:pt idx="0">
                    <c:v>1.9267307737659223</c:v>
                  </c:pt>
                  <c:pt idx="1">
                    <c:v>6.4806457600517939</c:v>
                  </c:pt>
                  <c:pt idx="2">
                    <c:v>7.4878374545652076</c:v>
                  </c:pt>
                  <c:pt idx="3">
                    <c:v>7.1039962092580557</c:v>
                  </c:pt>
                  <c:pt idx="4">
                    <c:v>2.3390061294147801</c:v>
                  </c:pt>
                  <c:pt idx="5">
                    <c:v>5.5175165386361122</c:v>
                  </c:pt>
                </c:numCache>
              </c:numRef>
            </c:plus>
            <c:minus>
              <c:numRef>
                <c:f>'Na+'!$K$14:$P$14</c:f>
                <c:numCache>
                  <c:formatCode>General</c:formatCode>
                  <c:ptCount val="6"/>
                  <c:pt idx="0">
                    <c:v>1.9267307737659223</c:v>
                  </c:pt>
                  <c:pt idx="1">
                    <c:v>6.4806457600517939</c:v>
                  </c:pt>
                  <c:pt idx="2">
                    <c:v>7.4878374545652076</c:v>
                  </c:pt>
                  <c:pt idx="3">
                    <c:v>7.1039962092580557</c:v>
                  </c:pt>
                  <c:pt idx="4">
                    <c:v>2.3390061294147801</c:v>
                  </c:pt>
                  <c:pt idx="5">
                    <c:v>5.51751653863611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Na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K$13:$P$13</c:f>
              <c:numCache>
                <c:formatCode>General</c:formatCode>
                <c:ptCount val="6"/>
                <c:pt idx="0">
                  <c:v>-0.61942138325652851</c:v>
                </c:pt>
                <c:pt idx="1">
                  <c:v>4.3545241136712756</c:v>
                </c:pt>
                <c:pt idx="2">
                  <c:v>5.6803510052910058</c:v>
                </c:pt>
                <c:pt idx="3">
                  <c:v>8.1660588006617054</c:v>
                </c:pt>
                <c:pt idx="4">
                  <c:v>2.8941533333333331</c:v>
                </c:pt>
                <c:pt idx="5">
                  <c:v>8.15937778225806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35F-4A62-980C-4AE02E07A62B}"/>
            </c:ext>
          </c:extLst>
        </c:ser>
        <c:ser>
          <c:idx val="0"/>
          <c:order val="1"/>
          <c:tx>
            <c:v>WT, NaCl</c:v>
          </c:tx>
          <c:spPr>
            <a:ln w="19050" cap="rnd">
              <a:solidFill>
                <a:srgbClr val="E74B3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K$25:$P$25</c:f>
                <c:numCache>
                  <c:formatCode>General</c:formatCode>
                  <c:ptCount val="6"/>
                  <c:pt idx="0">
                    <c:v>9.2678567663216871</c:v>
                  </c:pt>
                  <c:pt idx="1">
                    <c:v>7.0050934384465187</c:v>
                  </c:pt>
                  <c:pt idx="2">
                    <c:v>7.0216521073144378</c:v>
                  </c:pt>
                  <c:pt idx="3">
                    <c:v>14.564644386335829</c:v>
                  </c:pt>
                  <c:pt idx="4">
                    <c:v>4.1047646164011882</c:v>
                  </c:pt>
                  <c:pt idx="5">
                    <c:v>13.234763053748726</c:v>
                  </c:pt>
                </c:numCache>
              </c:numRef>
            </c:plus>
            <c:minus>
              <c:numRef>
                <c:f>'Na+'!$K$25:$P$25</c:f>
                <c:numCache>
                  <c:formatCode>General</c:formatCode>
                  <c:ptCount val="6"/>
                  <c:pt idx="0">
                    <c:v>9.2678567663216871</c:v>
                  </c:pt>
                  <c:pt idx="1">
                    <c:v>7.0050934384465187</c:v>
                  </c:pt>
                  <c:pt idx="2">
                    <c:v>7.0216521073144378</c:v>
                  </c:pt>
                  <c:pt idx="3">
                    <c:v>14.564644386335829</c:v>
                  </c:pt>
                  <c:pt idx="4">
                    <c:v>4.1047646164011882</c:v>
                  </c:pt>
                  <c:pt idx="5">
                    <c:v>13.234763053748726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E74B35"/>
                </a:solidFill>
                <a:round/>
              </a:ln>
              <a:effectLst/>
            </c:spPr>
          </c:errBars>
          <c:xVal>
            <c:numRef>
              <c:f>'Na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K$24:$P$24</c:f>
              <c:numCache>
                <c:formatCode>General</c:formatCode>
                <c:ptCount val="6"/>
                <c:pt idx="0">
                  <c:v>2.5038968172042999</c:v>
                </c:pt>
                <c:pt idx="1">
                  <c:v>8.6843493206256124</c:v>
                </c:pt>
                <c:pt idx="2">
                  <c:v>14.104434136973181</c:v>
                </c:pt>
                <c:pt idx="3">
                  <c:v>17.465475273777518</c:v>
                </c:pt>
                <c:pt idx="4">
                  <c:v>17.585484748079878</c:v>
                </c:pt>
                <c:pt idx="5">
                  <c:v>17.0130089791870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35F-4A62-980C-4AE02E07A62B}"/>
            </c:ext>
          </c:extLst>
        </c:ser>
        <c:ser>
          <c:idx val="3"/>
          <c:order val="2"/>
          <c:tx>
            <c:v>WT, NaCl, amiloride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K$35:$P$35</c:f>
                <c:numCache>
                  <c:formatCode>General</c:formatCode>
                  <c:ptCount val="6"/>
                  <c:pt idx="0">
                    <c:v>5.4343457619582569</c:v>
                  </c:pt>
                  <c:pt idx="1">
                    <c:v>5.439778650651844</c:v>
                  </c:pt>
                  <c:pt idx="2">
                    <c:v>1.3278542056146687</c:v>
                  </c:pt>
                  <c:pt idx="3">
                    <c:v>5.1024244623573329</c:v>
                  </c:pt>
                  <c:pt idx="4">
                    <c:v>3.6602043150808119</c:v>
                  </c:pt>
                  <c:pt idx="5">
                    <c:v>2.2162812851609681</c:v>
                  </c:pt>
                </c:numCache>
              </c:numRef>
            </c:plus>
            <c:minus>
              <c:numRef>
                <c:f>'Na+'!$K$35:$P$35</c:f>
                <c:numCache>
                  <c:formatCode>General</c:formatCode>
                  <c:ptCount val="6"/>
                  <c:pt idx="0">
                    <c:v>5.4343457619582569</c:v>
                  </c:pt>
                  <c:pt idx="1">
                    <c:v>5.439778650651844</c:v>
                  </c:pt>
                  <c:pt idx="2">
                    <c:v>1.3278542056146687</c:v>
                  </c:pt>
                  <c:pt idx="3">
                    <c:v>5.1024244623573329</c:v>
                  </c:pt>
                  <c:pt idx="4">
                    <c:v>3.6602043150808119</c:v>
                  </c:pt>
                  <c:pt idx="5">
                    <c:v>2.21628128516096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Na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K$34:$P$34</c:f>
              <c:numCache>
                <c:formatCode>General</c:formatCode>
                <c:ptCount val="6"/>
                <c:pt idx="0">
                  <c:v>3.9802183436853</c:v>
                </c:pt>
                <c:pt idx="1">
                  <c:v>0.78968970238095237</c:v>
                </c:pt>
                <c:pt idx="2">
                  <c:v>0.15937999864718616</c:v>
                </c:pt>
                <c:pt idx="3">
                  <c:v>-1.3615107965367967</c:v>
                </c:pt>
                <c:pt idx="4">
                  <c:v>-2.9371028270280446</c:v>
                </c:pt>
                <c:pt idx="5">
                  <c:v>-0.74799675070028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35F-4A62-980C-4AE02E07A62B}"/>
            </c:ext>
          </c:extLst>
        </c:ser>
        <c:ser>
          <c:idx val="2"/>
          <c:order val="3"/>
          <c:tx>
            <c:v>sos1, NaCl</c:v>
          </c:tx>
          <c:spPr>
            <a:ln w="19050" cap="rnd">
              <a:solidFill>
                <a:srgbClr val="52C2DD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2C2DD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a+'!$K$48:$P$48</c:f>
                <c:numCache>
                  <c:formatCode>General</c:formatCode>
                  <c:ptCount val="6"/>
                  <c:pt idx="0">
                    <c:v>6.2436874515044796</c:v>
                  </c:pt>
                  <c:pt idx="1">
                    <c:v>4.8934839726181041</c:v>
                  </c:pt>
                  <c:pt idx="2">
                    <c:v>5.1146916277068133</c:v>
                  </c:pt>
                  <c:pt idx="3">
                    <c:v>4.6565228179410108</c:v>
                  </c:pt>
                  <c:pt idx="4">
                    <c:v>4.8148176105615237</c:v>
                  </c:pt>
                  <c:pt idx="5">
                    <c:v>6.0558147186461442</c:v>
                  </c:pt>
                </c:numCache>
              </c:numRef>
            </c:plus>
            <c:minus>
              <c:numRef>
                <c:f>'Na+'!$K$48:$P$48</c:f>
                <c:numCache>
                  <c:formatCode>General</c:formatCode>
                  <c:ptCount val="6"/>
                  <c:pt idx="0">
                    <c:v>6.2436874515044796</c:v>
                  </c:pt>
                  <c:pt idx="1">
                    <c:v>4.8934839726181041</c:v>
                  </c:pt>
                  <c:pt idx="2">
                    <c:v>5.1146916277068133</c:v>
                  </c:pt>
                  <c:pt idx="3">
                    <c:v>4.6565228179410108</c:v>
                  </c:pt>
                  <c:pt idx="4">
                    <c:v>4.8148176105615237</c:v>
                  </c:pt>
                  <c:pt idx="5">
                    <c:v>6.0558147186461442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52C2DD"/>
                </a:solidFill>
                <a:round/>
              </a:ln>
              <a:effectLst/>
            </c:spPr>
          </c:errBars>
          <c:xVal>
            <c:numRef>
              <c:f>'Na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Na+'!$K$47:$P$47</c:f>
              <c:numCache>
                <c:formatCode>General</c:formatCode>
                <c:ptCount val="6"/>
                <c:pt idx="0">
                  <c:v>0.28920557384244028</c:v>
                </c:pt>
                <c:pt idx="1">
                  <c:v>0.3331566381391266</c:v>
                </c:pt>
                <c:pt idx="2">
                  <c:v>0.35870270722798914</c:v>
                </c:pt>
                <c:pt idx="3">
                  <c:v>-0.35105245596377471</c:v>
                </c:pt>
                <c:pt idx="4">
                  <c:v>0.16967720807610182</c:v>
                </c:pt>
                <c:pt idx="5">
                  <c:v>7.36178978978221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35F-4A62-980C-4AE02E07A6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3375488"/>
        <c:axId val="393376272"/>
      </c:scatterChart>
      <c:valAx>
        <c:axId val="393375488"/>
        <c:scaling>
          <c:orientation val="minMax"/>
          <c:max val="6.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6272"/>
        <c:crossesAt val="-200"/>
        <c:crossBetween val="midCat"/>
        <c:majorUnit val="2"/>
      </c:valAx>
      <c:valAx>
        <c:axId val="393376272"/>
        <c:scaling>
          <c:orientation val="minMax"/>
          <c:min val="-2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Net Na</a:t>
                </a:r>
                <a:r>
                  <a:rPr lang="en-US" sz="1200" baseline="30000" dirty="0"/>
                  <a:t>+</a:t>
                </a:r>
                <a:r>
                  <a:rPr lang="en-US" sz="1200" dirty="0"/>
                  <a:t> flux (nmol m</a:t>
                </a:r>
                <a:r>
                  <a:rPr lang="en-US" sz="1200" baseline="30000" dirty="0"/>
                  <a:t>-2</a:t>
                </a:r>
                <a:r>
                  <a:rPr lang="en-US" sz="1200" dirty="0"/>
                  <a:t> s</a:t>
                </a:r>
                <a:r>
                  <a:rPr lang="en-US" sz="1200" baseline="30000" dirty="0"/>
                  <a:t>-1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2.7438271604938273E-2"/>
              <c:y val="0.171740079365079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54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4468179012345675"/>
          <c:y val="0.46857500000000002"/>
          <c:w val="0.42213919753086421"/>
          <c:h val="0.2721476190476190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dirty="0"/>
              <a:t>Mature root zone</a:t>
            </a:r>
          </a:p>
        </c:rich>
      </c:tx>
      <c:layout>
        <c:manualLayout>
          <c:xMode val="edge"/>
          <c:yMode val="edge"/>
          <c:x val="0.2960256172839506"/>
          <c:y val="3.02380952380952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WT, sorbitol</c:v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B$14:$G$14</c:f>
                <c:numCache>
                  <c:formatCode>General</c:formatCode>
                  <c:ptCount val="6"/>
                  <c:pt idx="0">
                    <c:v>41.713941625095224</c:v>
                  </c:pt>
                  <c:pt idx="1">
                    <c:v>18.355832533477503</c:v>
                  </c:pt>
                  <c:pt idx="2">
                    <c:v>9.6043785565036366</c:v>
                  </c:pt>
                  <c:pt idx="3">
                    <c:v>11.650096343381653</c:v>
                  </c:pt>
                  <c:pt idx="4">
                    <c:v>10.50516814873901</c:v>
                  </c:pt>
                  <c:pt idx="5">
                    <c:v>3.1040827639392337</c:v>
                  </c:pt>
                </c:numCache>
              </c:numRef>
            </c:plus>
            <c:minus>
              <c:numRef>
                <c:f>'K+'!$B$14:$G$14</c:f>
                <c:numCache>
                  <c:formatCode>General</c:formatCode>
                  <c:ptCount val="6"/>
                  <c:pt idx="0">
                    <c:v>41.713941625095224</c:v>
                  </c:pt>
                  <c:pt idx="1">
                    <c:v>18.355832533477503</c:v>
                  </c:pt>
                  <c:pt idx="2">
                    <c:v>9.6043785565036366</c:v>
                  </c:pt>
                  <c:pt idx="3">
                    <c:v>11.650096343381653</c:v>
                  </c:pt>
                  <c:pt idx="4">
                    <c:v>10.50516814873901</c:v>
                  </c:pt>
                  <c:pt idx="5">
                    <c:v>3.10408276393923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K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B$13:$G$13</c:f>
              <c:numCache>
                <c:formatCode>General</c:formatCode>
                <c:ptCount val="6"/>
                <c:pt idx="0">
                  <c:v>-25.523683460369536</c:v>
                </c:pt>
                <c:pt idx="1">
                  <c:v>-9.3728373973160171</c:v>
                </c:pt>
                <c:pt idx="2">
                  <c:v>-3.6357321573268395</c:v>
                </c:pt>
                <c:pt idx="3">
                  <c:v>0.91751798313716382</c:v>
                </c:pt>
                <c:pt idx="4">
                  <c:v>3.1634043776369047</c:v>
                </c:pt>
                <c:pt idx="5">
                  <c:v>4.23330043655900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38B-4B61-AC33-7879DE8472DA}"/>
            </c:ext>
          </c:extLst>
        </c:ser>
        <c:ser>
          <c:idx val="0"/>
          <c:order val="1"/>
          <c:tx>
            <c:v>WT, NaCl</c:v>
          </c:tx>
          <c:spPr>
            <a:ln w="19050" cap="rnd">
              <a:solidFill>
                <a:srgbClr val="E74B3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B$25:$G$25</c:f>
                <c:numCache>
                  <c:formatCode>General</c:formatCode>
                  <c:ptCount val="6"/>
                  <c:pt idx="0">
                    <c:v>34.593416370677858</c:v>
                  </c:pt>
                  <c:pt idx="1">
                    <c:v>35.322843921143175</c:v>
                  </c:pt>
                  <c:pt idx="2">
                    <c:v>15.205117094240707</c:v>
                  </c:pt>
                  <c:pt idx="3">
                    <c:v>12.284018426620824</c:v>
                  </c:pt>
                  <c:pt idx="4">
                    <c:v>10.970272580300987</c:v>
                  </c:pt>
                  <c:pt idx="5">
                    <c:v>12.433670649805123</c:v>
                  </c:pt>
                </c:numCache>
              </c:numRef>
            </c:plus>
            <c:minus>
              <c:numRef>
                <c:f>'K+'!$B$25:$G$25</c:f>
                <c:numCache>
                  <c:formatCode>General</c:formatCode>
                  <c:ptCount val="6"/>
                  <c:pt idx="0">
                    <c:v>34.593416370677858</c:v>
                  </c:pt>
                  <c:pt idx="1">
                    <c:v>35.322843921143175</c:v>
                  </c:pt>
                  <c:pt idx="2">
                    <c:v>15.205117094240707</c:v>
                  </c:pt>
                  <c:pt idx="3">
                    <c:v>12.284018426620824</c:v>
                  </c:pt>
                  <c:pt idx="4">
                    <c:v>10.970272580300987</c:v>
                  </c:pt>
                  <c:pt idx="5">
                    <c:v>12.433670649805123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E74B35"/>
                </a:solidFill>
                <a:round/>
              </a:ln>
              <a:effectLst/>
            </c:spPr>
          </c:errBars>
          <c:xVal>
            <c:numRef>
              <c:f>'K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B$24:$G$24</c:f>
              <c:numCache>
                <c:formatCode>General</c:formatCode>
                <c:ptCount val="6"/>
                <c:pt idx="0">
                  <c:v>-30.179197698412697</c:v>
                </c:pt>
                <c:pt idx="1">
                  <c:v>-26.877750714285714</c:v>
                </c:pt>
                <c:pt idx="2">
                  <c:v>-5.9423458571951135</c:v>
                </c:pt>
                <c:pt idx="3">
                  <c:v>1.9734042847833155</c:v>
                </c:pt>
                <c:pt idx="4">
                  <c:v>-0.2197794727494736</c:v>
                </c:pt>
                <c:pt idx="5">
                  <c:v>5.61536919610855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38B-4B61-AC33-7879DE8472DA}"/>
            </c:ext>
          </c:extLst>
        </c:ser>
        <c:ser>
          <c:idx val="3"/>
          <c:order val="2"/>
          <c:tx>
            <c:v>WT, NaCl, amiloride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B$35:$G$35</c:f>
                <c:numCache>
                  <c:formatCode>General</c:formatCode>
                  <c:ptCount val="6"/>
                  <c:pt idx="0">
                    <c:v>20.356354488624685</c:v>
                  </c:pt>
                  <c:pt idx="1">
                    <c:v>30.802558775964297</c:v>
                  </c:pt>
                  <c:pt idx="2">
                    <c:v>15.754119707062546</c:v>
                  </c:pt>
                  <c:pt idx="3">
                    <c:v>14.867044101762295</c:v>
                  </c:pt>
                  <c:pt idx="4">
                    <c:v>14.308435680217821</c:v>
                  </c:pt>
                  <c:pt idx="5">
                    <c:v>16.466156623942673</c:v>
                  </c:pt>
                </c:numCache>
              </c:numRef>
            </c:plus>
            <c:minus>
              <c:numRef>
                <c:f>'K+'!$B$35:$G$35</c:f>
                <c:numCache>
                  <c:formatCode>General</c:formatCode>
                  <c:ptCount val="6"/>
                  <c:pt idx="0">
                    <c:v>20.356354488624685</c:v>
                  </c:pt>
                  <c:pt idx="1">
                    <c:v>30.802558775964297</c:v>
                  </c:pt>
                  <c:pt idx="2">
                    <c:v>15.754119707062546</c:v>
                  </c:pt>
                  <c:pt idx="3">
                    <c:v>14.867044101762295</c:v>
                  </c:pt>
                  <c:pt idx="4">
                    <c:v>14.308435680217821</c:v>
                  </c:pt>
                  <c:pt idx="5">
                    <c:v>16.4661566239426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K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B$34:$G$34</c:f>
              <c:numCache>
                <c:formatCode>General</c:formatCode>
                <c:ptCount val="6"/>
                <c:pt idx="0">
                  <c:v>-27.738829072681703</c:v>
                </c:pt>
                <c:pt idx="1">
                  <c:v>-14.804257142857139</c:v>
                </c:pt>
                <c:pt idx="2">
                  <c:v>-22.443569990842491</c:v>
                </c:pt>
                <c:pt idx="3">
                  <c:v>-14.564875045962731</c:v>
                </c:pt>
                <c:pt idx="4">
                  <c:v>-13.716066273291926</c:v>
                </c:pt>
                <c:pt idx="5">
                  <c:v>-8.9591287246376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38B-4B61-AC33-7879DE8472DA}"/>
            </c:ext>
          </c:extLst>
        </c:ser>
        <c:ser>
          <c:idx val="2"/>
          <c:order val="3"/>
          <c:tx>
            <c:v>sos1, NaCl</c:v>
          </c:tx>
          <c:spPr>
            <a:ln w="19050" cap="rnd">
              <a:solidFill>
                <a:srgbClr val="52C2DD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2C2DD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B$48:$G$48</c:f>
                <c:numCache>
                  <c:formatCode>General</c:formatCode>
                  <c:ptCount val="6"/>
                  <c:pt idx="0">
                    <c:v>31.868062767793994</c:v>
                  </c:pt>
                  <c:pt idx="1">
                    <c:v>19.225357915185445</c:v>
                  </c:pt>
                  <c:pt idx="2">
                    <c:v>16.920400948737516</c:v>
                  </c:pt>
                  <c:pt idx="3">
                    <c:v>13.950861079905438</c:v>
                  </c:pt>
                  <c:pt idx="4">
                    <c:v>11.931165696862651</c:v>
                  </c:pt>
                  <c:pt idx="5">
                    <c:v>7.7908489862457158</c:v>
                  </c:pt>
                </c:numCache>
              </c:numRef>
            </c:plus>
            <c:minus>
              <c:numRef>
                <c:f>'K+'!$B$48:$G$48</c:f>
                <c:numCache>
                  <c:formatCode>General</c:formatCode>
                  <c:ptCount val="6"/>
                  <c:pt idx="0">
                    <c:v>31.868062767793994</c:v>
                  </c:pt>
                  <c:pt idx="1">
                    <c:v>19.225357915185445</c:v>
                  </c:pt>
                  <c:pt idx="2">
                    <c:v>16.920400948737516</c:v>
                  </c:pt>
                  <c:pt idx="3">
                    <c:v>13.950861079905438</c:v>
                  </c:pt>
                  <c:pt idx="4">
                    <c:v>11.931165696862651</c:v>
                  </c:pt>
                  <c:pt idx="5">
                    <c:v>7.7908489862457158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52C2DD"/>
                </a:solidFill>
                <a:round/>
              </a:ln>
              <a:effectLst/>
            </c:spPr>
          </c:errBars>
          <c:xVal>
            <c:numRef>
              <c:f>'K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B$47:$G$47</c:f>
              <c:numCache>
                <c:formatCode>General</c:formatCode>
                <c:ptCount val="6"/>
                <c:pt idx="0">
                  <c:v>-36.979005680326061</c:v>
                </c:pt>
                <c:pt idx="1">
                  <c:v>-18.0934216525716</c:v>
                </c:pt>
                <c:pt idx="2">
                  <c:v>-12.681206879432338</c:v>
                </c:pt>
                <c:pt idx="3">
                  <c:v>-6.9435400132275111</c:v>
                </c:pt>
                <c:pt idx="4">
                  <c:v>-11.234841328066446</c:v>
                </c:pt>
                <c:pt idx="5">
                  <c:v>-4.30582362255680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38B-4B61-AC33-7879DE8472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3372352"/>
        <c:axId val="393378232"/>
      </c:scatterChart>
      <c:valAx>
        <c:axId val="393372352"/>
        <c:scaling>
          <c:orientation val="minMax"/>
          <c:max val="6.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8232"/>
        <c:crossesAt val="-300"/>
        <c:crossBetween val="midCat"/>
      </c:valAx>
      <c:valAx>
        <c:axId val="393378232"/>
        <c:scaling>
          <c:orientation val="minMax"/>
          <c:max val="25"/>
          <c:min val="-3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Net K</a:t>
                </a:r>
                <a:r>
                  <a:rPr lang="en-US" sz="1200" baseline="30000" dirty="0"/>
                  <a:t>+</a:t>
                </a:r>
                <a:r>
                  <a:rPr lang="en-US" sz="1200" dirty="0"/>
                  <a:t> flux (nmol m</a:t>
                </a:r>
                <a:r>
                  <a:rPr lang="en-US" sz="1200" baseline="30000" dirty="0"/>
                  <a:t>-2</a:t>
                </a:r>
                <a:r>
                  <a:rPr lang="en-US" sz="1200" dirty="0"/>
                  <a:t> s</a:t>
                </a:r>
                <a:r>
                  <a:rPr lang="en-US" sz="1200" baseline="30000" dirty="0"/>
                  <a:t>-1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2.7438271604938273E-2"/>
              <c:y val="0.186859126984126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235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7606481481481483"/>
          <c:y val="0.46550753968253966"/>
          <c:w val="0.42202160493827162"/>
          <c:h val="0.2704460317460317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dirty="0"/>
              <a:t>Root apex</a:t>
            </a:r>
          </a:p>
        </c:rich>
      </c:tx>
      <c:layout>
        <c:manualLayout>
          <c:xMode val="edge"/>
          <c:yMode val="edge"/>
          <c:x val="0.40388765432098767"/>
          <c:y val="3.02380952380952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WT, sorbitol</c:v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K$14:$P$14</c:f>
                <c:numCache>
                  <c:formatCode>General</c:formatCode>
                  <c:ptCount val="6"/>
                  <c:pt idx="0">
                    <c:v>67.423275310872256</c:v>
                  </c:pt>
                  <c:pt idx="1">
                    <c:v>20.944704159159553</c:v>
                  </c:pt>
                  <c:pt idx="2">
                    <c:v>5.9552912425943925</c:v>
                  </c:pt>
                  <c:pt idx="3">
                    <c:v>7.1694414810902796</c:v>
                  </c:pt>
                  <c:pt idx="4">
                    <c:v>5.2915094205875297</c:v>
                  </c:pt>
                  <c:pt idx="5">
                    <c:v>2.0215062292039496</c:v>
                  </c:pt>
                </c:numCache>
              </c:numRef>
            </c:plus>
            <c:minus>
              <c:numRef>
                <c:f>'K+'!$K$14:$P$14</c:f>
                <c:numCache>
                  <c:formatCode>General</c:formatCode>
                  <c:ptCount val="6"/>
                  <c:pt idx="0">
                    <c:v>67.423275310872256</c:v>
                  </c:pt>
                  <c:pt idx="1">
                    <c:v>20.944704159159553</c:v>
                  </c:pt>
                  <c:pt idx="2">
                    <c:v>5.9552912425943925</c:v>
                  </c:pt>
                  <c:pt idx="3">
                    <c:v>7.1694414810902796</c:v>
                  </c:pt>
                  <c:pt idx="4">
                    <c:v>5.2915094205875297</c:v>
                  </c:pt>
                  <c:pt idx="5">
                    <c:v>2.02150622920394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K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K$13:$P$13</c:f>
              <c:numCache>
                <c:formatCode>General</c:formatCode>
                <c:ptCount val="6"/>
                <c:pt idx="0">
                  <c:v>-109.659719964904</c:v>
                </c:pt>
                <c:pt idx="1">
                  <c:v>-47.410136761555293</c:v>
                </c:pt>
                <c:pt idx="2">
                  <c:v>-16.377626348324736</c:v>
                </c:pt>
                <c:pt idx="3">
                  <c:v>-15.657559465032199</c:v>
                </c:pt>
                <c:pt idx="4">
                  <c:v>-9.1558550808392845</c:v>
                </c:pt>
                <c:pt idx="5">
                  <c:v>-4.0981861889461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AB7-4929-A12F-AF86AE1B9C94}"/>
            </c:ext>
          </c:extLst>
        </c:ser>
        <c:ser>
          <c:idx val="0"/>
          <c:order val="1"/>
          <c:tx>
            <c:v>WT, NaCl</c:v>
          </c:tx>
          <c:spPr>
            <a:ln w="19050" cap="rnd">
              <a:solidFill>
                <a:srgbClr val="E74B3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K$25:$P$25</c:f>
                <c:numCache>
                  <c:formatCode>General</c:formatCode>
                  <c:ptCount val="6"/>
                  <c:pt idx="0">
                    <c:v>120.06438468481301</c:v>
                  </c:pt>
                  <c:pt idx="1">
                    <c:v>85.535868175143548</c:v>
                  </c:pt>
                  <c:pt idx="2">
                    <c:v>19.952326987331585</c:v>
                  </c:pt>
                  <c:pt idx="3">
                    <c:v>11.08554560125148</c:v>
                  </c:pt>
                  <c:pt idx="4">
                    <c:v>9.5494696220253417</c:v>
                  </c:pt>
                  <c:pt idx="5">
                    <c:v>7.5354402421004183</c:v>
                  </c:pt>
                </c:numCache>
              </c:numRef>
            </c:plus>
            <c:minus>
              <c:numRef>
                <c:f>'K+'!$K$25:$P$25</c:f>
                <c:numCache>
                  <c:formatCode>General</c:formatCode>
                  <c:ptCount val="6"/>
                  <c:pt idx="0">
                    <c:v>120.06438468481301</c:v>
                  </c:pt>
                  <c:pt idx="1">
                    <c:v>85.535868175143548</c:v>
                  </c:pt>
                  <c:pt idx="2">
                    <c:v>19.952326987331585</c:v>
                  </c:pt>
                  <c:pt idx="3">
                    <c:v>11.08554560125148</c:v>
                  </c:pt>
                  <c:pt idx="4">
                    <c:v>9.5494696220253417</c:v>
                  </c:pt>
                  <c:pt idx="5">
                    <c:v>7.5354402421004183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E74B35"/>
                </a:solidFill>
                <a:round/>
              </a:ln>
              <a:effectLst/>
            </c:spPr>
          </c:errBars>
          <c:xVal>
            <c:numRef>
              <c:f>'K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K$24:$P$24</c:f>
              <c:numCache>
                <c:formatCode>General</c:formatCode>
                <c:ptCount val="6"/>
                <c:pt idx="0">
                  <c:v>-123.89094358422938</c:v>
                </c:pt>
                <c:pt idx="1">
                  <c:v>-66.333700279756087</c:v>
                </c:pt>
                <c:pt idx="2">
                  <c:v>-25.734185800815698</c:v>
                </c:pt>
                <c:pt idx="3">
                  <c:v>-12.633757355439029</c:v>
                </c:pt>
                <c:pt idx="4">
                  <c:v>-10.682154562328352</c:v>
                </c:pt>
                <c:pt idx="5">
                  <c:v>-2.07993571428571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AB7-4929-A12F-AF86AE1B9C94}"/>
            </c:ext>
          </c:extLst>
        </c:ser>
        <c:ser>
          <c:idx val="3"/>
          <c:order val="2"/>
          <c:tx>
            <c:v>WT, NaCl, amiloride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K$35:$P$35</c:f>
                <c:numCache>
                  <c:formatCode>General</c:formatCode>
                  <c:ptCount val="6"/>
                  <c:pt idx="0">
                    <c:v>39.452604825757177</c:v>
                  </c:pt>
                  <c:pt idx="1">
                    <c:v>49.802736437548042</c:v>
                  </c:pt>
                  <c:pt idx="2">
                    <c:v>31.921103139775997</c:v>
                  </c:pt>
                  <c:pt idx="3">
                    <c:v>14.669483044039168</c:v>
                  </c:pt>
                  <c:pt idx="4">
                    <c:v>21.80173041333979</c:v>
                  </c:pt>
                  <c:pt idx="5">
                    <c:v>13.052382856071389</c:v>
                  </c:pt>
                </c:numCache>
              </c:numRef>
            </c:plus>
            <c:minus>
              <c:numRef>
                <c:f>'K+'!$K$35:$P$35</c:f>
                <c:numCache>
                  <c:formatCode>General</c:formatCode>
                  <c:ptCount val="6"/>
                  <c:pt idx="0">
                    <c:v>39.452604825757177</c:v>
                  </c:pt>
                  <c:pt idx="1">
                    <c:v>49.802736437548042</c:v>
                  </c:pt>
                  <c:pt idx="2">
                    <c:v>31.921103139775997</c:v>
                  </c:pt>
                  <c:pt idx="3">
                    <c:v>14.669483044039168</c:v>
                  </c:pt>
                  <c:pt idx="4">
                    <c:v>21.80173041333979</c:v>
                  </c:pt>
                  <c:pt idx="5">
                    <c:v>13.0523828560713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K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K$34:$P$34</c:f>
              <c:numCache>
                <c:formatCode>General</c:formatCode>
                <c:ptCount val="6"/>
                <c:pt idx="0">
                  <c:v>-99.151338095238103</c:v>
                </c:pt>
                <c:pt idx="1">
                  <c:v>-86.982836249999991</c:v>
                </c:pt>
                <c:pt idx="2">
                  <c:v>-62.816337992424245</c:v>
                </c:pt>
                <c:pt idx="3">
                  <c:v>-27.4825797965368</c:v>
                </c:pt>
                <c:pt idx="4">
                  <c:v>-30.617656184829663</c:v>
                </c:pt>
                <c:pt idx="5">
                  <c:v>-17.228748627450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AB7-4929-A12F-AF86AE1B9C94}"/>
            </c:ext>
          </c:extLst>
        </c:ser>
        <c:ser>
          <c:idx val="2"/>
          <c:order val="3"/>
          <c:tx>
            <c:v>sos1, NaCl</c:v>
          </c:tx>
          <c:spPr>
            <a:ln w="19050" cap="rnd">
              <a:solidFill>
                <a:srgbClr val="52C2DD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2C2DD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K+'!$K$48:$P$48</c:f>
                <c:numCache>
                  <c:formatCode>General</c:formatCode>
                  <c:ptCount val="6"/>
                  <c:pt idx="0">
                    <c:v>83.634439300599155</c:v>
                  </c:pt>
                  <c:pt idx="1">
                    <c:v>70.605560052372127</c:v>
                  </c:pt>
                  <c:pt idx="2">
                    <c:v>59.45615190125617</c:v>
                  </c:pt>
                  <c:pt idx="3">
                    <c:v>32.928510821659081</c:v>
                  </c:pt>
                  <c:pt idx="4">
                    <c:v>25.881412867492443</c:v>
                  </c:pt>
                  <c:pt idx="5">
                    <c:v>14.637926234596048</c:v>
                  </c:pt>
                </c:numCache>
              </c:numRef>
            </c:plus>
            <c:minus>
              <c:numRef>
                <c:f>'K+'!$K$48:$P$48</c:f>
                <c:numCache>
                  <c:formatCode>General</c:formatCode>
                  <c:ptCount val="6"/>
                  <c:pt idx="0">
                    <c:v>83.634439300599155</c:v>
                  </c:pt>
                  <c:pt idx="1">
                    <c:v>70.605560052372127</c:v>
                  </c:pt>
                  <c:pt idx="2">
                    <c:v>59.45615190125617</c:v>
                  </c:pt>
                  <c:pt idx="3">
                    <c:v>32.928510821659081</c:v>
                  </c:pt>
                  <c:pt idx="4">
                    <c:v>25.881412867492443</c:v>
                  </c:pt>
                  <c:pt idx="5">
                    <c:v>14.637926234596048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52C2DD"/>
                </a:solidFill>
                <a:round/>
              </a:ln>
              <a:effectLst/>
            </c:spPr>
          </c:errBars>
          <c:xVal>
            <c:numRef>
              <c:f>'K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K+'!$K$47:$P$47</c:f>
              <c:numCache>
                <c:formatCode>General</c:formatCode>
                <c:ptCount val="6"/>
                <c:pt idx="0">
                  <c:v>-207.41773959293397</c:v>
                </c:pt>
                <c:pt idx="1">
                  <c:v>-119.74386218737996</c:v>
                </c:pt>
                <c:pt idx="2">
                  <c:v>-84.928362064966947</c:v>
                </c:pt>
                <c:pt idx="3">
                  <c:v>-58.315771050011826</c:v>
                </c:pt>
                <c:pt idx="4">
                  <c:v>-54.186805509812771</c:v>
                </c:pt>
                <c:pt idx="5">
                  <c:v>-23.9429030905977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AB7-4929-A12F-AF86AE1B9C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3373136"/>
        <c:axId val="393377056"/>
      </c:scatterChart>
      <c:valAx>
        <c:axId val="393373136"/>
        <c:scaling>
          <c:orientation val="minMax"/>
          <c:max val="6.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7056"/>
        <c:crossesAt val="-300"/>
        <c:crossBetween val="midCat"/>
      </c:valAx>
      <c:valAx>
        <c:axId val="393377056"/>
        <c:scaling>
          <c:orientation val="minMax"/>
          <c:max val="25"/>
          <c:min val="-3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Net K</a:t>
                </a:r>
                <a:r>
                  <a:rPr lang="en-US" sz="1200" baseline="30000" dirty="0"/>
                  <a:t>+</a:t>
                </a:r>
                <a:r>
                  <a:rPr lang="en-US" sz="1200" dirty="0"/>
                  <a:t> flux (nmol m</a:t>
                </a:r>
                <a:r>
                  <a:rPr lang="en-US" sz="1200" baseline="30000" dirty="0"/>
                  <a:t>-2</a:t>
                </a:r>
                <a:r>
                  <a:rPr lang="en-US" sz="1200" dirty="0"/>
                  <a:t> s</a:t>
                </a:r>
                <a:r>
                  <a:rPr lang="en-US" sz="1200" baseline="30000" dirty="0"/>
                  <a:t>-1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2.7438271604938273E-2"/>
              <c:y val="0.186342460317460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337313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7606481481481489"/>
          <c:y val="0.46550753968253966"/>
          <c:w val="0.42202160493827168"/>
          <c:h val="0.2704460317460317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dirty="0"/>
              <a:t>Mature root zone</a:t>
            </a:r>
          </a:p>
        </c:rich>
      </c:tx>
      <c:layout>
        <c:manualLayout>
          <c:xMode val="edge"/>
          <c:yMode val="edge"/>
          <c:x val="0.2960256172839506"/>
          <c:y val="3.02380952380952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WT, sorbitol</c:v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B$14:$G$14</c:f>
                <c:numCache>
                  <c:formatCode>General</c:formatCode>
                  <c:ptCount val="6"/>
                  <c:pt idx="0">
                    <c:v>28.890687566009735</c:v>
                  </c:pt>
                  <c:pt idx="1">
                    <c:v>65.826031590798905</c:v>
                  </c:pt>
                  <c:pt idx="2">
                    <c:v>66.205305185924814</c:v>
                  </c:pt>
                  <c:pt idx="3">
                    <c:v>39.140874409789177</c:v>
                  </c:pt>
                  <c:pt idx="4">
                    <c:v>33.261498697568044</c:v>
                  </c:pt>
                  <c:pt idx="5">
                    <c:v>32.391778337470612</c:v>
                  </c:pt>
                </c:numCache>
              </c:numRef>
            </c:plus>
            <c:minus>
              <c:numRef>
                <c:f>'H+'!$B$14:$G$14</c:f>
                <c:numCache>
                  <c:formatCode>General</c:formatCode>
                  <c:ptCount val="6"/>
                  <c:pt idx="0">
                    <c:v>28.890687566009735</c:v>
                  </c:pt>
                  <c:pt idx="1">
                    <c:v>65.826031590798905</c:v>
                  </c:pt>
                  <c:pt idx="2">
                    <c:v>66.205305185924814</c:v>
                  </c:pt>
                  <c:pt idx="3">
                    <c:v>39.140874409789177</c:v>
                  </c:pt>
                  <c:pt idx="4">
                    <c:v>33.261498697568044</c:v>
                  </c:pt>
                  <c:pt idx="5">
                    <c:v>32.3917783374706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H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B$13:$G$13</c:f>
              <c:numCache>
                <c:formatCode>General</c:formatCode>
                <c:ptCount val="6"/>
                <c:pt idx="0">
                  <c:v>-16.098467508340725</c:v>
                </c:pt>
                <c:pt idx="1">
                  <c:v>-75.769374649529979</c:v>
                </c:pt>
                <c:pt idx="2">
                  <c:v>-78.105596528299316</c:v>
                </c:pt>
                <c:pt idx="3">
                  <c:v>-54.556094940745346</c:v>
                </c:pt>
                <c:pt idx="4">
                  <c:v>-50.859533858163267</c:v>
                </c:pt>
                <c:pt idx="5">
                  <c:v>-40.8689092028012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962-49B4-B574-57CC6BF80F99}"/>
            </c:ext>
          </c:extLst>
        </c:ser>
        <c:ser>
          <c:idx val="0"/>
          <c:order val="1"/>
          <c:tx>
            <c:v>WT, NaCl</c:v>
          </c:tx>
          <c:spPr>
            <a:ln w="19050" cap="rnd">
              <a:solidFill>
                <a:srgbClr val="E74B3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B$25:$G$25</c:f>
                <c:numCache>
                  <c:formatCode>General</c:formatCode>
                  <c:ptCount val="6"/>
                  <c:pt idx="0">
                    <c:v>51.772563676934055</c:v>
                  </c:pt>
                  <c:pt idx="1">
                    <c:v>29.138450229186002</c:v>
                  </c:pt>
                  <c:pt idx="2">
                    <c:v>29.383537302411792</c:v>
                  </c:pt>
                  <c:pt idx="3">
                    <c:v>41.533267826416726</c:v>
                  </c:pt>
                  <c:pt idx="4">
                    <c:v>54.940417779771423</c:v>
                  </c:pt>
                  <c:pt idx="5">
                    <c:v>25.298575301203869</c:v>
                  </c:pt>
                </c:numCache>
              </c:numRef>
            </c:plus>
            <c:minus>
              <c:numRef>
                <c:f>'H+'!$B$25:$G$25</c:f>
                <c:numCache>
                  <c:formatCode>General</c:formatCode>
                  <c:ptCount val="6"/>
                  <c:pt idx="0">
                    <c:v>51.772563676934055</c:v>
                  </c:pt>
                  <c:pt idx="1">
                    <c:v>29.138450229186002</c:v>
                  </c:pt>
                  <c:pt idx="2">
                    <c:v>29.383537302411792</c:v>
                  </c:pt>
                  <c:pt idx="3">
                    <c:v>41.533267826416726</c:v>
                  </c:pt>
                  <c:pt idx="4">
                    <c:v>54.940417779771423</c:v>
                  </c:pt>
                  <c:pt idx="5">
                    <c:v>25.298575301203869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E74B35"/>
                </a:solidFill>
                <a:round/>
              </a:ln>
              <a:effectLst/>
            </c:spPr>
          </c:errBars>
          <c:xVal>
            <c:numRef>
              <c:f>'H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B$24:$G$24</c:f>
              <c:numCache>
                <c:formatCode>General</c:formatCode>
                <c:ptCount val="6"/>
                <c:pt idx="0">
                  <c:v>-63.007660650281615</c:v>
                </c:pt>
                <c:pt idx="1">
                  <c:v>-44.173432291488886</c:v>
                </c:pt>
                <c:pt idx="2">
                  <c:v>-51.658824363971839</c:v>
                </c:pt>
                <c:pt idx="3">
                  <c:v>-60.855213259321317</c:v>
                </c:pt>
                <c:pt idx="4">
                  <c:v>-74.268011808164971</c:v>
                </c:pt>
                <c:pt idx="5">
                  <c:v>-56.4965522427035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962-49B4-B574-57CC6BF80F99}"/>
            </c:ext>
          </c:extLst>
        </c:ser>
        <c:ser>
          <c:idx val="3"/>
          <c:order val="2"/>
          <c:tx>
            <c:v>WT, NaCl, amiloride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B$35:$G$35</c:f>
                <c:numCache>
                  <c:formatCode>General</c:formatCode>
                  <c:ptCount val="6"/>
                  <c:pt idx="0">
                    <c:v>14.288618844816428</c:v>
                  </c:pt>
                  <c:pt idx="1">
                    <c:v>17.21469860922608</c:v>
                  </c:pt>
                  <c:pt idx="2">
                    <c:v>14.136213579668567</c:v>
                  </c:pt>
                  <c:pt idx="3">
                    <c:v>19.86125511703052</c:v>
                  </c:pt>
                  <c:pt idx="4">
                    <c:v>38.691489629084479</c:v>
                  </c:pt>
                  <c:pt idx="5">
                    <c:v>43.032354793492743</c:v>
                  </c:pt>
                </c:numCache>
              </c:numRef>
            </c:plus>
            <c:minus>
              <c:numRef>
                <c:f>'H+'!$B$35:$G$35</c:f>
                <c:numCache>
                  <c:formatCode>General</c:formatCode>
                  <c:ptCount val="6"/>
                  <c:pt idx="0">
                    <c:v>14.288618844816428</c:v>
                  </c:pt>
                  <c:pt idx="1">
                    <c:v>17.21469860922608</c:v>
                  </c:pt>
                  <c:pt idx="2">
                    <c:v>14.136213579668567</c:v>
                  </c:pt>
                  <c:pt idx="3">
                    <c:v>19.86125511703052</c:v>
                  </c:pt>
                  <c:pt idx="4">
                    <c:v>38.691489629084479</c:v>
                  </c:pt>
                  <c:pt idx="5">
                    <c:v>43.0323547934927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H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B$34:$G$34</c:f>
              <c:numCache>
                <c:formatCode>General</c:formatCode>
                <c:ptCount val="6"/>
                <c:pt idx="0">
                  <c:v>5.0952938847117784</c:v>
                </c:pt>
                <c:pt idx="1">
                  <c:v>-25.30935896103896</c:v>
                </c:pt>
                <c:pt idx="2">
                  <c:v>-36.845196399267401</c:v>
                </c:pt>
                <c:pt idx="3">
                  <c:v>-32.630239602484465</c:v>
                </c:pt>
                <c:pt idx="4">
                  <c:v>-51.234197363699103</c:v>
                </c:pt>
                <c:pt idx="5">
                  <c:v>-41.9741628964803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962-49B4-B574-57CC6BF80F99}"/>
            </c:ext>
          </c:extLst>
        </c:ser>
        <c:ser>
          <c:idx val="2"/>
          <c:order val="3"/>
          <c:tx>
            <c:v>sos1, NaCl</c:v>
          </c:tx>
          <c:spPr>
            <a:ln w="19050" cap="rnd">
              <a:solidFill>
                <a:srgbClr val="52C2DD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2C2DD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B$45:$G$45</c:f>
                <c:numCache>
                  <c:formatCode>General</c:formatCode>
                  <c:ptCount val="6"/>
                  <c:pt idx="0">
                    <c:v>15.899314032304185</c:v>
                  </c:pt>
                  <c:pt idx="1">
                    <c:v>21.742878080043752</c:v>
                  </c:pt>
                  <c:pt idx="2">
                    <c:v>20.272087336016643</c:v>
                  </c:pt>
                  <c:pt idx="3">
                    <c:v>23.249855041941135</c:v>
                  </c:pt>
                  <c:pt idx="4">
                    <c:v>28.50587690567049</c:v>
                  </c:pt>
                  <c:pt idx="5">
                    <c:v>32.383896286564074</c:v>
                  </c:pt>
                </c:numCache>
              </c:numRef>
            </c:plus>
            <c:minus>
              <c:numRef>
                <c:f>'H+'!$B$45:$G$45</c:f>
                <c:numCache>
                  <c:formatCode>General</c:formatCode>
                  <c:ptCount val="6"/>
                  <c:pt idx="0">
                    <c:v>15.899314032304185</c:v>
                  </c:pt>
                  <c:pt idx="1">
                    <c:v>21.742878080043752</c:v>
                  </c:pt>
                  <c:pt idx="2">
                    <c:v>20.272087336016643</c:v>
                  </c:pt>
                  <c:pt idx="3">
                    <c:v>23.249855041941135</c:v>
                  </c:pt>
                  <c:pt idx="4">
                    <c:v>28.50587690567049</c:v>
                  </c:pt>
                  <c:pt idx="5">
                    <c:v>32.383896286564074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52C2DD"/>
                </a:solidFill>
                <a:round/>
              </a:ln>
              <a:effectLst/>
            </c:spPr>
          </c:errBars>
          <c:xVal>
            <c:numRef>
              <c:f>'H+'!$B$2:$G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B$44:$G$44</c:f>
              <c:numCache>
                <c:formatCode>General</c:formatCode>
                <c:ptCount val="6"/>
                <c:pt idx="0">
                  <c:v>-18.554261033794166</c:v>
                </c:pt>
                <c:pt idx="1">
                  <c:v>-22.213941928042324</c:v>
                </c:pt>
                <c:pt idx="2">
                  <c:v>-32.456679433333328</c:v>
                </c:pt>
                <c:pt idx="3">
                  <c:v>-32.564597023041472</c:v>
                </c:pt>
                <c:pt idx="4">
                  <c:v>-33.621177084485403</c:v>
                </c:pt>
                <c:pt idx="5">
                  <c:v>-24.7946341405794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962-49B4-B574-57CC6BF80F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2359840"/>
        <c:axId val="492361408"/>
      </c:scatterChart>
      <c:valAx>
        <c:axId val="492359840"/>
        <c:scaling>
          <c:orientation val="minMax"/>
          <c:max val="6.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92361408"/>
        <c:crossesAt val="-150"/>
        <c:crossBetween val="midCat"/>
      </c:valAx>
      <c:valAx>
        <c:axId val="492361408"/>
        <c:scaling>
          <c:orientation val="minMax"/>
          <c:max val="150"/>
          <c:min val="-15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Net H</a:t>
                </a:r>
                <a:r>
                  <a:rPr lang="en-US" sz="1200" baseline="30000" dirty="0"/>
                  <a:t>+</a:t>
                </a:r>
                <a:r>
                  <a:rPr lang="en-US" sz="1200" dirty="0"/>
                  <a:t> flux (nmol m</a:t>
                </a:r>
                <a:r>
                  <a:rPr lang="en-US" sz="1200" baseline="30000" dirty="0"/>
                  <a:t>-2</a:t>
                </a:r>
                <a:r>
                  <a:rPr lang="en-US" sz="1200" dirty="0"/>
                  <a:t> s</a:t>
                </a:r>
                <a:r>
                  <a:rPr lang="en-US" sz="1200" baseline="30000" dirty="0"/>
                  <a:t>-1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2.7438271604938273E-2"/>
              <c:y val="0.186859126984126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923598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5847222222222214"/>
          <c:y val="0.18328531746031748"/>
          <c:w val="0.42202160493827168"/>
          <c:h val="0.2704460317460317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 dirty="0"/>
              <a:t>Root apex</a:t>
            </a:r>
          </a:p>
        </c:rich>
      </c:tx>
      <c:layout>
        <c:manualLayout>
          <c:xMode val="edge"/>
          <c:yMode val="edge"/>
          <c:x val="0.40388765432098767"/>
          <c:y val="3.02380952380952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WT, sorbitol</c:v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K$14:$P$14</c:f>
                <c:numCache>
                  <c:formatCode>General</c:formatCode>
                  <c:ptCount val="6"/>
                  <c:pt idx="0">
                    <c:v>30.00401952002165</c:v>
                  </c:pt>
                  <c:pt idx="1">
                    <c:v>31.749382588836184</c:v>
                  </c:pt>
                  <c:pt idx="2">
                    <c:v>39.157864506739493</c:v>
                  </c:pt>
                  <c:pt idx="3">
                    <c:v>18.715830183803849</c:v>
                  </c:pt>
                  <c:pt idx="4">
                    <c:v>35.66545842097004</c:v>
                  </c:pt>
                  <c:pt idx="5">
                    <c:v>22.884791539792062</c:v>
                  </c:pt>
                </c:numCache>
              </c:numRef>
            </c:plus>
            <c:minus>
              <c:numRef>
                <c:f>'H+'!$K$14:$P$14</c:f>
                <c:numCache>
                  <c:formatCode>General</c:formatCode>
                  <c:ptCount val="6"/>
                  <c:pt idx="0">
                    <c:v>30.00401952002165</c:v>
                  </c:pt>
                  <c:pt idx="1">
                    <c:v>31.749382588836184</c:v>
                  </c:pt>
                  <c:pt idx="2">
                    <c:v>39.157864506739493</c:v>
                  </c:pt>
                  <c:pt idx="3">
                    <c:v>18.715830183803849</c:v>
                  </c:pt>
                  <c:pt idx="4">
                    <c:v>35.66545842097004</c:v>
                  </c:pt>
                  <c:pt idx="5">
                    <c:v>22.8847915397920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'H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K$13:$P$13</c:f>
              <c:numCache>
                <c:formatCode>General</c:formatCode>
                <c:ptCount val="6"/>
                <c:pt idx="0">
                  <c:v>66.985334611590943</c:v>
                </c:pt>
                <c:pt idx="1">
                  <c:v>67.291641460423534</c:v>
                </c:pt>
                <c:pt idx="2">
                  <c:v>65.402248052411181</c:v>
                </c:pt>
                <c:pt idx="3">
                  <c:v>44.257125324433083</c:v>
                </c:pt>
                <c:pt idx="4">
                  <c:v>30.200393642925171</c:v>
                </c:pt>
                <c:pt idx="5">
                  <c:v>33.9304903587422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8CE-4790-8AB4-4D29E895D26A}"/>
            </c:ext>
          </c:extLst>
        </c:ser>
        <c:ser>
          <c:idx val="0"/>
          <c:order val="1"/>
          <c:tx>
            <c:v>WT, NaCl</c:v>
          </c:tx>
          <c:spPr>
            <a:ln w="19050" cap="rnd">
              <a:solidFill>
                <a:srgbClr val="E74B3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74B35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K$25:$P$25</c:f>
                <c:numCache>
                  <c:formatCode>General</c:formatCode>
                  <c:ptCount val="6"/>
                  <c:pt idx="0">
                    <c:v>8.0131662967600157</c:v>
                  </c:pt>
                  <c:pt idx="1">
                    <c:v>10.471212497836932</c:v>
                  </c:pt>
                  <c:pt idx="2">
                    <c:v>11.128470353243031</c:v>
                  </c:pt>
                  <c:pt idx="3">
                    <c:v>18.117343694242276</c:v>
                  </c:pt>
                  <c:pt idx="4">
                    <c:v>7.0938114184492607</c:v>
                  </c:pt>
                  <c:pt idx="5">
                    <c:v>13.930222361452977</c:v>
                  </c:pt>
                </c:numCache>
              </c:numRef>
            </c:plus>
            <c:minus>
              <c:numRef>
                <c:f>'H+'!$K$25:$P$25</c:f>
                <c:numCache>
                  <c:formatCode>General</c:formatCode>
                  <c:ptCount val="6"/>
                  <c:pt idx="0">
                    <c:v>8.0131662967600157</c:v>
                  </c:pt>
                  <c:pt idx="1">
                    <c:v>10.471212497836932</c:v>
                  </c:pt>
                  <c:pt idx="2">
                    <c:v>11.128470353243031</c:v>
                  </c:pt>
                  <c:pt idx="3">
                    <c:v>18.117343694242276</c:v>
                  </c:pt>
                  <c:pt idx="4">
                    <c:v>7.0938114184492607</c:v>
                  </c:pt>
                  <c:pt idx="5">
                    <c:v>13.930222361452977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E74B35"/>
                </a:solidFill>
                <a:round/>
              </a:ln>
              <a:effectLst/>
            </c:spPr>
          </c:errBars>
          <c:xVal>
            <c:numRef>
              <c:f>'H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K$24:$P$24</c:f>
              <c:numCache>
                <c:formatCode>General</c:formatCode>
                <c:ptCount val="6"/>
                <c:pt idx="0">
                  <c:v>57.528441597542233</c:v>
                </c:pt>
                <c:pt idx="1">
                  <c:v>49.316048366848207</c:v>
                </c:pt>
                <c:pt idx="2">
                  <c:v>36.242273608203341</c:v>
                </c:pt>
                <c:pt idx="3">
                  <c:v>31.006795179211476</c:v>
                </c:pt>
                <c:pt idx="4">
                  <c:v>25.635712838872593</c:v>
                </c:pt>
                <c:pt idx="5">
                  <c:v>21.4854550208557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8CE-4790-8AB4-4D29E895D26A}"/>
            </c:ext>
          </c:extLst>
        </c:ser>
        <c:ser>
          <c:idx val="3"/>
          <c:order val="2"/>
          <c:tx>
            <c:v>WT, NaCl, amiloride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K$35:$P$35</c:f>
                <c:numCache>
                  <c:formatCode>General</c:formatCode>
                  <c:ptCount val="6"/>
                  <c:pt idx="0">
                    <c:v>47.918155889160516</c:v>
                  </c:pt>
                  <c:pt idx="1">
                    <c:v>59.760527110469617</c:v>
                  </c:pt>
                  <c:pt idx="2">
                    <c:v>39.963204415376204</c:v>
                  </c:pt>
                  <c:pt idx="3">
                    <c:v>36.111344510170063</c:v>
                  </c:pt>
                  <c:pt idx="4">
                    <c:v>30.391913662669083</c:v>
                  </c:pt>
                  <c:pt idx="5">
                    <c:v>18.381393022491782</c:v>
                  </c:pt>
                </c:numCache>
              </c:numRef>
            </c:plus>
            <c:minus>
              <c:numRef>
                <c:f>'H+'!$K$35:$P$35</c:f>
                <c:numCache>
                  <c:formatCode>General</c:formatCode>
                  <c:ptCount val="6"/>
                  <c:pt idx="0">
                    <c:v>47.918155889160516</c:v>
                  </c:pt>
                  <c:pt idx="1">
                    <c:v>59.760527110469617</c:v>
                  </c:pt>
                  <c:pt idx="2">
                    <c:v>39.963204415376204</c:v>
                  </c:pt>
                  <c:pt idx="3">
                    <c:v>36.111344510170063</c:v>
                  </c:pt>
                  <c:pt idx="4">
                    <c:v>30.391913662669083</c:v>
                  </c:pt>
                  <c:pt idx="5">
                    <c:v>18.3813930224917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xVal>
            <c:numRef>
              <c:f>'H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K$34:$P$34</c:f>
              <c:numCache>
                <c:formatCode>General</c:formatCode>
                <c:ptCount val="6"/>
                <c:pt idx="0">
                  <c:v>78.363860828157343</c:v>
                </c:pt>
                <c:pt idx="1">
                  <c:v>79.746536607142872</c:v>
                </c:pt>
                <c:pt idx="2">
                  <c:v>47.76047218614719</c:v>
                </c:pt>
                <c:pt idx="3">
                  <c:v>41.409059233766243</c:v>
                </c:pt>
                <c:pt idx="4">
                  <c:v>33.006835290796161</c:v>
                </c:pt>
                <c:pt idx="5">
                  <c:v>19.9107359663865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8CE-4790-8AB4-4D29E895D26A}"/>
            </c:ext>
          </c:extLst>
        </c:ser>
        <c:ser>
          <c:idx val="2"/>
          <c:order val="3"/>
          <c:tx>
            <c:v>sos1, NaCl</c:v>
          </c:tx>
          <c:spPr>
            <a:ln w="19050" cap="rnd">
              <a:solidFill>
                <a:srgbClr val="52C2DD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2C2DD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+'!$K$45:$P$45</c:f>
                <c:numCache>
                  <c:formatCode>General</c:formatCode>
                  <c:ptCount val="6"/>
                  <c:pt idx="0">
                    <c:v>28.449135271600156</c:v>
                  </c:pt>
                  <c:pt idx="1">
                    <c:v>62.462312339343868</c:v>
                  </c:pt>
                  <c:pt idx="2">
                    <c:v>40.248046043891179</c:v>
                  </c:pt>
                  <c:pt idx="3">
                    <c:v>27.73561167915534</c:v>
                  </c:pt>
                  <c:pt idx="4">
                    <c:v>23.244831910110538</c:v>
                  </c:pt>
                  <c:pt idx="5">
                    <c:v>25.862711954220703</c:v>
                  </c:pt>
                </c:numCache>
              </c:numRef>
            </c:plus>
            <c:minus>
              <c:numRef>
                <c:f>'H+'!$K$45:$P$45</c:f>
                <c:numCache>
                  <c:formatCode>General</c:formatCode>
                  <c:ptCount val="6"/>
                  <c:pt idx="0">
                    <c:v>28.449135271600156</c:v>
                  </c:pt>
                  <c:pt idx="1">
                    <c:v>62.462312339343868</c:v>
                  </c:pt>
                  <c:pt idx="2">
                    <c:v>40.248046043891179</c:v>
                  </c:pt>
                  <c:pt idx="3">
                    <c:v>27.73561167915534</c:v>
                  </c:pt>
                  <c:pt idx="4">
                    <c:v>23.244831910110538</c:v>
                  </c:pt>
                  <c:pt idx="5">
                    <c:v>25.862711954220703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52C2DD"/>
                </a:solidFill>
                <a:round/>
              </a:ln>
              <a:effectLst/>
            </c:spPr>
          </c:errBars>
          <c:xVal>
            <c:numRef>
              <c:f>'H+'!$K$2:$P$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</c:numCache>
            </c:numRef>
          </c:xVal>
          <c:yVal>
            <c:numRef>
              <c:f>'H+'!$K$44:$P$44</c:f>
              <c:numCache>
                <c:formatCode>General</c:formatCode>
                <c:ptCount val="6"/>
                <c:pt idx="0">
                  <c:v>70.770629884792626</c:v>
                </c:pt>
                <c:pt idx="1">
                  <c:v>80.815049530529961</c:v>
                </c:pt>
                <c:pt idx="2">
                  <c:v>69.679172303030299</c:v>
                </c:pt>
                <c:pt idx="3">
                  <c:v>50.44011977726575</c:v>
                </c:pt>
                <c:pt idx="4">
                  <c:v>43.391195128205126</c:v>
                </c:pt>
                <c:pt idx="5">
                  <c:v>31.7884788888888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8CE-4790-8AB4-4D29E895D2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2364152"/>
        <c:axId val="492365328"/>
      </c:scatterChart>
      <c:valAx>
        <c:axId val="492364152"/>
        <c:scaling>
          <c:orientation val="minMax"/>
          <c:max val="6.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Time after treatment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92365328"/>
        <c:crossesAt val="-150"/>
        <c:crossBetween val="midCat"/>
      </c:valAx>
      <c:valAx>
        <c:axId val="492365328"/>
        <c:scaling>
          <c:orientation val="minMax"/>
          <c:max val="150"/>
          <c:min val="-15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/>
                  <a:t>Net H</a:t>
                </a:r>
                <a:r>
                  <a:rPr lang="en-US" sz="1200" baseline="30000" dirty="0"/>
                  <a:t>+</a:t>
                </a:r>
                <a:r>
                  <a:rPr lang="en-US" sz="1200" dirty="0"/>
                  <a:t> flux (nmol m</a:t>
                </a:r>
                <a:r>
                  <a:rPr lang="en-US" sz="1200" baseline="30000" dirty="0"/>
                  <a:t>-2</a:t>
                </a:r>
                <a:r>
                  <a:rPr lang="en-US" sz="1200" dirty="0"/>
                  <a:t> s</a:t>
                </a:r>
                <a:r>
                  <a:rPr lang="en-US" sz="1200" baseline="30000" dirty="0"/>
                  <a:t>-1</a:t>
                </a:r>
                <a:r>
                  <a:rPr lang="en-US" sz="1200" dirty="0"/>
                  <a:t>)</a:t>
                </a:r>
              </a:p>
            </c:rich>
          </c:tx>
          <c:layout>
            <c:manualLayout>
              <c:xMode val="edge"/>
              <c:yMode val="edge"/>
              <c:x val="2.7438271604938273E-2"/>
              <c:y val="0.181819444444444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9236415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5847222222222214"/>
          <c:y val="0.4806265873015873"/>
          <c:w val="0.42202160493827162"/>
          <c:h val="0.2704460317460317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52041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956887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893037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672817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75007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004368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655114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48826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930087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15418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4266381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C460C-BD4C-48D2-89AC-DE7A56C49E0C}" type="datetimeFigureOut">
              <a:rPr kumimoji="1" lang="en-GB" smtClean="0"/>
              <a:t>30/03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2930E-BE9A-40E6-A673-669B0E81D0FC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577463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5AFCFF0C-31C7-49B9-8A67-1EEF9B89D6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7821540"/>
              </p:ext>
            </p:extLst>
          </p:nvPr>
        </p:nvGraphicFramePr>
        <p:xfrm>
          <a:off x="0" y="0"/>
          <a:ext cx="54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51315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00000000-0008-0000-01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4726042"/>
              </p:ext>
            </p:extLst>
          </p:nvPr>
        </p:nvGraphicFramePr>
        <p:xfrm>
          <a:off x="0" y="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0000000-0008-0000-01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7633495"/>
              </p:ext>
            </p:extLst>
          </p:nvPr>
        </p:nvGraphicFramePr>
        <p:xfrm>
          <a:off x="3240000" y="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1A11CDE-9969-4916-91B3-ED86AA5B360D}"/>
              </a:ext>
            </a:extLst>
          </p:cNvPr>
          <p:cNvSpPr txBox="1"/>
          <p:nvPr/>
        </p:nvSpPr>
        <p:spPr>
          <a:xfrm>
            <a:off x="0" y="0"/>
            <a:ext cx="3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GB" sz="2400" dirty="0"/>
              <a:t>A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E1EF4D-8A47-4D18-990B-60E72830030E}"/>
              </a:ext>
            </a:extLst>
          </p:cNvPr>
          <p:cNvSpPr txBox="1"/>
          <p:nvPr/>
        </p:nvSpPr>
        <p:spPr>
          <a:xfrm>
            <a:off x="3240000" y="-1"/>
            <a:ext cx="3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GB" sz="2400" dirty="0"/>
              <a:t>B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BDB29D-F79D-4574-878C-78B958EEE7B4}"/>
              </a:ext>
            </a:extLst>
          </p:cNvPr>
          <p:cNvSpPr txBox="1"/>
          <p:nvPr/>
        </p:nvSpPr>
        <p:spPr>
          <a:xfrm>
            <a:off x="1116100" y="1700530"/>
            <a:ext cx="5760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GB" sz="1000" i="1" dirty="0"/>
              <a:t>sos1</a:t>
            </a:r>
            <a:r>
              <a:rPr kumimoji="1" lang="en-GB" sz="1000" dirty="0"/>
              <a:t>, NaCl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9FB065F-6869-4EA3-84A3-9F548874F0CA}"/>
              </a:ext>
            </a:extLst>
          </p:cNvPr>
          <p:cNvSpPr txBox="1"/>
          <p:nvPr/>
        </p:nvSpPr>
        <p:spPr>
          <a:xfrm>
            <a:off x="4356100" y="1699786"/>
            <a:ext cx="5760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GB" sz="1000" i="1" dirty="0"/>
              <a:t>sos1</a:t>
            </a:r>
            <a:r>
              <a:rPr kumimoji="1" lang="en-GB" sz="1000" dirty="0"/>
              <a:t>, NaCl</a:t>
            </a:r>
          </a:p>
        </p:txBody>
      </p:sp>
    </p:spTree>
    <p:extLst>
      <p:ext uri="{BB962C8B-B14F-4D97-AF65-F5344CB8AC3E}">
        <p14:creationId xmlns:p14="http://schemas.microsoft.com/office/powerpoint/2010/main" val="3073600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6145106"/>
              </p:ext>
            </p:extLst>
          </p:nvPr>
        </p:nvGraphicFramePr>
        <p:xfrm>
          <a:off x="0" y="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00000000-0008-0000-00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1123921"/>
              </p:ext>
            </p:extLst>
          </p:nvPr>
        </p:nvGraphicFramePr>
        <p:xfrm>
          <a:off x="3240000" y="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1A11CDE-9969-4916-91B3-ED86AA5B360D}"/>
              </a:ext>
            </a:extLst>
          </p:cNvPr>
          <p:cNvSpPr txBox="1"/>
          <p:nvPr/>
        </p:nvSpPr>
        <p:spPr>
          <a:xfrm>
            <a:off x="0" y="0"/>
            <a:ext cx="3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GB" sz="2400" dirty="0"/>
              <a:t>A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E1EF4D-8A47-4D18-990B-60E72830030E}"/>
              </a:ext>
            </a:extLst>
          </p:cNvPr>
          <p:cNvSpPr txBox="1"/>
          <p:nvPr/>
        </p:nvSpPr>
        <p:spPr>
          <a:xfrm>
            <a:off x="3240000" y="-1"/>
            <a:ext cx="3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GB" sz="2400" dirty="0"/>
              <a:t>B</a:t>
            </a: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00000000-0008-0000-02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5919531"/>
              </p:ext>
            </p:extLst>
          </p:nvPr>
        </p:nvGraphicFramePr>
        <p:xfrm>
          <a:off x="0" y="2520000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00000000-0008-0000-02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589069"/>
              </p:ext>
            </p:extLst>
          </p:nvPr>
        </p:nvGraphicFramePr>
        <p:xfrm>
          <a:off x="3240000" y="2519998"/>
          <a:ext cx="32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DA97107-7EA5-4040-A032-A8C7B186E7D7}"/>
              </a:ext>
            </a:extLst>
          </p:cNvPr>
          <p:cNvSpPr txBox="1"/>
          <p:nvPr/>
        </p:nvSpPr>
        <p:spPr>
          <a:xfrm>
            <a:off x="0" y="2520000"/>
            <a:ext cx="3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GB" sz="2400" dirty="0"/>
              <a:t>C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28C1B89-8AAF-48D2-AEDE-7442F3FDA2AF}"/>
              </a:ext>
            </a:extLst>
          </p:cNvPr>
          <p:cNvSpPr txBox="1"/>
          <p:nvPr/>
        </p:nvSpPr>
        <p:spPr>
          <a:xfrm>
            <a:off x="3240000" y="2519996"/>
            <a:ext cx="3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GB" sz="2400" dirty="0"/>
              <a:t>D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C2B45B3-7185-41C1-A845-BFE7FADB1F30}"/>
              </a:ext>
            </a:extLst>
          </p:cNvPr>
          <p:cNvSpPr/>
          <p:nvPr/>
        </p:nvSpPr>
        <p:spPr>
          <a:xfrm>
            <a:off x="7171920" y="3744173"/>
            <a:ext cx="1368000" cy="684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en-GB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D69E61E-F012-4EF5-BE6A-F3021515A281}"/>
              </a:ext>
            </a:extLst>
          </p:cNvPr>
          <p:cNvSpPr txBox="1"/>
          <p:nvPr/>
        </p:nvSpPr>
        <p:spPr>
          <a:xfrm>
            <a:off x="1863725" y="1690261"/>
            <a:ext cx="5760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GB" sz="1000" i="1" dirty="0"/>
              <a:t>sos1</a:t>
            </a:r>
            <a:r>
              <a:rPr kumimoji="1" lang="en-GB" sz="1000" dirty="0"/>
              <a:t>, NaCl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AA218A0-8A33-4F44-B29C-8661EB4B0F05}"/>
              </a:ext>
            </a:extLst>
          </p:cNvPr>
          <p:cNvSpPr txBox="1"/>
          <p:nvPr/>
        </p:nvSpPr>
        <p:spPr>
          <a:xfrm>
            <a:off x="5105400" y="1688046"/>
            <a:ext cx="5760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GB" sz="1000" i="1" dirty="0"/>
              <a:t>sos1</a:t>
            </a:r>
            <a:r>
              <a:rPr kumimoji="1" lang="en-GB" sz="1000" dirty="0"/>
              <a:t>, NaCl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1F83202-28F8-4331-9951-7E4FF2478483}"/>
              </a:ext>
            </a:extLst>
          </p:cNvPr>
          <p:cNvSpPr txBox="1"/>
          <p:nvPr/>
        </p:nvSpPr>
        <p:spPr>
          <a:xfrm>
            <a:off x="1482725" y="3496310"/>
            <a:ext cx="5760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GB" sz="1000" i="1" dirty="0"/>
              <a:t>sos1</a:t>
            </a:r>
            <a:r>
              <a:rPr kumimoji="1" lang="en-GB" sz="1000" dirty="0"/>
              <a:t>, NaCl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3D04ABA-1757-47A5-971D-D7AD28A73FA0}"/>
              </a:ext>
            </a:extLst>
          </p:cNvPr>
          <p:cNvSpPr txBox="1"/>
          <p:nvPr/>
        </p:nvSpPr>
        <p:spPr>
          <a:xfrm>
            <a:off x="4724400" y="4245610"/>
            <a:ext cx="5760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GB" sz="1000" i="1" dirty="0"/>
              <a:t>sos1</a:t>
            </a:r>
            <a:r>
              <a:rPr kumimoji="1" lang="en-GB" sz="1000" dirty="0"/>
              <a:t>, NaCl</a:t>
            </a:r>
          </a:p>
        </p:txBody>
      </p:sp>
    </p:spTree>
    <p:extLst>
      <p:ext uri="{BB962C8B-B14F-4D97-AF65-F5344CB8AC3E}">
        <p14:creationId xmlns:p14="http://schemas.microsoft.com/office/powerpoint/2010/main" val="23207676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グラフィックス 28">
            <a:extLst>
              <a:ext uri="{FF2B5EF4-FFF2-40B4-BE49-F238E27FC236}">
                <a16:creationId xmlns:a16="http://schemas.microsoft.com/office/drawing/2014/main" id="{63D274E2-217D-41B9-A806-B31FB94FA3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4775" y="0"/>
            <a:ext cx="540000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5374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</TotalTime>
  <Words>147</Words>
  <Application>Microsoft Office PowerPoint</Application>
  <PresentationFormat>A4 210 x 297 mm</PresentationFormat>
  <Paragraphs>33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aki Ogura</dc:creator>
  <cp:lastModifiedBy>Takaaki Ogura</cp:lastModifiedBy>
  <cp:revision>8</cp:revision>
  <dcterms:created xsi:type="dcterms:W3CDTF">2022-03-23T07:05:26Z</dcterms:created>
  <dcterms:modified xsi:type="dcterms:W3CDTF">2022-03-30T14:12:49Z</dcterms:modified>
</cp:coreProperties>
</file>